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379543-D4D1-57BC-3221-3358E3FAF49D}" v="243" dt="2025-03-02T10:47:36.3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56" autoAdjust="0"/>
    <p:restoredTop sz="95033" autoAdjust="0"/>
  </p:normalViewPr>
  <p:slideViewPr>
    <p:cSldViewPr snapToGrid="0">
      <p:cViewPr>
        <p:scale>
          <a:sx n="100" d="100"/>
          <a:sy n="100" d="100"/>
        </p:scale>
        <p:origin x="298" y="-43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ángulo 110">
            <a:extLst>
              <a:ext uri="{FF2B5EF4-FFF2-40B4-BE49-F238E27FC236}">
                <a16:creationId xmlns:a16="http://schemas.microsoft.com/office/drawing/2014/main" id="{45C11325-DE02-1B54-EB39-854311E80AC1}"/>
              </a:ext>
            </a:extLst>
          </p:cNvPr>
          <p:cNvSpPr/>
          <p:nvPr/>
        </p:nvSpPr>
        <p:spPr>
          <a:xfrm>
            <a:off x="99060" y="1183322"/>
            <a:ext cx="7358769" cy="3510598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358140" y="229215"/>
            <a:ext cx="9528644" cy="954107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800" dirty="0">
                <a:latin typeface="Arial"/>
                <a:ea typeface="Calibri"/>
                <a:cs typeface="Arial"/>
              </a:rPr>
              <a:t>Defining new radiological patterns to improve classification of </a:t>
            </a:r>
            <a:r>
              <a:rPr lang="en-US" sz="2800" dirty="0" err="1">
                <a:latin typeface="Arial"/>
                <a:ea typeface="Calibri"/>
                <a:cs typeface="Arial"/>
              </a:rPr>
              <a:t>Bosniak</a:t>
            </a:r>
            <a:r>
              <a:rPr lang="en-US" sz="2800" dirty="0">
                <a:latin typeface="Arial"/>
                <a:ea typeface="Calibri"/>
                <a:cs typeface="Arial"/>
              </a:rPr>
              <a:t> III and IV cystic renal masse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130" y="4774424"/>
            <a:ext cx="3940150" cy="857590"/>
          </a:xfrm>
          <a:prstGeom prst="rect">
            <a:avLst/>
          </a:prstGeom>
        </p:spPr>
      </p:pic>
      <p:grpSp>
        <p:nvGrpSpPr>
          <p:cNvPr id="6" name="Grupo 39">
            <a:extLst>
              <a:ext uri="{FF2B5EF4-FFF2-40B4-BE49-F238E27FC236}">
                <a16:creationId xmlns:a16="http://schemas.microsoft.com/office/drawing/2014/main" id="{933C8124-4B9C-BB21-B0A6-C3241805ABB8}"/>
              </a:ext>
            </a:extLst>
          </p:cNvPr>
          <p:cNvGrpSpPr/>
          <p:nvPr/>
        </p:nvGrpSpPr>
        <p:grpSpPr>
          <a:xfrm>
            <a:off x="5713346" y="2251994"/>
            <a:ext cx="1587609" cy="1858163"/>
            <a:chOff x="9169942" y="2300508"/>
            <a:chExt cx="2658632" cy="3309219"/>
          </a:xfrm>
        </p:grpSpPr>
        <p:grpSp>
          <p:nvGrpSpPr>
            <p:cNvPr id="81" name="Grupo 185">
              <a:extLst>
                <a:ext uri="{FF2B5EF4-FFF2-40B4-BE49-F238E27FC236}">
                  <a16:creationId xmlns:a16="http://schemas.microsoft.com/office/drawing/2014/main" id="{D5C59C5E-A09A-3198-579C-0C2572573BA4}"/>
                </a:ext>
              </a:extLst>
            </p:cNvPr>
            <p:cNvGrpSpPr/>
            <p:nvPr/>
          </p:nvGrpSpPr>
          <p:grpSpPr>
            <a:xfrm>
              <a:off x="9779337" y="2300508"/>
              <a:ext cx="2049237" cy="2724101"/>
              <a:chOff x="9779337" y="2300508"/>
              <a:chExt cx="2049237" cy="2724101"/>
            </a:xfrm>
          </p:grpSpPr>
          <p:grpSp>
            <p:nvGrpSpPr>
              <p:cNvPr id="87" name="Grupo 186">
                <a:extLst>
                  <a:ext uri="{FF2B5EF4-FFF2-40B4-BE49-F238E27FC236}">
                    <a16:creationId xmlns:a16="http://schemas.microsoft.com/office/drawing/2014/main" id="{0D490007-020A-E02F-C2E8-68F4A063D78C}"/>
                  </a:ext>
                </a:extLst>
              </p:cNvPr>
              <p:cNvGrpSpPr/>
              <p:nvPr/>
            </p:nvGrpSpPr>
            <p:grpSpPr>
              <a:xfrm>
                <a:off x="9779337" y="2300508"/>
                <a:ext cx="2049237" cy="2724101"/>
                <a:chOff x="9779337" y="2300507"/>
                <a:chExt cx="2735801" cy="3628021"/>
              </a:xfrm>
            </p:grpSpPr>
            <p:sp>
              <p:nvSpPr>
                <p:cNvPr id="91" name="Forma libre: forma 190">
                  <a:extLst>
                    <a:ext uri="{FF2B5EF4-FFF2-40B4-BE49-F238E27FC236}">
                      <a16:creationId xmlns:a16="http://schemas.microsoft.com/office/drawing/2014/main" id="{DDAB2DF3-A24E-D787-A9AE-6247AC683F97}"/>
                    </a:ext>
                  </a:extLst>
                </p:cNvPr>
                <p:cNvSpPr/>
                <p:nvPr/>
              </p:nvSpPr>
              <p:spPr>
                <a:xfrm>
                  <a:off x="11310321" y="3866687"/>
                  <a:ext cx="625792" cy="2061841"/>
                </a:xfrm>
                <a:custGeom>
                  <a:avLst/>
                  <a:gdLst>
                    <a:gd name="connsiteX0" fmla="*/ 83858 w 625792"/>
                    <a:gd name="connsiteY0" fmla="*/ 3352 h 2061841"/>
                    <a:gd name="connsiteX1" fmla="*/ 382308 w 625792"/>
                    <a:gd name="connsiteY1" fmla="*/ 149402 h 2061841"/>
                    <a:gd name="connsiteX2" fmla="*/ 490258 w 625792"/>
                    <a:gd name="connsiteY2" fmla="*/ 358952 h 2061841"/>
                    <a:gd name="connsiteX3" fmla="*/ 579158 w 625792"/>
                    <a:gd name="connsiteY3" fmla="*/ 720902 h 2061841"/>
                    <a:gd name="connsiteX4" fmla="*/ 572808 w 625792"/>
                    <a:gd name="connsiteY4" fmla="*/ 1209852 h 2061841"/>
                    <a:gd name="connsiteX5" fmla="*/ 623608 w 625792"/>
                    <a:gd name="connsiteY5" fmla="*/ 1800402 h 2061841"/>
                    <a:gd name="connsiteX6" fmla="*/ 598208 w 625792"/>
                    <a:gd name="connsiteY6" fmla="*/ 2029002 h 2061841"/>
                    <a:gd name="connsiteX7" fmla="*/ 439458 w 625792"/>
                    <a:gd name="connsiteY7" fmla="*/ 2041702 h 2061841"/>
                    <a:gd name="connsiteX8" fmla="*/ 433108 w 625792"/>
                    <a:gd name="connsiteY8" fmla="*/ 1851202 h 2061841"/>
                    <a:gd name="connsiteX9" fmla="*/ 433108 w 625792"/>
                    <a:gd name="connsiteY9" fmla="*/ 1292402 h 2061841"/>
                    <a:gd name="connsiteX10" fmla="*/ 401358 w 625792"/>
                    <a:gd name="connsiteY10" fmla="*/ 886002 h 2061841"/>
                    <a:gd name="connsiteX11" fmla="*/ 337858 w 625792"/>
                    <a:gd name="connsiteY11" fmla="*/ 651052 h 2061841"/>
                    <a:gd name="connsiteX12" fmla="*/ 160058 w 625792"/>
                    <a:gd name="connsiteY12" fmla="*/ 657402 h 2061841"/>
                    <a:gd name="connsiteX13" fmla="*/ 77508 w 625792"/>
                    <a:gd name="connsiteY13" fmla="*/ 714552 h 2061841"/>
                    <a:gd name="connsiteX14" fmla="*/ 39408 w 625792"/>
                    <a:gd name="connsiteY14" fmla="*/ 670102 h 2061841"/>
                    <a:gd name="connsiteX15" fmla="*/ 52108 w 625792"/>
                    <a:gd name="connsiteY15" fmla="*/ 498652 h 2061841"/>
                    <a:gd name="connsiteX16" fmla="*/ 52108 w 625792"/>
                    <a:gd name="connsiteY16" fmla="*/ 276402 h 2061841"/>
                    <a:gd name="connsiteX17" fmla="*/ 1308 w 625792"/>
                    <a:gd name="connsiteY17" fmla="*/ 149402 h 2061841"/>
                    <a:gd name="connsiteX18" fmla="*/ 20358 w 625792"/>
                    <a:gd name="connsiteY18" fmla="*/ 54152 h 2061841"/>
                    <a:gd name="connsiteX19" fmla="*/ 83858 w 625792"/>
                    <a:gd name="connsiteY19" fmla="*/ 3352 h 20618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625792" h="2061841">
                      <a:moveTo>
                        <a:pt x="83858" y="3352"/>
                      </a:moveTo>
                      <a:cubicBezTo>
                        <a:pt x="144183" y="19227"/>
                        <a:pt x="314575" y="90135"/>
                        <a:pt x="382308" y="149402"/>
                      </a:cubicBezTo>
                      <a:cubicBezTo>
                        <a:pt x="450041" y="208669"/>
                        <a:pt x="457450" y="263702"/>
                        <a:pt x="490258" y="358952"/>
                      </a:cubicBezTo>
                      <a:cubicBezTo>
                        <a:pt x="523066" y="454202"/>
                        <a:pt x="565400" y="579085"/>
                        <a:pt x="579158" y="720902"/>
                      </a:cubicBezTo>
                      <a:cubicBezTo>
                        <a:pt x="592916" y="862719"/>
                        <a:pt x="565400" y="1029935"/>
                        <a:pt x="572808" y="1209852"/>
                      </a:cubicBezTo>
                      <a:cubicBezTo>
                        <a:pt x="580216" y="1389769"/>
                        <a:pt x="619375" y="1663877"/>
                        <a:pt x="623608" y="1800402"/>
                      </a:cubicBezTo>
                      <a:cubicBezTo>
                        <a:pt x="627841" y="1936927"/>
                        <a:pt x="628900" y="1988785"/>
                        <a:pt x="598208" y="2029002"/>
                      </a:cubicBezTo>
                      <a:cubicBezTo>
                        <a:pt x="567516" y="2069219"/>
                        <a:pt x="466975" y="2071335"/>
                        <a:pt x="439458" y="2041702"/>
                      </a:cubicBezTo>
                      <a:cubicBezTo>
                        <a:pt x="411941" y="2012069"/>
                        <a:pt x="434166" y="1976085"/>
                        <a:pt x="433108" y="1851202"/>
                      </a:cubicBezTo>
                      <a:cubicBezTo>
                        <a:pt x="432050" y="1726319"/>
                        <a:pt x="438400" y="1453269"/>
                        <a:pt x="433108" y="1292402"/>
                      </a:cubicBezTo>
                      <a:cubicBezTo>
                        <a:pt x="427816" y="1131535"/>
                        <a:pt x="417233" y="992894"/>
                        <a:pt x="401358" y="886002"/>
                      </a:cubicBezTo>
                      <a:cubicBezTo>
                        <a:pt x="385483" y="779110"/>
                        <a:pt x="378075" y="689152"/>
                        <a:pt x="337858" y="651052"/>
                      </a:cubicBezTo>
                      <a:cubicBezTo>
                        <a:pt x="297641" y="612952"/>
                        <a:pt x="203450" y="646819"/>
                        <a:pt x="160058" y="657402"/>
                      </a:cubicBezTo>
                      <a:cubicBezTo>
                        <a:pt x="116666" y="667985"/>
                        <a:pt x="97616" y="712435"/>
                        <a:pt x="77508" y="714552"/>
                      </a:cubicBezTo>
                      <a:cubicBezTo>
                        <a:pt x="57400" y="716669"/>
                        <a:pt x="43641" y="706085"/>
                        <a:pt x="39408" y="670102"/>
                      </a:cubicBezTo>
                      <a:cubicBezTo>
                        <a:pt x="35175" y="634119"/>
                        <a:pt x="49991" y="564269"/>
                        <a:pt x="52108" y="498652"/>
                      </a:cubicBezTo>
                      <a:cubicBezTo>
                        <a:pt x="54225" y="433035"/>
                        <a:pt x="60575" y="334610"/>
                        <a:pt x="52108" y="276402"/>
                      </a:cubicBezTo>
                      <a:cubicBezTo>
                        <a:pt x="43641" y="218194"/>
                        <a:pt x="6600" y="186444"/>
                        <a:pt x="1308" y="149402"/>
                      </a:cubicBezTo>
                      <a:cubicBezTo>
                        <a:pt x="-3984" y="112360"/>
                        <a:pt x="7658" y="76377"/>
                        <a:pt x="20358" y="54152"/>
                      </a:cubicBezTo>
                      <a:cubicBezTo>
                        <a:pt x="33058" y="31927"/>
                        <a:pt x="23533" y="-12523"/>
                        <a:pt x="83858" y="3352"/>
                      </a:cubicBezTo>
                      <a:close/>
                    </a:path>
                  </a:pathLst>
                </a:custGeom>
                <a:solidFill>
                  <a:srgbClr val="FECC96"/>
                </a:solidFill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  <p:grpSp>
              <p:nvGrpSpPr>
                <p:cNvPr id="92" name="Grupo 191">
                  <a:extLst>
                    <a:ext uri="{FF2B5EF4-FFF2-40B4-BE49-F238E27FC236}">
                      <a16:creationId xmlns:a16="http://schemas.microsoft.com/office/drawing/2014/main" id="{E632A828-96F7-D1C9-BB10-706F72D2B9C7}"/>
                    </a:ext>
                  </a:extLst>
                </p:cNvPr>
                <p:cNvGrpSpPr/>
                <p:nvPr/>
              </p:nvGrpSpPr>
              <p:grpSpPr>
                <a:xfrm>
                  <a:off x="9779337" y="2300507"/>
                  <a:ext cx="2735801" cy="3347037"/>
                  <a:chOff x="9779337" y="2300507"/>
                  <a:chExt cx="2735801" cy="3347037"/>
                </a:xfrm>
              </p:grpSpPr>
              <p:sp>
                <p:nvSpPr>
                  <p:cNvPr id="93" name="Forma libre: forma 192">
                    <a:extLst>
                      <a:ext uri="{FF2B5EF4-FFF2-40B4-BE49-F238E27FC236}">
                        <a16:creationId xmlns:a16="http://schemas.microsoft.com/office/drawing/2014/main" id="{80D4C924-D08A-4957-B0FC-64DE121FF464}"/>
                      </a:ext>
                    </a:extLst>
                  </p:cNvPr>
                  <p:cNvSpPr/>
                  <p:nvPr/>
                </p:nvSpPr>
                <p:spPr>
                  <a:xfrm>
                    <a:off x="11188054" y="2970425"/>
                    <a:ext cx="1327084" cy="2494234"/>
                  </a:xfrm>
                  <a:custGeom>
                    <a:avLst/>
                    <a:gdLst>
                      <a:gd name="connsiteX0" fmla="*/ 937009 w 1327084"/>
                      <a:gd name="connsiteY0" fmla="*/ 1557 h 2494234"/>
                      <a:gd name="connsiteX1" fmla="*/ 1114809 w 1327084"/>
                      <a:gd name="connsiteY1" fmla="*/ 26957 h 2494234"/>
                      <a:gd name="connsiteX2" fmla="*/ 1324359 w 1327084"/>
                      <a:gd name="connsiteY2" fmla="*/ 33307 h 2494234"/>
                      <a:gd name="connsiteX3" fmla="*/ 1235459 w 1327084"/>
                      <a:gd name="connsiteY3" fmla="*/ 280957 h 2494234"/>
                      <a:gd name="connsiteX4" fmla="*/ 1254509 w 1327084"/>
                      <a:gd name="connsiteY4" fmla="*/ 693707 h 2494234"/>
                      <a:gd name="connsiteX5" fmla="*/ 1254509 w 1327084"/>
                      <a:gd name="connsiteY5" fmla="*/ 852457 h 2494234"/>
                      <a:gd name="connsiteX6" fmla="*/ 1254509 w 1327084"/>
                      <a:gd name="connsiteY6" fmla="*/ 2236757 h 2494234"/>
                      <a:gd name="connsiteX7" fmla="*/ 1292609 w 1327084"/>
                      <a:gd name="connsiteY7" fmla="*/ 2459007 h 2494234"/>
                      <a:gd name="connsiteX8" fmla="*/ 1051309 w 1327084"/>
                      <a:gd name="connsiteY8" fmla="*/ 2484407 h 2494234"/>
                      <a:gd name="connsiteX9" fmla="*/ 911609 w 1327084"/>
                      <a:gd name="connsiteY9" fmla="*/ 2363757 h 2494234"/>
                      <a:gd name="connsiteX10" fmla="*/ 917959 w 1327084"/>
                      <a:gd name="connsiteY10" fmla="*/ 1785907 h 2494234"/>
                      <a:gd name="connsiteX11" fmla="*/ 848109 w 1327084"/>
                      <a:gd name="connsiteY11" fmla="*/ 1182657 h 2494234"/>
                      <a:gd name="connsiteX12" fmla="*/ 721109 w 1327084"/>
                      <a:gd name="connsiteY12" fmla="*/ 1277907 h 2494234"/>
                      <a:gd name="connsiteX13" fmla="*/ 251209 w 1327084"/>
                      <a:gd name="connsiteY13" fmla="*/ 1487457 h 2494234"/>
                      <a:gd name="connsiteX14" fmla="*/ 124209 w 1327084"/>
                      <a:gd name="connsiteY14" fmla="*/ 1493807 h 2494234"/>
                      <a:gd name="connsiteX15" fmla="*/ 73409 w 1327084"/>
                      <a:gd name="connsiteY15" fmla="*/ 1398557 h 2494234"/>
                      <a:gd name="connsiteX16" fmla="*/ 321059 w 1327084"/>
                      <a:gd name="connsiteY16" fmla="*/ 1309657 h 2494234"/>
                      <a:gd name="connsiteX17" fmla="*/ 651259 w 1327084"/>
                      <a:gd name="connsiteY17" fmla="*/ 1087407 h 2494234"/>
                      <a:gd name="connsiteX18" fmla="*/ 587759 w 1327084"/>
                      <a:gd name="connsiteY18" fmla="*/ 985807 h 2494234"/>
                      <a:gd name="connsiteX19" fmla="*/ 422659 w 1327084"/>
                      <a:gd name="connsiteY19" fmla="*/ 1087407 h 2494234"/>
                      <a:gd name="connsiteX20" fmla="*/ 244859 w 1327084"/>
                      <a:gd name="connsiteY20" fmla="*/ 1163607 h 2494234"/>
                      <a:gd name="connsiteX21" fmla="*/ 48009 w 1327084"/>
                      <a:gd name="connsiteY21" fmla="*/ 1176307 h 2494234"/>
                      <a:gd name="connsiteX22" fmla="*/ 16259 w 1327084"/>
                      <a:gd name="connsiteY22" fmla="*/ 992157 h 2494234"/>
                      <a:gd name="connsiteX23" fmla="*/ 263909 w 1327084"/>
                      <a:gd name="connsiteY23" fmla="*/ 960407 h 2494234"/>
                      <a:gd name="connsiteX24" fmla="*/ 492509 w 1327084"/>
                      <a:gd name="connsiteY24" fmla="*/ 903257 h 2494234"/>
                      <a:gd name="connsiteX25" fmla="*/ 632209 w 1327084"/>
                      <a:gd name="connsiteY25" fmla="*/ 801657 h 2494234"/>
                      <a:gd name="connsiteX26" fmla="*/ 441709 w 1327084"/>
                      <a:gd name="connsiteY26" fmla="*/ 655607 h 2494234"/>
                      <a:gd name="connsiteX27" fmla="*/ 257559 w 1327084"/>
                      <a:gd name="connsiteY27" fmla="*/ 592107 h 2494234"/>
                      <a:gd name="connsiteX28" fmla="*/ 130559 w 1327084"/>
                      <a:gd name="connsiteY28" fmla="*/ 547657 h 2494234"/>
                      <a:gd name="connsiteX29" fmla="*/ 130559 w 1327084"/>
                      <a:gd name="connsiteY29" fmla="*/ 401607 h 2494234"/>
                      <a:gd name="connsiteX30" fmla="*/ 225809 w 1327084"/>
                      <a:gd name="connsiteY30" fmla="*/ 369857 h 2494234"/>
                      <a:gd name="connsiteX31" fmla="*/ 454409 w 1327084"/>
                      <a:gd name="connsiteY31" fmla="*/ 554007 h 2494234"/>
                      <a:gd name="connsiteX32" fmla="*/ 625859 w 1327084"/>
                      <a:gd name="connsiteY32" fmla="*/ 630207 h 2494234"/>
                      <a:gd name="connsiteX33" fmla="*/ 746509 w 1327084"/>
                      <a:gd name="connsiteY33" fmla="*/ 725457 h 2494234"/>
                      <a:gd name="connsiteX34" fmla="*/ 841759 w 1327084"/>
                      <a:gd name="connsiteY34" fmla="*/ 674657 h 2494234"/>
                      <a:gd name="connsiteX35" fmla="*/ 854459 w 1327084"/>
                      <a:gd name="connsiteY35" fmla="*/ 357157 h 2494234"/>
                      <a:gd name="connsiteX36" fmla="*/ 860809 w 1327084"/>
                      <a:gd name="connsiteY36" fmla="*/ 77757 h 2494234"/>
                      <a:gd name="connsiteX37" fmla="*/ 937009 w 1327084"/>
                      <a:gd name="connsiteY37" fmla="*/ 1557 h 249423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</a:cxnLst>
                    <a:rect l="l" t="t" r="r" b="b"/>
                    <a:pathLst>
                      <a:path w="1327084" h="2494234">
                        <a:moveTo>
                          <a:pt x="937009" y="1557"/>
                        </a:moveTo>
                        <a:cubicBezTo>
                          <a:pt x="979342" y="-6910"/>
                          <a:pt x="1050251" y="21665"/>
                          <a:pt x="1114809" y="26957"/>
                        </a:cubicBezTo>
                        <a:cubicBezTo>
                          <a:pt x="1179367" y="32249"/>
                          <a:pt x="1304251" y="-9026"/>
                          <a:pt x="1324359" y="33307"/>
                        </a:cubicBezTo>
                        <a:cubicBezTo>
                          <a:pt x="1344467" y="75640"/>
                          <a:pt x="1247101" y="170890"/>
                          <a:pt x="1235459" y="280957"/>
                        </a:cubicBezTo>
                        <a:cubicBezTo>
                          <a:pt x="1223817" y="391024"/>
                          <a:pt x="1251334" y="598457"/>
                          <a:pt x="1254509" y="693707"/>
                        </a:cubicBezTo>
                        <a:cubicBezTo>
                          <a:pt x="1257684" y="788957"/>
                          <a:pt x="1254509" y="852457"/>
                          <a:pt x="1254509" y="852457"/>
                        </a:cubicBezTo>
                        <a:cubicBezTo>
                          <a:pt x="1254509" y="1109632"/>
                          <a:pt x="1248159" y="1968999"/>
                          <a:pt x="1254509" y="2236757"/>
                        </a:cubicBezTo>
                        <a:cubicBezTo>
                          <a:pt x="1260859" y="2504515"/>
                          <a:pt x="1326476" y="2417732"/>
                          <a:pt x="1292609" y="2459007"/>
                        </a:cubicBezTo>
                        <a:cubicBezTo>
                          <a:pt x="1258742" y="2500282"/>
                          <a:pt x="1114809" y="2500282"/>
                          <a:pt x="1051309" y="2484407"/>
                        </a:cubicBezTo>
                        <a:cubicBezTo>
                          <a:pt x="987809" y="2468532"/>
                          <a:pt x="933834" y="2480174"/>
                          <a:pt x="911609" y="2363757"/>
                        </a:cubicBezTo>
                        <a:cubicBezTo>
                          <a:pt x="889384" y="2247340"/>
                          <a:pt x="928542" y="1982757"/>
                          <a:pt x="917959" y="1785907"/>
                        </a:cubicBezTo>
                        <a:cubicBezTo>
                          <a:pt x="907376" y="1589057"/>
                          <a:pt x="880917" y="1267324"/>
                          <a:pt x="848109" y="1182657"/>
                        </a:cubicBezTo>
                        <a:cubicBezTo>
                          <a:pt x="815301" y="1097990"/>
                          <a:pt x="820592" y="1227107"/>
                          <a:pt x="721109" y="1277907"/>
                        </a:cubicBezTo>
                        <a:cubicBezTo>
                          <a:pt x="621626" y="1328707"/>
                          <a:pt x="350692" y="1451474"/>
                          <a:pt x="251209" y="1487457"/>
                        </a:cubicBezTo>
                        <a:cubicBezTo>
                          <a:pt x="151726" y="1523440"/>
                          <a:pt x="153842" y="1508624"/>
                          <a:pt x="124209" y="1493807"/>
                        </a:cubicBezTo>
                        <a:cubicBezTo>
                          <a:pt x="94576" y="1478990"/>
                          <a:pt x="40601" y="1429249"/>
                          <a:pt x="73409" y="1398557"/>
                        </a:cubicBezTo>
                        <a:cubicBezTo>
                          <a:pt x="106217" y="1367865"/>
                          <a:pt x="224751" y="1361515"/>
                          <a:pt x="321059" y="1309657"/>
                        </a:cubicBezTo>
                        <a:cubicBezTo>
                          <a:pt x="417367" y="1257799"/>
                          <a:pt x="606809" y="1141382"/>
                          <a:pt x="651259" y="1087407"/>
                        </a:cubicBezTo>
                        <a:cubicBezTo>
                          <a:pt x="695709" y="1033432"/>
                          <a:pt x="625859" y="985807"/>
                          <a:pt x="587759" y="985807"/>
                        </a:cubicBezTo>
                        <a:cubicBezTo>
                          <a:pt x="549659" y="985807"/>
                          <a:pt x="479809" y="1057774"/>
                          <a:pt x="422659" y="1087407"/>
                        </a:cubicBezTo>
                        <a:cubicBezTo>
                          <a:pt x="365509" y="1117040"/>
                          <a:pt x="307301" y="1148790"/>
                          <a:pt x="244859" y="1163607"/>
                        </a:cubicBezTo>
                        <a:cubicBezTo>
                          <a:pt x="182417" y="1178424"/>
                          <a:pt x="86109" y="1204882"/>
                          <a:pt x="48009" y="1176307"/>
                        </a:cubicBezTo>
                        <a:cubicBezTo>
                          <a:pt x="9909" y="1147732"/>
                          <a:pt x="-19724" y="1028140"/>
                          <a:pt x="16259" y="992157"/>
                        </a:cubicBezTo>
                        <a:cubicBezTo>
                          <a:pt x="52242" y="956174"/>
                          <a:pt x="184534" y="975224"/>
                          <a:pt x="263909" y="960407"/>
                        </a:cubicBezTo>
                        <a:cubicBezTo>
                          <a:pt x="343284" y="945590"/>
                          <a:pt x="431126" y="929715"/>
                          <a:pt x="492509" y="903257"/>
                        </a:cubicBezTo>
                        <a:cubicBezTo>
                          <a:pt x="553892" y="876799"/>
                          <a:pt x="640676" y="842932"/>
                          <a:pt x="632209" y="801657"/>
                        </a:cubicBezTo>
                        <a:cubicBezTo>
                          <a:pt x="623742" y="760382"/>
                          <a:pt x="504151" y="690532"/>
                          <a:pt x="441709" y="655607"/>
                        </a:cubicBezTo>
                        <a:cubicBezTo>
                          <a:pt x="379267" y="620682"/>
                          <a:pt x="257559" y="592107"/>
                          <a:pt x="257559" y="592107"/>
                        </a:cubicBezTo>
                        <a:cubicBezTo>
                          <a:pt x="205701" y="574115"/>
                          <a:pt x="151726" y="579407"/>
                          <a:pt x="130559" y="547657"/>
                        </a:cubicBezTo>
                        <a:cubicBezTo>
                          <a:pt x="109392" y="515907"/>
                          <a:pt x="114684" y="431240"/>
                          <a:pt x="130559" y="401607"/>
                        </a:cubicBezTo>
                        <a:cubicBezTo>
                          <a:pt x="146434" y="371974"/>
                          <a:pt x="171834" y="344457"/>
                          <a:pt x="225809" y="369857"/>
                        </a:cubicBezTo>
                        <a:cubicBezTo>
                          <a:pt x="279784" y="395257"/>
                          <a:pt x="387734" y="510615"/>
                          <a:pt x="454409" y="554007"/>
                        </a:cubicBezTo>
                        <a:cubicBezTo>
                          <a:pt x="521084" y="597399"/>
                          <a:pt x="577176" y="601632"/>
                          <a:pt x="625859" y="630207"/>
                        </a:cubicBezTo>
                        <a:cubicBezTo>
                          <a:pt x="674542" y="658782"/>
                          <a:pt x="710526" y="718049"/>
                          <a:pt x="746509" y="725457"/>
                        </a:cubicBezTo>
                        <a:cubicBezTo>
                          <a:pt x="782492" y="732865"/>
                          <a:pt x="823767" y="736040"/>
                          <a:pt x="841759" y="674657"/>
                        </a:cubicBezTo>
                        <a:cubicBezTo>
                          <a:pt x="859751" y="613274"/>
                          <a:pt x="851284" y="456640"/>
                          <a:pt x="854459" y="357157"/>
                        </a:cubicBezTo>
                        <a:cubicBezTo>
                          <a:pt x="857634" y="257674"/>
                          <a:pt x="851284" y="138082"/>
                          <a:pt x="860809" y="77757"/>
                        </a:cubicBezTo>
                        <a:cubicBezTo>
                          <a:pt x="870334" y="17432"/>
                          <a:pt x="894676" y="10024"/>
                          <a:pt x="937009" y="1557"/>
                        </a:cubicBezTo>
                        <a:close/>
                      </a:path>
                    </a:pathLst>
                  </a:custGeom>
                  <a:solidFill>
                    <a:srgbClr val="F47258"/>
                  </a:solidFill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94" name="Forma libre: forma 193">
                    <a:extLst>
                      <a:ext uri="{FF2B5EF4-FFF2-40B4-BE49-F238E27FC236}">
                        <a16:creationId xmlns:a16="http://schemas.microsoft.com/office/drawing/2014/main" id="{BE885F4B-8556-72A7-0B3B-265FF86D9B9A}"/>
                      </a:ext>
                    </a:extLst>
                  </p:cNvPr>
                  <p:cNvSpPr/>
                  <p:nvPr/>
                </p:nvSpPr>
                <p:spPr>
                  <a:xfrm>
                    <a:off x="11366309" y="2797072"/>
                    <a:ext cx="971841" cy="2790765"/>
                  </a:xfrm>
                  <a:custGeom>
                    <a:avLst/>
                    <a:gdLst>
                      <a:gd name="connsiteX0" fmla="*/ 95303 w 971841"/>
                      <a:gd name="connsiteY0" fmla="*/ 629864 h 2790765"/>
                      <a:gd name="connsiteX1" fmla="*/ 241353 w 971841"/>
                      <a:gd name="connsiteY1" fmla="*/ 826714 h 2790765"/>
                      <a:gd name="connsiteX2" fmla="*/ 387403 w 971841"/>
                      <a:gd name="connsiteY2" fmla="*/ 915614 h 2790765"/>
                      <a:gd name="connsiteX3" fmla="*/ 514403 w 971841"/>
                      <a:gd name="connsiteY3" fmla="*/ 934664 h 2790765"/>
                      <a:gd name="connsiteX4" fmla="*/ 622353 w 971841"/>
                      <a:gd name="connsiteY4" fmla="*/ 820364 h 2790765"/>
                      <a:gd name="connsiteX5" fmla="*/ 635053 w 971841"/>
                      <a:gd name="connsiteY5" fmla="*/ 445714 h 2790765"/>
                      <a:gd name="connsiteX6" fmla="*/ 609653 w 971841"/>
                      <a:gd name="connsiteY6" fmla="*/ 20264 h 2790765"/>
                      <a:gd name="connsiteX7" fmla="*/ 743003 w 971841"/>
                      <a:gd name="connsiteY7" fmla="*/ 64714 h 2790765"/>
                      <a:gd name="connsiteX8" fmla="*/ 876353 w 971841"/>
                      <a:gd name="connsiteY8" fmla="*/ 32964 h 2790765"/>
                      <a:gd name="connsiteX9" fmla="*/ 882703 w 971841"/>
                      <a:gd name="connsiteY9" fmla="*/ 83764 h 2790765"/>
                      <a:gd name="connsiteX10" fmla="*/ 863653 w 971841"/>
                      <a:gd name="connsiteY10" fmla="*/ 490164 h 2790765"/>
                      <a:gd name="connsiteX11" fmla="*/ 946203 w 971841"/>
                      <a:gd name="connsiteY11" fmla="*/ 2033214 h 2790765"/>
                      <a:gd name="connsiteX12" fmla="*/ 958903 w 971841"/>
                      <a:gd name="connsiteY12" fmla="*/ 2738064 h 2790765"/>
                      <a:gd name="connsiteX13" fmla="*/ 774753 w 971841"/>
                      <a:gd name="connsiteY13" fmla="*/ 2719014 h 2790765"/>
                      <a:gd name="connsiteX14" fmla="*/ 698553 w 971841"/>
                      <a:gd name="connsiteY14" fmla="*/ 2553914 h 2790765"/>
                      <a:gd name="connsiteX15" fmla="*/ 736653 w 971841"/>
                      <a:gd name="connsiteY15" fmla="*/ 2007814 h 2790765"/>
                      <a:gd name="connsiteX16" fmla="*/ 685853 w 971841"/>
                      <a:gd name="connsiteY16" fmla="*/ 1347414 h 2790765"/>
                      <a:gd name="connsiteX17" fmla="*/ 571553 w 971841"/>
                      <a:gd name="connsiteY17" fmla="*/ 1302964 h 2790765"/>
                      <a:gd name="connsiteX18" fmla="*/ 362003 w 971841"/>
                      <a:gd name="connsiteY18" fmla="*/ 1455364 h 2790765"/>
                      <a:gd name="connsiteX19" fmla="*/ 190553 w 971841"/>
                      <a:gd name="connsiteY19" fmla="*/ 1696664 h 2790765"/>
                      <a:gd name="connsiteX20" fmla="*/ 158803 w 971841"/>
                      <a:gd name="connsiteY20" fmla="*/ 1734764 h 2790765"/>
                      <a:gd name="connsiteX21" fmla="*/ 95303 w 971841"/>
                      <a:gd name="connsiteY21" fmla="*/ 1633164 h 2790765"/>
                      <a:gd name="connsiteX22" fmla="*/ 222303 w 971841"/>
                      <a:gd name="connsiteY22" fmla="*/ 1429964 h 2790765"/>
                      <a:gd name="connsiteX23" fmla="*/ 368353 w 971841"/>
                      <a:gd name="connsiteY23" fmla="*/ 1302964 h 2790765"/>
                      <a:gd name="connsiteX24" fmla="*/ 438203 w 971841"/>
                      <a:gd name="connsiteY24" fmla="*/ 1226764 h 2790765"/>
                      <a:gd name="connsiteX25" fmla="*/ 158803 w 971841"/>
                      <a:gd name="connsiteY25" fmla="*/ 1245814 h 2790765"/>
                      <a:gd name="connsiteX26" fmla="*/ 25453 w 971841"/>
                      <a:gd name="connsiteY26" fmla="*/ 1239464 h 2790765"/>
                      <a:gd name="connsiteX27" fmla="*/ 19103 w 971841"/>
                      <a:gd name="connsiteY27" fmla="*/ 1106114 h 2790765"/>
                      <a:gd name="connsiteX28" fmla="*/ 228653 w 971841"/>
                      <a:gd name="connsiteY28" fmla="*/ 1106114 h 2790765"/>
                      <a:gd name="connsiteX29" fmla="*/ 419153 w 971841"/>
                      <a:gd name="connsiteY29" fmla="*/ 1131514 h 2790765"/>
                      <a:gd name="connsiteX30" fmla="*/ 431853 w 971841"/>
                      <a:gd name="connsiteY30" fmla="*/ 1036264 h 2790765"/>
                      <a:gd name="connsiteX31" fmla="*/ 203253 w 971841"/>
                      <a:gd name="connsiteY31" fmla="*/ 928314 h 2790765"/>
                      <a:gd name="connsiteX32" fmla="*/ 6403 w 971841"/>
                      <a:gd name="connsiteY32" fmla="*/ 845764 h 2790765"/>
                      <a:gd name="connsiteX33" fmla="*/ 95303 w 971841"/>
                      <a:gd name="connsiteY33" fmla="*/ 629864 h 2790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</a:cxnLst>
                    <a:rect l="l" t="t" r="r" b="b"/>
                    <a:pathLst>
                      <a:path w="971841" h="2790765">
                        <a:moveTo>
                          <a:pt x="95303" y="629864"/>
                        </a:moveTo>
                        <a:cubicBezTo>
                          <a:pt x="134461" y="626689"/>
                          <a:pt x="192670" y="779089"/>
                          <a:pt x="241353" y="826714"/>
                        </a:cubicBezTo>
                        <a:cubicBezTo>
                          <a:pt x="290036" y="874339"/>
                          <a:pt x="341895" y="897622"/>
                          <a:pt x="387403" y="915614"/>
                        </a:cubicBezTo>
                        <a:cubicBezTo>
                          <a:pt x="432911" y="933606"/>
                          <a:pt x="475245" y="950539"/>
                          <a:pt x="514403" y="934664"/>
                        </a:cubicBezTo>
                        <a:cubicBezTo>
                          <a:pt x="553561" y="918789"/>
                          <a:pt x="602245" y="901856"/>
                          <a:pt x="622353" y="820364"/>
                        </a:cubicBezTo>
                        <a:cubicBezTo>
                          <a:pt x="642461" y="738872"/>
                          <a:pt x="637170" y="579064"/>
                          <a:pt x="635053" y="445714"/>
                        </a:cubicBezTo>
                        <a:cubicBezTo>
                          <a:pt x="632936" y="312364"/>
                          <a:pt x="591661" y="83764"/>
                          <a:pt x="609653" y="20264"/>
                        </a:cubicBezTo>
                        <a:cubicBezTo>
                          <a:pt x="627645" y="-43236"/>
                          <a:pt x="698553" y="62597"/>
                          <a:pt x="743003" y="64714"/>
                        </a:cubicBezTo>
                        <a:cubicBezTo>
                          <a:pt x="787453" y="66831"/>
                          <a:pt x="853070" y="29789"/>
                          <a:pt x="876353" y="32964"/>
                        </a:cubicBezTo>
                        <a:cubicBezTo>
                          <a:pt x="899636" y="36139"/>
                          <a:pt x="884820" y="7564"/>
                          <a:pt x="882703" y="83764"/>
                        </a:cubicBezTo>
                        <a:cubicBezTo>
                          <a:pt x="880586" y="159964"/>
                          <a:pt x="853070" y="165256"/>
                          <a:pt x="863653" y="490164"/>
                        </a:cubicBezTo>
                        <a:cubicBezTo>
                          <a:pt x="874236" y="815072"/>
                          <a:pt x="930328" y="1658564"/>
                          <a:pt x="946203" y="2033214"/>
                        </a:cubicBezTo>
                        <a:cubicBezTo>
                          <a:pt x="962078" y="2407864"/>
                          <a:pt x="987478" y="2623764"/>
                          <a:pt x="958903" y="2738064"/>
                        </a:cubicBezTo>
                        <a:cubicBezTo>
                          <a:pt x="930328" y="2852364"/>
                          <a:pt x="818145" y="2749706"/>
                          <a:pt x="774753" y="2719014"/>
                        </a:cubicBezTo>
                        <a:cubicBezTo>
                          <a:pt x="731361" y="2688322"/>
                          <a:pt x="704903" y="2672447"/>
                          <a:pt x="698553" y="2553914"/>
                        </a:cubicBezTo>
                        <a:cubicBezTo>
                          <a:pt x="692203" y="2435381"/>
                          <a:pt x="738770" y="2208897"/>
                          <a:pt x="736653" y="2007814"/>
                        </a:cubicBezTo>
                        <a:cubicBezTo>
                          <a:pt x="734536" y="1806731"/>
                          <a:pt x="713370" y="1464889"/>
                          <a:pt x="685853" y="1347414"/>
                        </a:cubicBezTo>
                        <a:cubicBezTo>
                          <a:pt x="658336" y="1229939"/>
                          <a:pt x="625528" y="1284972"/>
                          <a:pt x="571553" y="1302964"/>
                        </a:cubicBezTo>
                        <a:cubicBezTo>
                          <a:pt x="517578" y="1320956"/>
                          <a:pt x="425503" y="1389747"/>
                          <a:pt x="362003" y="1455364"/>
                        </a:cubicBezTo>
                        <a:cubicBezTo>
                          <a:pt x="298503" y="1520981"/>
                          <a:pt x="224420" y="1650098"/>
                          <a:pt x="190553" y="1696664"/>
                        </a:cubicBezTo>
                        <a:cubicBezTo>
                          <a:pt x="156686" y="1743230"/>
                          <a:pt x="174678" y="1745347"/>
                          <a:pt x="158803" y="1734764"/>
                        </a:cubicBezTo>
                        <a:cubicBezTo>
                          <a:pt x="142928" y="1724181"/>
                          <a:pt x="84720" y="1683964"/>
                          <a:pt x="95303" y="1633164"/>
                        </a:cubicBezTo>
                        <a:cubicBezTo>
                          <a:pt x="105886" y="1582364"/>
                          <a:pt x="176795" y="1484997"/>
                          <a:pt x="222303" y="1429964"/>
                        </a:cubicBezTo>
                        <a:cubicBezTo>
                          <a:pt x="267811" y="1374931"/>
                          <a:pt x="332370" y="1336831"/>
                          <a:pt x="368353" y="1302964"/>
                        </a:cubicBezTo>
                        <a:cubicBezTo>
                          <a:pt x="404336" y="1269097"/>
                          <a:pt x="473128" y="1236289"/>
                          <a:pt x="438203" y="1226764"/>
                        </a:cubicBezTo>
                        <a:cubicBezTo>
                          <a:pt x="403278" y="1217239"/>
                          <a:pt x="227595" y="1243697"/>
                          <a:pt x="158803" y="1245814"/>
                        </a:cubicBezTo>
                        <a:cubicBezTo>
                          <a:pt x="90011" y="1247931"/>
                          <a:pt x="48736" y="1262747"/>
                          <a:pt x="25453" y="1239464"/>
                        </a:cubicBezTo>
                        <a:cubicBezTo>
                          <a:pt x="2170" y="1216181"/>
                          <a:pt x="-14764" y="1128339"/>
                          <a:pt x="19103" y="1106114"/>
                        </a:cubicBezTo>
                        <a:cubicBezTo>
                          <a:pt x="52970" y="1083889"/>
                          <a:pt x="161978" y="1101881"/>
                          <a:pt x="228653" y="1106114"/>
                        </a:cubicBezTo>
                        <a:cubicBezTo>
                          <a:pt x="295328" y="1110347"/>
                          <a:pt x="385286" y="1143156"/>
                          <a:pt x="419153" y="1131514"/>
                        </a:cubicBezTo>
                        <a:cubicBezTo>
                          <a:pt x="453020" y="1119872"/>
                          <a:pt x="467836" y="1070131"/>
                          <a:pt x="431853" y="1036264"/>
                        </a:cubicBezTo>
                        <a:cubicBezTo>
                          <a:pt x="395870" y="1002397"/>
                          <a:pt x="274161" y="960064"/>
                          <a:pt x="203253" y="928314"/>
                        </a:cubicBezTo>
                        <a:cubicBezTo>
                          <a:pt x="132345" y="896564"/>
                          <a:pt x="25453" y="892331"/>
                          <a:pt x="6403" y="845764"/>
                        </a:cubicBezTo>
                        <a:cubicBezTo>
                          <a:pt x="-12647" y="799197"/>
                          <a:pt x="56145" y="633039"/>
                          <a:pt x="95303" y="629864"/>
                        </a:cubicBezTo>
                        <a:close/>
                      </a:path>
                    </a:pathLst>
                  </a:custGeom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95" name="Forma libre: forma 194">
                    <a:extLst>
                      <a:ext uri="{FF2B5EF4-FFF2-40B4-BE49-F238E27FC236}">
                        <a16:creationId xmlns:a16="http://schemas.microsoft.com/office/drawing/2014/main" id="{8AA7D389-98DC-20EC-AFA1-BC1CBDAA222F}"/>
                      </a:ext>
                    </a:extLst>
                  </p:cNvPr>
                  <p:cNvSpPr/>
                  <p:nvPr/>
                </p:nvSpPr>
                <p:spPr>
                  <a:xfrm>
                    <a:off x="9779337" y="2300507"/>
                    <a:ext cx="1916526" cy="3347037"/>
                  </a:xfrm>
                  <a:custGeom>
                    <a:avLst/>
                    <a:gdLst>
                      <a:gd name="connsiteX0" fmla="*/ 914400 w 1916526"/>
                      <a:gd name="connsiteY0" fmla="*/ 0 h 3347037"/>
                      <a:gd name="connsiteX1" fmla="*/ 1828800 w 1916526"/>
                      <a:gd name="connsiteY1" fmla="*/ 864454 h 3347037"/>
                      <a:gd name="connsiteX2" fmla="*/ 1738631 w 1916526"/>
                      <a:gd name="connsiteY2" fmla="*/ 1239231 h 3347037"/>
                      <a:gd name="connsiteX3" fmla="*/ 1680293 w 1916526"/>
                      <a:gd name="connsiteY3" fmla="*/ 1335184 h 3347037"/>
                      <a:gd name="connsiteX4" fmla="*/ 1703909 w 1916526"/>
                      <a:gd name="connsiteY4" fmla="*/ 1394010 h 3347037"/>
                      <a:gd name="connsiteX5" fmla="*/ 1741074 w 1916526"/>
                      <a:gd name="connsiteY5" fmla="*/ 1618130 h 3347037"/>
                      <a:gd name="connsiteX6" fmla="*/ 1703909 w 1916526"/>
                      <a:gd name="connsiteY6" fmla="*/ 1842250 h 3347037"/>
                      <a:gd name="connsiteX7" fmla="*/ 1678522 w 1916526"/>
                      <a:gd name="connsiteY7" fmla="*/ 1905487 h 3347037"/>
                      <a:gd name="connsiteX8" fmla="*/ 1760361 w 1916526"/>
                      <a:gd name="connsiteY8" fmla="*/ 1999259 h 3347037"/>
                      <a:gd name="connsiteX9" fmla="*/ 1916526 w 1916526"/>
                      <a:gd name="connsiteY9" fmla="*/ 2482583 h 3347037"/>
                      <a:gd name="connsiteX10" fmla="*/ 1002126 w 1916526"/>
                      <a:gd name="connsiteY10" fmla="*/ 3347037 h 3347037"/>
                      <a:gd name="connsiteX11" fmla="*/ 87726 w 1916526"/>
                      <a:gd name="connsiteY11" fmla="*/ 2482583 h 3347037"/>
                      <a:gd name="connsiteX12" fmla="*/ 95073 w 1916526"/>
                      <a:gd name="connsiteY12" fmla="*/ 2372483 h 3347037"/>
                      <a:gd name="connsiteX13" fmla="*/ 104255 w 1916526"/>
                      <a:gd name="connsiteY13" fmla="*/ 2327114 h 3347037"/>
                      <a:gd name="connsiteX14" fmla="*/ 64964 w 1916526"/>
                      <a:gd name="connsiteY14" fmla="*/ 2261119 h 3347037"/>
                      <a:gd name="connsiteX15" fmla="*/ 0 w 1916526"/>
                      <a:gd name="connsiteY15" fmla="*/ 1967754 h 3347037"/>
                      <a:gd name="connsiteX16" fmla="*/ 16795 w 1916526"/>
                      <a:gd name="connsiteY16" fmla="*/ 1815862 h 3347037"/>
                      <a:gd name="connsiteX17" fmla="*/ 32842 w 1916526"/>
                      <a:gd name="connsiteY17" fmla="*/ 1758966 h 3347037"/>
                      <a:gd name="connsiteX18" fmla="*/ 10325 w 1916526"/>
                      <a:gd name="connsiteY18" fmla="*/ 1673548 h 3347037"/>
                      <a:gd name="connsiteX19" fmla="*/ 0 w 1916526"/>
                      <a:gd name="connsiteY19" fmla="*/ 1554097 h 3347037"/>
                      <a:gd name="connsiteX20" fmla="*/ 16795 w 1916526"/>
                      <a:gd name="connsiteY20" fmla="*/ 1402205 h 3347037"/>
                      <a:gd name="connsiteX21" fmla="*/ 32289 w 1916526"/>
                      <a:gd name="connsiteY21" fmla="*/ 1347269 h 3347037"/>
                      <a:gd name="connsiteX22" fmla="*/ 16795 w 1916526"/>
                      <a:gd name="connsiteY22" fmla="*/ 1292332 h 3347037"/>
                      <a:gd name="connsiteX23" fmla="*/ 0 w 1916526"/>
                      <a:gd name="connsiteY23" fmla="*/ 1140440 h 3347037"/>
                      <a:gd name="connsiteX24" fmla="*/ 4268 w 1916526"/>
                      <a:gd name="connsiteY24" fmla="*/ 1063381 h 3347037"/>
                      <a:gd name="connsiteX25" fmla="*/ 13583 w 1916526"/>
                      <a:gd name="connsiteY25" fmla="*/ 1007735 h 3347037"/>
                      <a:gd name="connsiteX26" fmla="*/ 4721 w 1916526"/>
                      <a:gd name="connsiteY26" fmla="*/ 952840 h 3347037"/>
                      <a:gd name="connsiteX27" fmla="*/ 0 w 1916526"/>
                      <a:gd name="connsiteY27" fmla="*/ 864454 h 3347037"/>
                      <a:gd name="connsiteX28" fmla="*/ 914400 w 1916526"/>
                      <a:gd name="connsiteY28" fmla="*/ 0 h 33470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</a:cxnLst>
                    <a:rect l="l" t="t" r="r" b="b"/>
                    <a:pathLst>
                      <a:path w="1916526" h="3347037">
                        <a:moveTo>
                          <a:pt x="914400" y="0"/>
                        </a:moveTo>
                        <a:cubicBezTo>
                          <a:pt x="1419409" y="0"/>
                          <a:pt x="1828800" y="387029"/>
                          <a:pt x="1828800" y="864454"/>
                        </a:cubicBezTo>
                        <a:cubicBezTo>
                          <a:pt x="1828800" y="998730"/>
                          <a:pt x="1796417" y="1125855"/>
                          <a:pt x="1738631" y="1239231"/>
                        </a:cubicBezTo>
                        <a:lnTo>
                          <a:pt x="1680293" y="1335184"/>
                        </a:lnTo>
                        <a:lnTo>
                          <a:pt x="1703909" y="1394010"/>
                        </a:lnTo>
                        <a:cubicBezTo>
                          <a:pt x="1728062" y="1464809"/>
                          <a:pt x="1741074" y="1540084"/>
                          <a:pt x="1741074" y="1618130"/>
                        </a:cubicBezTo>
                        <a:cubicBezTo>
                          <a:pt x="1741074" y="1696176"/>
                          <a:pt x="1728062" y="1771451"/>
                          <a:pt x="1703909" y="1842250"/>
                        </a:cubicBezTo>
                        <a:lnTo>
                          <a:pt x="1678522" y="1905487"/>
                        </a:lnTo>
                        <a:lnTo>
                          <a:pt x="1760361" y="1999259"/>
                        </a:lnTo>
                        <a:cubicBezTo>
                          <a:pt x="1858956" y="2137226"/>
                          <a:pt x="1916526" y="2303549"/>
                          <a:pt x="1916526" y="2482583"/>
                        </a:cubicBezTo>
                        <a:cubicBezTo>
                          <a:pt x="1916526" y="2960008"/>
                          <a:pt x="1507135" y="3347037"/>
                          <a:pt x="1002126" y="3347037"/>
                        </a:cubicBezTo>
                        <a:cubicBezTo>
                          <a:pt x="497117" y="3347037"/>
                          <a:pt x="87726" y="2960008"/>
                          <a:pt x="87726" y="2482583"/>
                        </a:cubicBezTo>
                        <a:cubicBezTo>
                          <a:pt x="87726" y="2445284"/>
                          <a:pt x="90225" y="2408537"/>
                          <a:pt x="95073" y="2372483"/>
                        </a:cubicBezTo>
                        <a:lnTo>
                          <a:pt x="104255" y="2327114"/>
                        </a:lnTo>
                        <a:lnTo>
                          <a:pt x="64964" y="2261119"/>
                        </a:lnTo>
                        <a:cubicBezTo>
                          <a:pt x="23132" y="2170950"/>
                          <a:pt x="0" y="2071815"/>
                          <a:pt x="0" y="1967754"/>
                        </a:cubicBezTo>
                        <a:cubicBezTo>
                          <a:pt x="0" y="1915724"/>
                          <a:pt x="5783" y="1864925"/>
                          <a:pt x="16795" y="1815862"/>
                        </a:cubicBezTo>
                        <a:lnTo>
                          <a:pt x="32842" y="1758966"/>
                        </a:lnTo>
                        <a:lnTo>
                          <a:pt x="10325" y="1673548"/>
                        </a:lnTo>
                        <a:cubicBezTo>
                          <a:pt x="3530" y="1634643"/>
                          <a:pt x="0" y="1594746"/>
                          <a:pt x="0" y="1554097"/>
                        </a:cubicBezTo>
                        <a:cubicBezTo>
                          <a:pt x="0" y="1502067"/>
                          <a:pt x="5783" y="1451268"/>
                          <a:pt x="16795" y="1402205"/>
                        </a:cubicBezTo>
                        <a:lnTo>
                          <a:pt x="32289" y="1347269"/>
                        </a:lnTo>
                        <a:lnTo>
                          <a:pt x="16795" y="1292332"/>
                        </a:lnTo>
                        <a:cubicBezTo>
                          <a:pt x="5783" y="1243270"/>
                          <a:pt x="0" y="1192471"/>
                          <a:pt x="0" y="1140440"/>
                        </a:cubicBezTo>
                        <a:cubicBezTo>
                          <a:pt x="0" y="1114425"/>
                          <a:pt x="1446" y="1088717"/>
                          <a:pt x="4268" y="1063381"/>
                        </a:cubicBezTo>
                        <a:lnTo>
                          <a:pt x="13583" y="1007735"/>
                        </a:lnTo>
                        <a:lnTo>
                          <a:pt x="4721" y="952840"/>
                        </a:lnTo>
                        <a:cubicBezTo>
                          <a:pt x="1599" y="923779"/>
                          <a:pt x="0" y="894293"/>
                          <a:pt x="0" y="864454"/>
                        </a:cubicBezTo>
                        <a:cubicBezTo>
                          <a:pt x="0" y="387029"/>
                          <a:pt x="409391" y="0"/>
                          <a:pt x="914400" y="0"/>
                        </a:cubicBezTo>
                        <a:close/>
                      </a:path>
                    </a:pathLst>
                  </a:custGeom>
                  <a:solidFill>
                    <a:srgbClr val="D04E46"/>
                  </a:solidFill>
                  <a:ln w="349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wrap="square" rtlCol="0" anchor="ctr">
                    <a:no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88" name="Forma libre: forma 187">
                <a:extLst>
                  <a:ext uri="{FF2B5EF4-FFF2-40B4-BE49-F238E27FC236}">
                    <a16:creationId xmlns:a16="http://schemas.microsoft.com/office/drawing/2014/main" id="{EAF678D7-EC09-153E-4BE7-DC03431C809F}"/>
                  </a:ext>
                </a:extLst>
              </p:cNvPr>
              <p:cNvSpPr/>
              <p:nvPr/>
            </p:nvSpPr>
            <p:spPr>
              <a:xfrm>
                <a:off x="9870190" y="3144907"/>
                <a:ext cx="1056954" cy="842918"/>
              </a:xfrm>
              <a:custGeom>
                <a:avLst/>
                <a:gdLst>
                  <a:gd name="connsiteX0" fmla="*/ 59048 w 1056954"/>
                  <a:gd name="connsiteY0" fmla="*/ 59984 h 842918"/>
                  <a:gd name="connsiteX1" fmla="*/ 8248 w 1056954"/>
                  <a:gd name="connsiteY1" fmla="*/ 193334 h 842918"/>
                  <a:gd name="connsiteX2" fmla="*/ 1898 w 1056954"/>
                  <a:gd name="connsiteY2" fmla="*/ 390184 h 842918"/>
                  <a:gd name="connsiteX3" fmla="*/ 27298 w 1056954"/>
                  <a:gd name="connsiteY3" fmla="*/ 631484 h 842918"/>
                  <a:gd name="connsiteX4" fmla="*/ 78098 w 1056954"/>
                  <a:gd name="connsiteY4" fmla="*/ 828334 h 842918"/>
                  <a:gd name="connsiteX5" fmla="*/ 363848 w 1056954"/>
                  <a:gd name="connsiteY5" fmla="*/ 821984 h 842918"/>
                  <a:gd name="connsiteX6" fmla="*/ 713098 w 1056954"/>
                  <a:gd name="connsiteY6" fmla="*/ 771184 h 842918"/>
                  <a:gd name="connsiteX7" fmla="*/ 941698 w 1056954"/>
                  <a:gd name="connsiteY7" fmla="*/ 631484 h 842918"/>
                  <a:gd name="connsiteX8" fmla="*/ 1049648 w 1056954"/>
                  <a:gd name="connsiteY8" fmla="*/ 453684 h 842918"/>
                  <a:gd name="connsiteX9" fmla="*/ 1017898 w 1056954"/>
                  <a:gd name="connsiteY9" fmla="*/ 206034 h 842918"/>
                  <a:gd name="connsiteX10" fmla="*/ 782948 w 1056954"/>
                  <a:gd name="connsiteY10" fmla="*/ 40934 h 842918"/>
                  <a:gd name="connsiteX11" fmla="*/ 528948 w 1056954"/>
                  <a:gd name="connsiteY11" fmla="*/ 2834 h 842918"/>
                  <a:gd name="connsiteX12" fmla="*/ 141598 w 1056954"/>
                  <a:gd name="connsiteY12" fmla="*/ 9184 h 842918"/>
                  <a:gd name="connsiteX13" fmla="*/ 59048 w 1056954"/>
                  <a:gd name="connsiteY13" fmla="*/ 59984 h 8429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56954" h="842918">
                    <a:moveTo>
                      <a:pt x="59048" y="59984"/>
                    </a:moveTo>
                    <a:cubicBezTo>
                      <a:pt x="36823" y="90676"/>
                      <a:pt x="17773" y="138301"/>
                      <a:pt x="8248" y="193334"/>
                    </a:cubicBezTo>
                    <a:cubicBezTo>
                      <a:pt x="-1277" y="248367"/>
                      <a:pt x="-1277" y="317159"/>
                      <a:pt x="1898" y="390184"/>
                    </a:cubicBezTo>
                    <a:cubicBezTo>
                      <a:pt x="5073" y="463209"/>
                      <a:pt x="14598" y="558459"/>
                      <a:pt x="27298" y="631484"/>
                    </a:cubicBezTo>
                    <a:cubicBezTo>
                      <a:pt x="39998" y="704509"/>
                      <a:pt x="22006" y="796584"/>
                      <a:pt x="78098" y="828334"/>
                    </a:cubicBezTo>
                    <a:cubicBezTo>
                      <a:pt x="134190" y="860084"/>
                      <a:pt x="258015" y="831509"/>
                      <a:pt x="363848" y="821984"/>
                    </a:cubicBezTo>
                    <a:cubicBezTo>
                      <a:pt x="469681" y="812459"/>
                      <a:pt x="616790" y="802934"/>
                      <a:pt x="713098" y="771184"/>
                    </a:cubicBezTo>
                    <a:cubicBezTo>
                      <a:pt x="809406" y="739434"/>
                      <a:pt x="885606" y="684401"/>
                      <a:pt x="941698" y="631484"/>
                    </a:cubicBezTo>
                    <a:cubicBezTo>
                      <a:pt x="997790" y="578567"/>
                      <a:pt x="1036948" y="524592"/>
                      <a:pt x="1049648" y="453684"/>
                    </a:cubicBezTo>
                    <a:cubicBezTo>
                      <a:pt x="1062348" y="382776"/>
                      <a:pt x="1062348" y="274826"/>
                      <a:pt x="1017898" y="206034"/>
                    </a:cubicBezTo>
                    <a:cubicBezTo>
                      <a:pt x="973448" y="137242"/>
                      <a:pt x="864440" y="74801"/>
                      <a:pt x="782948" y="40934"/>
                    </a:cubicBezTo>
                    <a:cubicBezTo>
                      <a:pt x="701456" y="7067"/>
                      <a:pt x="635840" y="8126"/>
                      <a:pt x="528948" y="2834"/>
                    </a:cubicBezTo>
                    <a:cubicBezTo>
                      <a:pt x="422056" y="-2458"/>
                      <a:pt x="220973" y="-341"/>
                      <a:pt x="141598" y="9184"/>
                    </a:cubicBezTo>
                    <a:cubicBezTo>
                      <a:pt x="62223" y="18709"/>
                      <a:pt x="81273" y="29292"/>
                      <a:pt x="59048" y="599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9" name="Forma libre: forma 188">
                <a:extLst>
                  <a:ext uri="{FF2B5EF4-FFF2-40B4-BE49-F238E27FC236}">
                    <a16:creationId xmlns:a16="http://schemas.microsoft.com/office/drawing/2014/main" id="{3829A962-6E15-55C5-6D90-FA8810EF96A1}"/>
                  </a:ext>
                </a:extLst>
              </p:cNvPr>
              <p:cNvSpPr/>
              <p:nvPr/>
            </p:nvSpPr>
            <p:spPr>
              <a:xfrm>
                <a:off x="9951062" y="3913907"/>
                <a:ext cx="1131010" cy="793354"/>
              </a:xfrm>
              <a:custGeom>
                <a:avLst/>
                <a:gdLst>
                  <a:gd name="connsiteX0" fmla="*/ 9926 w 1131010"/>
                  <a:gd name="connsiteY0" fmla="*/ 256184 h 793354"/>
                  <a:gd name="connsiteX1" fmla="*/ 35326 w 1131010"/>
                  <a:gd name="connsiteY1" fmla="*/ 459384 h 793354"/>
                  <a:gd name="connsiteX2" fmla="*/ 187726 w 1131010"/>
                  <a:gd name="connsiteY2" fmla="*/ 630834 h 793354"/>
                  <a:gd name="connsiteX3" fmla="*/ 384576 w 1131010"/>
                  <a:gd name="connsiteY3" fmla="*/ 770534 h 793354"/>
                  <a:gd name="connsiteX4" fmla="*/ 625876 w 1131010"/>
                  <a:gd name="connsiteY4" fmla="*/ 789584 h 793354"/>
                  <a:gd name="connsiteX5" fmla="*/ 835426 w 1131010"/>
                  <a:gd name="connsiteY5" fmla="*/ 732434 h 793354"/>
                  <a:gd name="connsiteX6" fmla="*/ 1025926 w 1131010"/>
                  <a:gd name="connsiteY6" fmla="*/ 573684 h 793354"/>
                  <a:gd name="connsiteX7" fmla="*/ 1127526 w 1131010"/>
                  <a:gd name="connsiteY7" fmla="*/ 332384 h 793354"/>
                  <a:gd name="connsiteX8" fmla="*/ 1089426 w 1131010"/>
                  <a:gd name="connsiteY8" fmla="*/ 65684 h 793354"/>
                  <a:gd name="connsiteX9" fmla="*/ 917976 w 1131010"/>
                  <a:gd name="connsiteY9" fmla="*/ 2184 h 793354"/>
                  <a:gd name="connsiteX10" fmla="*/ 727476 w 1131010"/>
                  <a:gd name="connsiteY10" fmla="*/ 21234 h 793354"/>
                  <a:gd name="connsiteX11" fmla="*/ 511576 w 1131010"/>
                  <a:gd name="connsiteY11" fmla="*/ 84734 h 793354"/>
                  <a:gd name="connsiteX12" fmla="*/ 327426 w 1131010"/>
                  <a:gd name="connsiteY12" fmla="*/ 116484 h 793354"/>
                  <a:gd name="connsiteX13" fmla="*/ 168676 w 1131010"/>
                  <a:gd name="connsiteY13" fmla="*/ 122834 h 793354"/>
                  <a:gd name="connsiteX14" fmla="*/ 9926 w 1131010"/>
                  <a:gd name="connsiteY14" fmla="*/ 256184 h 793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1131010" h="793354">
                    <a:moveTo>
                      <a:pt x="9926" y="256184"/>
                    </a:moveTo>
                    <a:cubicBezTo>
                      <a:pt x="-12299" y="312276"/>
                      <a:pt x="5693" y="396942"/>
                      <a:pt x="35326" y="459384"/>
                    </a:cubicBezTo>
                    <a:cubicBezTo>
                      <a:pt x="64959" y="521826"/>
                      <a:pt x="129518" y="578976"/>
                      <a:pt x="187726" y="630834"/>
                    </a:cubicBezTo>
                    <a:cubicBezTo>
                      <a:pt x="245934" y="682692"/>
                      <a:pt x="311551" y="744076"/>
                      <a:pt x="384576" y="770534"/>
                    </a:cubicBezTo>
                    <a:cubicBezTo>
                      <a:pt x="457601" y="796992"/>
                      <a:pt x="550734" y="795934"/>
                      <a:pt x="625876" y="789584"/>
                    </a:cubicBezTo>
                    <a:cubicBezTo>
                      <a:pt x="701018" y="783234"/>
                      <a:pt x="768751" y="768417"/>
                      <a:pt x="835426" y="732434"/>
                    </a:cubicBezTo>
                    <a:cubicBezTo>
                      <a:pt x="902101" y="696451"/>
                      <a:pt x="977243" y="640359"/>
                      <a:pt x="1025926" y="573684"/>
                    </a:cubicBezTo>
                    <a:cubicBezTo>
                      <a:pt x="1074609" y="507009"/>
                      <a:pt x="1116943" y="417051"/>
                      <a:pt x="1127526" y="332384"/>
                    </a:cubicBezTo>
                    <a:cubicBezTo>
                      <a:pt x="1138109" y="247717"/>
                      <a:pt x="1124351" y="120717"/>
                      <a:pt x="1089426" y="65684"/>
                    </a:cubicBezTo>
                    <a:cubicBezTo>
                      <a:pt x="1054501" y="10651"/>
                      <a:pt x="978301" y="9592"/>
                      <a:pt x="917976" y="2184"/>
                    </a:cubicBezTo>
                    <a:cubicBezTo>
                      <a:pt x="857651" y="-5224"/>
                      <a:pt x="795209" y="7476"/>
                      <a:pt x="727476" y="21234"/>
                    </a:cubicBezTo>
                    <a:cubicBezTo>
                      <a:pt x="659743" y="34992"/>
                      <a:pt x="578251" y="68859"/>
                      <a:pt x="511576" y="84734"/>
                    </a:cubicBezTo>
                    <a:cubicBezTo>
                      <a:pt x="444901" y="100609"/>
                      <a:pt x="384576" y="110134"/>
                      <a:pt x="327426" y="116484"/>
                    </a:cubicBezTo>
                    <a:cubicBezTo>
                      <a:pt x="270276" y="122834"/>
                      <a:pt x="222651" y="104842"/>
                      <a:pt x="168676" y="122834"/>
                    </a:cubicBezTo>
                    <a:cubicBezTo>
                      <a:pt x="114701" y="140826"/>
                      <a:pt x="32151" y="200092"/>
                      <a:pt x="9926" y="2561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90" name="Forma libre: forma 189">
                <a:extLst>
                  <a:ext uri="{FF2B5EF4-FFF2-40B4-BE49-F238E27FC236}">
                    <a16:creationId xmlns:a16="http://schemas.microsoft.com/office/drawing/2014/main" id="{710B943A-AFEB-D59F-B9B9-4E673E4511E0}"/>
                  </a:ext>
                </a:extLst>
              </p:cNvPr>
              <p:cNvSpPr/>
              <p:nvPr/>
            </p:nvSpPr>
            <p:spPr>
              <a:xfrm>
                <a:off x="9878417" y="2403616"/>
                <a:ext cx="1098835" cy="717462"/>
              </a:xfrm>
              <a:custGeom>
                <a:avLst/>
                <a:gdLst>
                  <a:gd name="connsiteX0" fmla="*/ 69871 w 1098835"/>
                  <a:gd name="connsiteY0" fmla="*/ 229775 h 717462"/>
                  <a:gd name="connsiteX1" fmla="*/ 21 w 1098835"/>
                  <a:gd name="connsiteY1" fmla="*/ 394875 h 717462"/>
                  <a:gd name="connsiteX2" fmla="*/ 76221 w 1098835"/>
                  <a:gd name="connsiteY2" fmla="*/ 579025 h 717462"/>
                  <a:gd name="connsiteX3" fmla="*/ 215921 w 1098835"/>
                  <a:gd name="connsiteY3" fmla="*/ 661575 h 717462"/>
                  <a:gd name="connsiteX4" fmla="*/ 533421 w 1098835"/>
                  <a:gd name="connsiteY4" fmla="*/ 648875 h 717462"/>
                  <a:gd name="connsiteX5" fmla="*/ 857271 w 1098835"/>
                  <a:gd name="connsiteY5" fmla="*/ 712375 h 717462"/>
                  <a:gd name="connsiteX6" fmla="*/ 1003321 w 1098835"/>
                  <a:gd name="connsiteY6" fmla="*/ 686975 h 717462"/>
                  <a:gd name="connsiteX7" fmla="*/ 1098571 w 1098835"/>
                  <a:gd name="connsiteY7" fmla="*/ 477425 h 717462"/>
                  <a:gd name="connsiteX8" fmla="*/ 1022371 w 1098835"/>
                  <a:gd name="connsiteY8" fmla="*/ 153575 h 717462"/>
                  <a:gd name="connsiteX9" fmla="*/ 774721 w 1098835"/>
                  <a:gd name="connsiteY9" fmla="*/ 20225 h 717462"/>
                  <a:gd name="connsiteX10" fmla="*/ 571521 w 1098835"/>
                  <a:gd name="connsiteY10" fmla="*/ 1175 h 717462"/>
                  <a:gd name="connsiteX11" fmla="*/ 368321 w 1098835"/>
                  <a:gd name="connsiteY11" fmla="*/ 26575 h 717462"/>
                  <a:gd name="connsiteX12" fmla="*/ 196871 w 1098835"/>
                  <a:gd name="connsiteY12" fmla="*/ 115475 h 717462"/>
                  <a:gd name="connsiteX13" fmla="*/ 69871 w 1098835"/>
                  <a:gd name="connsiteY13" fmla="*/ 229775 h 7174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98835" h="717462">
                    <a:moveTo>
                      <a:pt x="69871" y="229775"/>
                    </a:moveTo>
                    <a:cubicBezTo>
                      <a:pt x="37063" y="276342"/>
                      <a:pt x="-1037" y="336667"/>
                      <a:pt x="21" y="394875"/>
                    </a:cubicBezTo>
                    <a:cubicBezTo>
                      <a:pt x="1079" y="453083"/>
                      <a:pt x="40238" y="534575"/>
                      <a:pt x="76221" y="579025"/>
                    </a:cubicBezTo>
                    <a:cubicBezTo>
                      <a:pt x="112204" y="623475"/>
                      <a:pt x="139721" y="649933"/>
                      <a:pt x="215921" y="661575"/>
                    </a:cubicBezTo>
                    <a:cubicBezTo>
                      <a:pt x="292121" y="673217"/>
                      <a:pt x="426529" y="640408"/>
                      <a:pt x="533421" y="648875"/>
                    </a:cubicBezTo>
                    <a:cubicBezTo>
                      <a:pt x="640313" y="657342"/>
                      <a:pt x="778954" y="706025"/>
                      <a:pt x="857271" y="712375"/>
                    </a:cubicBezTo>
                    <a:cubicBezTo>
                      <a:pt x="935588" y="718725"/>
                      <a:pt x="963104" y="726133"/>
                      <a:pt x="1003321" y="686975"/>
                    </a:cubicBezTo>
                    <a:cubicBezTo>
                      <a:pt x="1043538" y="647817"/>
                      <a:pt x="1095396" y="566325"/>
                      <a:pt x="1098571" y="477425"/>
                    </a:cubicBezTo>
                    <a:cubicBezTo>
                      <a:pt x="1101746" y="388525"/>
                      <a:pt x="1076346" y="229775"/>
                      <a:pt x="1022371" y="153575"/>
                    </a:cubicBezTo>
                    <a:cubicBezTo>
                      <a:pt x="968396" y="77375"/>
                      <a:pt x="849863" y="45625"/>
                      <a:pt x="774721" y="20225"/>
                    </a:cubicBezTo>
                    <a:cubicBezTo>
                      <a:pt x="699579" y="-5175"/>
                      <a:pt x="639254" y="117"/>
                      <a:pt x="571521" y="1175"/>
                    </a:cubicBezTo>
                    <a:cubicBezTo>
                      <a:pt x="503788" y="2233"/>
                      <a:pt x="430763" y="7525"/>
                      <a:pt x="368321" y="26575"/>
                    </a:cubicBezTo>
                    <a:cubicBezTo>
                      <a:pt x="305879" y="45625"/>
                      <a:pt x="243438" y="87958"/>
                      <a:pt x="196871" y="115475"/>
                    </a:cubicBezTo>
                    <a:cubicBezTo>
                      <a:pt x="150304" y="142992"/>
                      <a:pt x="102679" y="183208"/>
                      <a:pt x="69871" y="229775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  <p:grpSp>
          <p:nvGrpSpPr>
            <p:cNvPr id="82" name="Grupo 133">
              <a:extLst>
                <a:ext uri="{FF2B5EF4-FFF2-40B4-BE49-F238E27FC236}">
                  <a16:creationId xmlns:a16="http://schemas.microsoft.com/office/drawing/2014/main" id="{C6DB8D82-0848-8372-9B84-7E6094DEACFF}"/>
                </a:ext>
              </a:extLst>
            </p:cNvPr>
            <p:cNvGrpSpPr/>
            <p:nvPr/>
          </p:nvGrpSpPr>
          <p:grpSpPr>
            <a:xfrm>
              <a:off x="9169942" y="3975713"/>
              <a:ext cx="1634014" cy="1634014"/>
              <a:chOff x="9169942" y="3975713"/>
              <a:chExt cx="1634014" cy="1634014"/>
            </a:xfrm>
          </p:grpSpPr>
          <p:sp>
            <p:nvSpPr>
              <p:cNvPr id="83" name="Elipse 121">
                <a:extLst>
                  <a:ext uri="{FF2B5EF4-FFF2-40B4-BE49-F238E27FC236}">
                    <a16:creationId xmlns:a16="http://schemas.microsoft.com/office/drawing/2014/main" id="{55E1AB83-3658-128E-7D8E-C6953AA2268A}"/>
                  </a:ext>
                </a:extLst>
              </p:cNvPr>
              <p:cNvSpPr/>
              <p:nvPr/>
            </p:nvSpPr>
            <p:spPr>
              <a:xfrm>
                <a:off x="9169942" y="3975713"/>
                <a:ext cx="1634014" cy="1634014"/>
              </a:xfrm>
              <a:prstGeom prst="ellipse">
                <a:avLst/>
              </a:prstGeom>
              <a:solidFill>
                <a:schemeClr val="accent4">
                  <a:lumMod val="50000"/>
                </a:schemeClr>
              </a:solidFill>
              <a:ln w="349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84" name="Elipse 122">
                <a:extLst>
                  <a:ext uri="{FF2B5EF4-FFF2-40B4-BE49-F238E27FC236}">
                    <a16:creationId xmlns:a16="http://schemas.microsoft.com/office/drawing/2014/main" id="{DB2AF4C9-D5CD-260A-F4A6-CF73D73BAD65}"/>
                  </a:ext>
                </a:extLst>
              </p:cNvPr>
              <p:cNvSpPr/>
              <p:nvPr/>
            </p:nvSpPr>
            <p:spPr>
              <a:xfrm>
                <a:off x="10033715" y="4107229"/>
                <a:ext cx="578503" cy="570113"/>
              </a:xfrm>
              <a:prstGeom prst="ellipse">
                <a:avLst/>
              </a:prstGeom>
              <a:solidFill>
                <a:schemeClr val="tx1"/>
              </a:solidFill>
              <a:ln w="2222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5" name="Elipse 123">
                <a:extLst>
                  <a:ext uri="{FF2B5EF4-FFF2-40B4-BE49-F238E27FC236}">
                    <a16:creationId xmlns:a16="http://schemas.microsoft.com/office/drawing/2014/main" id="{024F22E4-3BAC-36A5-B48F-1BE86293C047}"/>
                  </a:ext>
                </a:extLst>
              </p:cNvPr>
              <p:cNvSpPr/>
              <p:nvPr/>
            </p:nvSpPr>
            <p:spPr>
              <a:xfrm>
                <a:off x="9188998" y="4528627"/>
                <a:ext cx="578503" cy="570113"/>
              </a:xfrm>
              <a:prstGeom prst="ellipse">
                <a:avLst/>
              </a:prstGeom>
              <a:solidFill>
                <a:schemeClr val="tx1"/>
              </a:solidFill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6" name="Elipse 124">
                <a:extLst>
                  <a:ext uri="{FF2B5EF4-FFF2-40B4-BE49-F238E27FC236}">
                    <a16:creationId xmlns:a16="http://schemas.microsoft.com/office/drawing/2014/main" id="{5C0ED6EB-90E2-94CF-5AA8-43CD091385A5}"/>
                  </a:ext>
                </a:extLst>
              </p:cNvPr>
              <p:cNvSpPr/>
              <p:nvPr/>
            </p:nvSpPr>
            <p:spPr>
              <a:xfrm>
                <a:off x="9800185" y="4983571"/>
                <a:ext cx="703900" cy="579438"/>
              </a:xfrm>
              <a:prstGeom prst="ellipse">
                <a:avLst/>
              </a:prstGeom>
              <a:solidFill>
                <a:schemeClr val="tx1"/>
              </a:solidFill>
              <a:ln w="2222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</p:grpSp>
      </p:grpSp>
      <p:grpSp>
        <p:nvGrpSpPr>
          <p:cNvPr id="7" name="Grupo 38">
            <a:extLst>
              <a:ext uri="{FF2B5EF4-FFF2-40B4-BE49-F238E27FC236}">
                <a16:creationId xmlns:a16="http://schemas.microsoft.com/office/drawing/2014/main" id="{E08A0DA6-D7D4-01F2-4E9F-2CEB1044874E}"/>
              </a:ext>
            </a:extLst>
          </p:cNvPr>
          <p:cNvGrpSpPr/>
          <p:nvPr/>
        </p:nvGrpSpPr>
        <p:grpSpPr>
          <a:xfrm>
            <a:off x="3885803" y="2247160"/>
            <a:ext cx="1445113" cy="1947577"/>
            <a:chOff x="6201146" y="2280216"/>
            <a:chExt cx="2539611" cy="3348725"/>
          </a:xfrm>
        </p:grpSpPr>
        <p:grpSp>
          <p:nvGrpSpPr>
            <p:cNvPr id="45" name="Grupo 175">
              <a:extLst>
                <a:ext uri="{FF2B5EF4-FFF2-40B4-BE49-F238E27FC236}">
                  <a16:creationId xmlns:a16="http://schemas.microsoft.com/office/drawing/2014/main" id="{EED3CBCD-82CC-F4EC-1785-782B58C4AA3B}"/>
                </a:ext>
              </a:extLst>
            </p:cNvPr>
            <p:cNvGrpSpPr/>
            <p:nvPr/>
          </p:nvGrpSpPr>
          <p:grpSpPr>
            <a:xfrm>
              <a:off x="6691520" y="2280216"/>
              <a:ext cx="2049237" cy="2724101"/>
              <a:chOff x="6691520" y="2280216"/>
              <a:chExt cx="2049237" cy="2724101"/>
            </a:xfrm>
          </p:grpSpPr>
          <p:grpSp>
            <p:nvGrpSpPr>
              <p:cNvPr id="72" name="Grupo 176">
                <a:extLst>
                  <a:ext uri="{FF2B5EF4-FFF2-40B4-BE49-F238E27FC236}">
                    <a16:creationId xmlns:a16="http://schemas.microsoft.com/office/drawing/2014/main" id="{302AFF66-4FFC-C63B-7537-95C5E4D360F8}"/>
                  </a:ext>
                </a:extLst>
              </p:cNvPr>
              <p:cNvGrpSpPr/>
              <p:nvPr/>
            </p:nvGrpSpPr>
            <p:grpSpPr>
              <a:xfrm>
                <a:off x="6691520" y="2280216"/>
                <a:ext cx="2049237" cy="2724101"/>
                <a:chOff x="6691520" y="2280215"/>
                <a:chExt cx="2735801" cy="3628021"/>
              </a:xfrm>
            </p:grpSpPr>
            <p:sp>
              <p:nvSpPr>
                <p:cNvPr id="76" name="Forma libre: forma 180">
                  <a:extLst>
                    <a:ext uri="{FF2B5EF4-FFF2-40B4-BE49-F238E27FC236}">
                      <a16:creationId xmlns:a16="http://schemas.microsoft.com/office/drawing/2014/main" id="{5352F89A-E89F-1895-9AE9-A1C5D4E99E27}"/>
                    </a:ext>
                  </a:extLst>
                </p:cNvPr>
                <p:cNvSpPr/>
                <p:nvPr/>
              </p:nvSpPr>
              <p:spPr>
                <a:xfrm>
                  <a:off x="8222504" y="3846395"/>
                  <a:ext cx="625792" cy="2061841"/>
                </a:xfrm>
                <a:custGeom>
                  <a:avLst/>
                  <a:gdLst>
                    <a:gd name="connsiteX0" fmla="*/ 83858 w 625792"/>
                    <a:gd name="connsiteY0" fmla="*/ 3352 h 2061841"/>
                    <a:gd name="connsiteX1" fmla="*/ 382308 w 625792"/>
                    <a:gd name="connsiteY1" fmla="*/ 149402 h 2061841"/>
                    <a:gd name="connsiteX2" fmla="*/ 490258 w 625792"/>
                    <a:gd name="connsiteY2" fmla="*/ 358952 h 2061841"/>
                    <a:gd name="connsiteX3" fmla="*/ 579158 w 625792"/>
                    <a:gd name="connsiteY3" fmla="*/ 720902 h 2061841"/>
                    <a:gd name="connsiteX4" fmla="*/ 572808 w 625792"/>
                    <a:gd name="connsiteY4" fmla="*/ 1209852 h 2061841"/>
                    <a:gd name="connsiteX5" fmla="*/ 623608 w 625792"/>
                    <a:gd name="connsiteY5" fmla="*/ 1800402 h 2061841"/>
                    <a:gd name="connsiteX6" fmla="*/ 598208 w 625792"/>
                    <a:gd name="connsiteY6" fmla="*/ 2029002 h 2061841"/>
                    <a:gd name="connsiteX7" fmla="*/ 439458 w 625792"/>
                    <a:gd name="connsiteY7" fmla="*/ 2041702 h 2061841"/>
                    <a:gd name="connsiteX8" fmla="*/ 433108 w 625792"/>
                    <a:gd name="connsiteY8" fmla="*/ 1851202 h 2061841"/>
                    <a:gd name="connsiteX9" fmla="*/ 433108 w 625792"/>
                    <a:gd name="connsiteY9" fmla="*/ 1292402 h 2061841"/>
                    <a:gd name="connsiteX10" fmla="*/ 401358 w 625792"/>
                    <a:gd name="connsiteY10" fmla="*/ 886002 h 2061841"/>
                    <a:gd name="connsiteX11" fmla="*/ 337858 w 625792"/>
                    <a:gd name="connsiteY11" fmla="*/ 651052 h 2061841"/>
                    <a:gd name="connsiteX12" fmla="*/ 160058 w 625792"/>
                    <a:gd name="connsiteY12" fmla="*/ 657402 h 2061841"/>
                    <a:gd name="connsiteX13" fmla="*/ 77508 w 625792"/>
                    <a:gd name="connsiteY13" fmla="*/ 714552 h 2061841"/>
                    <a:gd name="connsiteX14" fmla="*/ 39408 w 625792"/>
                    <a:gd name="connsiteY14" fmla="*/ 670102 h 2061841"/>
                    <a:gd name="connsiteX15" fmla="*/ 52108 w 625792"/>
                    <a:gd name="connsiteY15" fmla="*/ 498652 h 2061841"/>
                    <a:gd name="connsiteX16" fmla="*/ 52108 w 625792"/>
                    <a:gd name="connsiteY16" fmla="*/ 276402 h 2061841"/>
                    <a:gd name="connsiteX17" fmla="*/ 1308 w 625792"/>
                    <a:gd name="connsiteY17" fmla="*/ 149402 h 2061841"/>
                    <a:gd name="connsiteX18" fmla="*/ 20358 w 625792"/>
                    <a:gd name="connsiteY18" fmla="*/ 54152 h 2061841"/>
                    <a:gd name="connsiteX19" fmla="*/ 83858 w 625792"/>
                    <a:gd name="connsiteY19" fmla="*/ 3352 h 20618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625792" h="2061841">
                      <a:moveTo>
                        <a:pt x="83858" y="3352"/>
                      </a:moveTo>
                      <a:cubicBezTo>
                        <a:pt x="144183" y="19227"/>
                        <a:pt x="314575" y="90135"/>
                        <a:pt x="382308" y="149402"/>
                      </a:cubicBezTo>
                      <a:cubicBezTo>
                        <a:pt x="450041" y="208669"/>
                        <a:pt x="457450" y="263702"/>
                        <a:pt x="490258" y="358952"/>
                      </a:cubicBezTo>
                      <a:cubicBezTo>
                        <a:pt x="523066" y="454202"/>
                        <a:pt x="565400" y="579085"/>
                        <a:pt x="579158" y="720902"/>
                      </a:cubicBezTo>
                      <a:cubicBezTo>
                        <a:pt x="592916" y="862719"/>
                        <a:pt x="565400" y="1029935"/>
                        <a:pt x="572808" y="1209852"/>
                      </a:cubicBezTo>
                      <a:cubicBezTo>
                        <a:pt x="580216" y="1389769"/>
                        <a:pt x="619375" y="1663877"/>
                        <a:pt x="623608" y="1800402"/>
                      </a:cubicBezTo>
                      <a:cubicBezTo>
                        <a:pt x="627841" y="1936927"/>
                        <a:pt x="628900" y="1988785"/>
                        <a:pt x="598208" y="2029002"/>
                      </a:cubicBezTo>
                      <a:cubicBezTo>
                        <a:pt x="567516" y="2069219"/>
                        <a:pt x="466975" y="2071335"/>
                        <a:pt x="439458" y="2041702"/>
                      </a:cubicBezTo>
                      <a:cubicBezTo>
                        <a:pt x="411941" y="2012069"/>
                        <a:pt x="434166" y="1976085"/>
                        <a:pt x="433108" y="1851202"/>
                      </a:cubicBezTo>
                      <a:cubicBezTo>
                        <a:pt x="432050" y="1726319"/>
                        <a:pt x="438400" y="1453269"/>
                        <a:pt x="433108" y="1292402"/>
                      </a:cubicBezTo>
                      <a:cubicBezTo>
                        <a:pt x="427816" y="1131535"/>
                        <a:pt x="417233" y="992894"/>
                        <a:pt x="401358" y="886002"/>
                      </a:cubicBezTo>
                      <a:cubicBezTo>
                        <a:pt x="385483" y="779110"/>
                        <a:pt x="378075" y="689152"/>
                        <a:pt x="337858" y="651052"/>
                      </a:cubicBezTo>
                      <a:cubicBezTo>
                        <a:pt x="297641" y="612952"/>
                        <a:pt x="203450" y="646819"/>
                        <a:pt x="160058" y="657402"/>
                      </a:cubicBezTo>
                      <a:cubicBezTo>
                        <a:pt x="116666" y="667985"/>
                        <a:pt x="97616" y="712435"/>
                        <a:pt x="77508" y="714552"/>
                      </a:cubicBezTo>
                      <a:cubicBezTo>
                        <a:pt x="57400" y="716669"/>
                        <a:pt x="43641" y="706085"/>
                        <a:pt x="39408" y="670102"/>
                      </a:cubicBezTo>
                      <a:cubicBezTo>
                        <a:pt x="35175" y="634119"/>
                        <a:pt x="49991" y="564269"/>
                        <a:pt x="52108" y="498652"/>
                      </a:cubicBezTo>
                      <a:cubicBezTo>
                        <a:pt x="54225" y="433035"/>
                        <a:pt x="60575" y="334610"/>
                        <a:pt x="52108" y="276402"/>
                      </a:cubicBezTo>
                      <a:cubicBezTo>
                        <a:pt x="43641" y="218194"/>
                        <a:pt x="6600" y="186444"/>
                        <a:pt x="1308" y="149402"/>
                      </a:cubicBezTo>
                      <a:cubicBezTo>
                        <a:pt x="-3984" y="112360"/>
                        <a:pt x="7658" y="76377"/>
                        <a:pt x="20358" y="54152"/>
                      </a:cubicBezTo>
                      <a:cubicBezTo>
                        <a:pt x="33058" y="31927"/>
                        <a:pt x="23533" y="-12523"/>
                        <a:pt x="83858" y="3352"/>
                      </a:cubicBezTo>
                      <a:close/>
                    </a:path>
                  </a:pathLst>
                </a:custGeom>
                <a:solidFill>
                  <a:srgbClr val="FECC96"/>
                </a:solidFill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  <p:grpSp>
              <p:nvGrpSpPr>
                <p:cNvPr id="77" name="Grupo 181">
                  <a:extLst>
                    <a:ext uri="{FF2B5EF4-FFF2-40B4-BE49-F238E27FC236}">
                      <a16:creationId xmlns:a16="http://schemas.microsoft.com/office/drawing/2014/main" id="{FD4E71DB-0802-0D9D-9582-3EFCB4B3C30B}"/>
                    </a:ext>
                  </a:extLst>
                </p:cNvPr>
                <p:cNvGrpSpPr/>
                <p:nvPr/>
              </p:nvGrpSpPr>
              <p:grpSpPr>
                <a:xfrm>
                  <a:off x="6691520" y="2280215"/>
                  <a:ext cx="2735801" cy="3347037"/>
                  <a:chOff x="6691520" y="2280215"/>
                  <a:chExt cx="2735801" cy="3347037"/>
                </a:xfrm>
              </p:grpSpPr>
              <p:sp>
                <p:nvSpPr>
                  <p:cNvPr id="78" name="Forma libre: forma 182">
                    <a:extLst>
                      <a:ext uri="{FF2B5EF4-FFF2-40B4-BE49-F238E27FC236}">
                        <a16:creationId xmlns:a16="http://schemas.microsoft.com/office/drawing/2014/main" id="{22757A98-AB6F-9FAE-B81D-E0A89193862A}"/>
                      </a:ext>
                    </a:extLst>
                  </p:cNvPr>
                  <p:cNvSpPr/>
                  <p:nvPr/>
                </p:nvSpPr>
                <p:spPr>
                  <a:xfrm>
                    <a:off x="8100237" y="2950133"/>
                    <a:ext cx="1327084" cy="2494234"/>
                  </a:xfrm>
                  <a:custGeom>
                    <a:avLst/>
                    <a:gdLst>
                      <a:gd name="connsiteX0" fmla="*/ 937009 w 1327084"/>
                      <a:gd name="connsiteY0" fmla="*/ 1557 h 2494234"/>
                      <a:gd name="connsiteX1" fmla="*/ 1114809 w 1327084"/>
                      <a:gd name="connsiteY1" fmla="*/ 26957 h 2494234"/>
                      <a:gd name="connsiteX2" fmla="*/ 1324359 w 1327084"/>
                      <a:gd name="connsiteY2" fmla="*/ 33307 h 2494234"/>
                      <a:gd name="connsiteX3" fmla="*/ 1235459 w 1327084"/>
                      <a:gd name="connsiteY3" fmla="*/ 280957 h 2494234"/>
                      <a:gd name="connsiteX4" fmla="*/ 1254509 w 1327084"/>
                      <a:gd name="connsiteY4" fmla="*/ 693707 h 2494234"/>
                      <a:gd name="connsiteX5" fmla="*/ 1254509 w 1327084"/>
                      <a:gd name="connsiteY5" fmla="*/ 852457 h 2494234"/>
                      <a:gd name="connsiteX6" fmla="*/ 1254509 w 1327084"/>
                      <a:gd name="connsiteY6" fmla="*/ 2236757 h 2494234"/>
                      <a:gd name="connsiteX7" fmla="*/ 1292609 w 1327084"/>
                      <a:gd name="connsiteY7" fmla="*/ 2459007 h 2494234"/>
                      <a:gd name="connsiteX8" fmla="*/ 1051309 w 1327084"/>
                      <a:gd name="connsiteY8" fmla="*/ 2484407 h 2494234"/>
                      <a:gd name="connsiteX9" fmla="*/ 911609 w 1327084"/>
                      <a:gd name="connsiteY9" fmla="*/ 2363757 h 2494234"/>
                      <a:gd name="connsiteX10" fmla="*/ 917959 w 1327084"/>
                      <a:gd name="connsiteY10" fmla="*/ 1785907 h 2494234"/>
                      <a:gd name="connsiteX11" fmla="*/ 848109 w 1327084"/>
                      <a:gd name="connsiteY11" fmla="*/ 1182657 h 2494234"/>
                      <a:gd name="connsiteX12" fmla="*/ 721109 w 1327084"/>
                      <a:gd name="connsiteY12" fmla="*/ 1277907 h 2494234"/>
                      <a:gd name="connsiteX13" fmla="*/ 251209 w 1327084"/>
                      <a:gd name="connsiteY13" fmla="*/ 1487457 h 2494234"/>
                      <a:gd name="connsiteX14" fmla="*/ 124209 w 1327084"/>
                      <a:gd name="connsiteY14" fmla="*/ 1493807 h 2494234"/>
                      <a:gd name="connsiteX15" fmla="*/ 73409 w 1327084"/>
                      <a:gd name="connsiteY15" fmla="*/ 1398557 h 2494234"/>
                      <a:gd name="connsiteX16" fmla="*/ 321059 w 1327084"/>
                      <a:gd name="connsiteY16" fmla="*/ 1309657 h 2494234"/>
                      <a:gd name="connsiteX17" fmla="*/ 651259 w 1327084"/>
                      <a:gd name="connsiteY17" fmla="*/ 1087407 h 2494234"/>
                      <a:gd name="connsiteX18" fmla="*/ 587759 w 1327084"/>
                      <a:gd name="connsiteY18" fmla="*/ 985807 h 2494234"/>
                      <a:gd name="connsiteX19" fmla="*/ 422659 w 1327084"/>
                      <a:gd name="connsiteY19" fmla="*/ 1087407 h 2494234"/>
                      <a:gd name="connsiteX20" fmla="*/ 244859 w 1327084"/>
                      <a:gd name="connsiteY20" fmla="*/ 1163607 h 2494234"/>
                      <a:gd name="connsiteX21" fmla="*/ 48009 w 1327084"/>
                      <a:gd name="connsiteY21" fmla="*/ 1176307 h 2494234"/>
                      <a:gd name="connsiteX22" fmla="*/ 16259 w 1327084"/>
                      <a:gd name="connsiteY22" fmla="*/ 992157 h 2494234"/>
                      <a:gd name="connsiteX23" fmla="*/ 263909 w 1327084"/>
                      <a:gd name="connsiteY23" fmla="*/ 960407 h 2494234"/>
                      <a:gd name="connsiteX24" fmla="*/ 492509 w 1327084"/>
                      <a:gd name="connsiteY24" fmla="*/ 903257 h 2494234"/>
                      <a:gd name="connsiteX25" fmla="*/ 632209 w 1327084"/>
                      <a:gd name="connsiteY25" fmla="*/ 801657 h 2494234"/>
                      <a:gd name="connsiteX26" fmla="*/ 441709 w 1327084"/>
                      <a:gd name="connsiteY26" fmla="*/ 655607 h 2494234"/>
                      <a:gd name="connsiteX27" fmla="*/ 257559 w 1327084"/>
                      <a:gd name="connsiteY27" fmla="*/ 592107 h 2494234"/>
                      <a:gd name="connsiteX28" fmla="*/ 130559 w 1327084"/>
                      <a:gd name="connsiteY28" fmla="*/ 547657 h 2494234"/>
                      <a:gd name="connsiteX29" fmla="*/ 130559 w 1327084"/>
                      <a:gd name="connsiteY29" fmla="*/ 401607 h 2494234"/>
                      <a:gd name="connsiteX30" fmla="*/ 225809 w 1327084"/>
                      <a:gd name="connsiteY30" fmla="*/ 369857 h 2494234"/>
                      <a:gd name="connsiteX31" fmla="*/ 454409 w 1327084"/>
                      <a:gd name="connsiteY31" fmla="*/ 554007 h 2494234"/>
                      <a:gd name="connsiteX32" fmla="*/ 625859 w 1327084"/>
                      <a:gd name="connsiteY32" fmla="*/ 630207 h 2494234"/>
                      <a:gd name="connsiteX33" fmla="*/ 746509 w 1327084"/>
                      <a:gd name="connsiteY33" fmla="*/ 725457 h 2494234"/>
                      <a:gd name="connsiteX34" fmla="*/ 841759 w 1327084"/>
                      <a:gd name="connsiteY34" fmla="*/ 674657 h 2494234"/>
                      <a:gd name="connsiteX35" fmla="*/ 854459 w 1327084"/>
                      <a:gd name="connsiteY35" fmla="*/ 357157 h 2494234"/>
                      <a:gd name="connsiteX36" fmla="*/ 860809 w 1327084"/>
                      <a:gd name="connsiteY36" fmla="*/ 77757 h 2494234"/>
                      <a:gd name="connsiteX37" fmla="*/ 937009 w 1327084"/>
                      <a:gd name="connsiteY37" fmla="*/ 1557 h 249423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</a:cxnLst>
                    <a:rect l="l" t="t" r="r" b="b"/>
                    <a:pathLst>
                      <a:path w="1327084" h="2494234">
                        <a:moveTo>
                          <a:pt x="937009" y="1557"/>
                        </a:moveTo>
                        <a:cubicBezTo>
                          <a:pt x="979342" y="-6910"/>
                          <a:pt x="1050251" y="21665"/>
                          <a:pt x="1114809" y="26957"/>
                        </a:cubicBezTo>
                        <a:cubicBezTo>
                          <a:pt x="1179367" y="32249"/>
                          <a:pt x="1304251" y="-9026"/>
                          <a:pt x="1324359" y="33307"/>
                        </a:cubicBezTo>
                        <a:cubicBezTo>
                          <a:pt x="1344467" y="75640"/>
                          <a:pt x="1247101" y="170890"/>
                          <a:pt x="1235459" y="280957"/>
                        </a:cubicBezTo>
                        <a:cubicBezTo>
                          <a:pt x="1223817" y="391024"/>
                          <a:pt x="1251334" y="598457"/>
                          <a:pt x="1254509" y="693707"/>
                        </a:cubicBezTo>
                        <a:cubicBezTo>
                          <a:pt x="1257684" y="788957"/>
                          <a:pt x="1254509" y="852457"/>
                          <a:pt x="1254509" y="852457"/>
                        </a:cubicBezTo>
                        <a:cubicBezTo>
                          <a:pt x="1254509" y="1109632"/>
                          <a:pt x="1248159" y="1968999"/>
                          <a:pt x="1254509" y="2236757"/>
                        </a:cubicBezTo>
                        <a:cubicBezTo>
                          <a:pt x="1260859" y="2504515"/>
                          <a:pt x="1326476" y="2417732"/>
                          <a:pt x="1292609" y="2459007"/>
                        </a:cubicBezTo>
                        <a:cubicBezTo>
                          <a:pt x="1258742" y="2500282"/>
                          <a:pt x="1114809" y="2500282"/>
                          <a:pt x="1051309" y="2484407"/>
                        </a:cubicBezTo>
                        <a:cubicBezTo>
                          <a:pt x="987809" y="2468532"/>
                          <a:pt x="933834" y="2480174"/>
                          <a:pt x="911609" y="2363757"/>
                        </a:cubicBezTo>
                        <a:cubicBezTo>
                          <a:pt x="889384" y="2247340"/>
                          <a:pt x="928542" y="1982757"/>
                          <a:pt x="917959" y="1785907"/>
                        </a:cubicBezTo>
                        <a:cubicBezTo>
                          <a:pt x="907376" y="1589057"/>
                          <a:pt x="880917" y="1267324"/>
                          <a:pt x="848109" y="1182657"/>
                        </a:cubicBezTo>
                        <a:cubicBezTo>
                          <a:pt x="815301" y="1097990"/>
                          <a:pt x="820592" y="1227107"/>
                          <a:pt x="721109" y="1277907"/>
                        </a:cubicBezTo>
                        <a:cubicBezTo>
                          <a:pt x="621626" y="1328707"/>
                          <a:pt x="350692" y="1451474"/>
                          <a:pt x="251209" y="1487457"/>
                        </a:cubicBezTo>
                        <a:cubicBezTo>
                          <a:pt x="151726" y="1523440"/>
                          <a:pt x="153842" y="1508624"/>
                          <a:pt x="124209" y="1493807"/>
                        </a:cubicBezTo>
                        <a:cubicBezTo>
                          <a:pt x="94576" y="1478990"/>
                          <a:pt x="40601" y="1429249"/>
                          <a:pt x="73409" y="1398557"/>
                        </a:cubicBezTo>
                        <a:cubicBezTo>
                          <a:pt x="106217" y="1367865"/>
                          <a:pt x="224751" y="1361515"/>
                          <a:pt x="321059" y="1309657"/>
                        </a:cubicBezTo>
                        <a:cubicBezTo>
                          <a:pt x="417367" y="1257799"/>
                          <a:pt x="606809" y="1141382"/>
                          <a:pt x="651259" y="1087407"/>
                        </a:cubicBezTo>
                        <a:cubicBezTo>
                          <a:pt x="695709" y="1033432"/>
                          <a:pt x="625859" y="985807"/>
                          <a:pt x="587759" y="985807"/>
                        </a:cubicBezTo>
                        <a:cubicBezTo>
                          <a:pt x="549659" y="985807"/>
                          <a:pt x="479809" y="1057774"/>
                          <a:pt x="422659" y="1087407"/>
                        </a:cubicBezTo>
                        <a:cubicBezTo>
                          <a:pt x="365509" y="1117040"/>
                          <a:pt x="307301" y="1148790"/>
                          <a:pt x="244859" y="1163607"/>
                        </a:cubicBezTo>
                        <a:cubicBezTo>
                          <a:pt x="182417" y="1178424"/>
                          <a:pt x="86109" y="1204882"/>
                          <a:pt x="48009" y="1176307"/>
                        </a:cubicBezTo>
                        <a:cubicBezTo>
                          <a:pt x="9909" y="1147732"/>
                          <a:pt x="-19724" y="1028140"/>
                          <a:pt x="16259" y="992157"/>
                        </a:cubicBezTo>
                        <a:cubicBezTo>
                          <a:pt x="52242" y="956174"/>
                          <a:pt x="184534" y="975224"/>
                          <a:pt x="263909" y="960407"/>
                        </a:cubicBezTo>
                        <a:cubicBezTo>
                          <a:pt x="343284" y="945590"/>
                          <a:pt x="431126" y="929715"/>
                          <a:pt x="492509" y="903257"/>
                        </a:cubicBezTo>
                        <a:cubicBezTo>
                          <a:pt x="553892" y="876799"/>
                          <a:pt x="640676" y="842932"/>
                          <a:pt x="632209" y="801657"/>
                        </a:cubicBezTo>
                        <a:cubicBezTo>
                          <a:pt x="623742" y="760382"/>
                          <a:pt x="504151" y="690532"/>
                          <a:pt x="441709" y="655607"/>
                        </a:cubicBezTo>
                        <a:cubicBezTo>
                          <a:pt x="379267" y="620682"/>
                          <a:pt x="257559" y="592107"/>
                          <a:pt x="257559" y="592107"/>
                        </a:cubicBezTo>
                        <a:cubicBezTo>
                          <a:pt x="205701" y="574115"/>
                          <a:pt x="151726" y="579407"/>
                          <a:pt x="130559" y="547657"/>
                        </a:cubicBezTo>
                        <a:cubicBezTo>
                          <a:pt x="109392" y="515907"/>
                          <a:pt x="114684" y="431240"/>
                          <a:pt x="130559" y="401607"/>
                        </a:cubicBezTo>
                        <a:cubicBezTo>
                          <a:pt x="146434" y="371974"/>
                          <a:pt x="171834" y="344457"/>
                          <a:pt x="225809" y="369857"/>
                        </a:cubicBezTo>
                        <a:cubicBezTo>
                          <a:pt x="279784" y="395257"/>
                          <a:pt x="387734" y="510615"/>
                          <a:pt x="454409" y="554007"/>
                        </a:cubicBezTo>
                        <a:cubicBezTo>
                          <a:pt x="521084" y="597399"/>
                          <a:pt x="577176" y="601632"/>
                          <a:pt x="625859" y="630207"/>
                        </a:cubicBezTo>
                        <a:cubicBezTo>
                          <a:pt x="674542" y="658782"/>
                          <a:pt x="710526" y="718049"/>
                          <a:pt x="746509" y="725457"/>
                        </a:cubicBezTo>
                        <a:cubicBezTo>
                          <a:pt x="782492" y="732865"/>
                          <a:pt x="823767" y="736040"/>
                          <a:pt x="841759" y="674657"/>
                        </a:cubicBezTo>
                        <a:cubicBezTo>
                          <a:pt x="859751" y="613274"/>
                          <a:pt x="851284" y="456640"/>
                          <a:pt x="854459" y="357157"/>
                        </a:cubicBezTo>
                        <a:cubicBezTo>
                          <a:pt x="857634" y="257674"/>
                          <a:pt x="851284" y="138082"/>
                          <a:pt x="860809" y="77757"/>
                        </a:cubicBezTo>
                        <a:cubicBezTo>
                          <a:pt x="870334" y="17432"/>
                          <a:pt x="894676" y="10024"/>
                          <a:pt x="937009" y="1557"/>
                        </a:cubicBezTo>
                        <a:close/>
                      </a:path>
                    </a:pathLst>
                  </a:custGeom>
                  <a:solidFill>
                    <a:srgbClr val="F47258"/>
                  </a:solidFill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9" name="Forma libre: forma 183">
                    <a:extLst>
                      <a:ext uri="{FF2B5EF4-FFF2-40B4-BE49-F238E27FC236}">
                        <a16:creationId xmlns:a16="http://schemas.microsoft.com/office/drawing/2014/main" id="{099673F7-88BF-2910-9587-85AB10466479}"/>
                      </a:ext>
                    </a:extLst>
                  </p:cNvPr>
                  <p:cNvSpPr/>
                  <p:nvPr/>
                </p:nvSpPr>
                <p:spPr>
                  <a:xfrm>
                    <a:off x="8278492" y="2776780"/>
                    <a:ext cx="971841" cy="2790765"/>
                  </a:xfrm>
                  <a:custGeom>
                    <a:avLst/>
                    <a:gdLst>
                      <a:gd name="connsiteX0" fmla="*/ 95303 w 971841"/>
                      <a:gd name="connsiteY0" fmla="*/ 629864 h 2790765"/>
                      <a:gd name="connsiteX1" fmla="*/ 241353 w 971841"/>
                      <a:gd name="connsiteY1" fmla="*/ 826714 h 2790765"/>
                      <a:gd name="connsiteX2" fmla="*/ 387403 w 971841"/>
                      <a:gd name="connsiteY2" fmla="*/ 915614 h 2790765"/>
                      <a:gd name="connsiteX3" fmla="*/ 514403 w 971841"/>
                      <a:gd name="connsiteY3" fmla="*/ 934664 h 2790765"/>
                      <a:gd name="connsiteX4" fmla="*/ 622353 w 971841"/>
                      <a:gd name="connsiteY4" fmla="*/ 820364 h 2790765"/>
                      <a:gd name="connsiteX5" fmla="*/ 635053 w 971841"/>
                      <a:gd name="connsiteY5" fmla="*/ 445714 h 2790765"/>
                      <a:gd name="connsiteX6" fmla="*/ 609653 w 971841"/>
                      <a:gd name="connsiteY6" fmla="*/ 20264 h 2790765"/>
                      <a:gd name="connsiteX7" fmla="*/ 743003 w 971841"/>
                      <a:gd name="connsiteY7" fmla="*/ 64714 h 2790765"/>
                      <a:gd name="connsiteX8" fmla="*/ 876353 w 971841"/>
                      <a:gd name="connsiteY8" fmla="*/ 32964 h 2790765"/>
                      <a:gd name="connsiteX9" fmla="*/ 882703 w 971841"/>
                      <a:gd name="connsiteY9" fmla="*/ 83764 h 2790765"/>
                      <a:gd name="connsiteX10" fmla="*/ 863653 w 971841"/>
                      <a:gd name="connsiteY10" fmla="*/ 490164 h 2790765"/>
                      <a:gd name="connsiteX11" fmla="*/ 946203 w 971841"/>
                      <a:gd name="connsiteY11" fmla="*/ 2033214 h 2790765"/>
                      <a:gd name="connsiteX12" fmla="*/ 958903 w 971841"/>
                      <a:gd name="connsiteY12" fmla="*/ 2738064 h 2790765"/>
                      <a:gd name="connsiteX13" fmla="*/ 774753 w 971841"/>
                      <a:gd name="connsiteY13" fmla="*/ 2719014 h 2790765"/>
                      <a:gd name="connsiteX14" fmla="*/ 698553 w 971841"/>
                      <a:gd name="connsiteY14" fmla="*/ 2553914 h 2790765"/>
                      <a:gd name="connsiteX15" fmla="*/ 736653 w 971841"/>
                      <a:gd name="connsiteY15" fmla="*/ 2007814 h 2790765"/>
                      <a:gd name="connsiteX16" fmla="*/ 685853 w 971841"/>
                      <a:gd name="connsiteY16" fmla="*/ 1347414 h 2790765"/>
                      <a:gd name="connsiteX17" fmla="*/ 571553 w 971841"/>
                      <a:gd name="connsiteY17" fmla="*/ 1302964 h 2790765"/>
                      <a:gd name="connsiteX18" fmla="*/ 362003 w 971841"/>
                      <a:gd name="connsiteY18" fmla="*/ 1455364 h 2790765"/>
                      <a:gd name="connsiteX19" fmla="*/ 190553 w 971841"/>
                      <a:gd name="connsiteY19" fmla="*/ 1696664 h 2790765"/>
                      <a:gd name="connsiteX20" fmla="*/ 158803 w 971841"/>
                      <a:gd name="connsiteY20" fmla="*/ 1734764 h 2790765"/>
                      <a:gd name="connsiteX21" fmla="*/ 95303 w 971841"/>
                      <a:gd name="connsiteY21" fmla="*/ 1633164 h 2790765"/>
                      <a:gd name="connsiteX22" fmla="*/ 222303 w 971841"/>
                      <a:gd name="connsiteY22" fmla="*/ 1429964 h 2790765"/>
                      <a:gd name="connsiteX23" fmla="*/ 368353 w 971841"/>
                      <a:gd name="connsiteY23" fmla="*/ 1302964 h 2790765"/>
                      <a:gd name="connsiteX24" fmla="*/ 438203 w 971841"/>
                      <a:gd name="connsiteY24" fmla="*/ 1226764 h 2790765"/>
                      <a:gd name="connsiteX25" fmla="*/ 158803 w 971841"/>
                      <a:gd name="connsiteY25" fmla="*/ 1245814 h 2790765"/>
                      <a:gd name="connsiteX26" fmla="*/ 25453 w 971841"/>
                      <a:gd name="connsiteY26" fmla="*/ 1239464 h 2790765"/>
                      <a:gd name="connsiteX27" fmla="*/ 19103 w 971841"/>
                      <a:gd name="connsiteY27" fmla="*/ 1106114 h 2790765"/>
                      <a:gd name="connsiteX28" fmla="*/ 228653 w 971841"/>
                      <a:gd name="connsiteY28" fmla="*/ 1106114 h 2790765"/>
                      <a:gd name="connsiteX29" fmla="*/ 419153 w 971841"/>
                      <a:gd name="connsiteY29" fmla="*/ 1131514 h 2790765"/>
                      <a:gd name="connsiteX30" fmla="*/ 431853 w 971841"/>
                      <a:gd name="connsiteY30" fmla="*/ 1036264 h 2790765"/>
                      <a:gd name="connsiteX31" fmla="*/ 203253 w 971841"/>
                      <a:gd name="connsiteY31" fmla="*/ 928314 h 2790765"/>
                      <a:gd name="connsiteX32" fmla="*/ 6403 w 971841"/>
                      <a:gd name="connsiteY32" fmla="*/ 845764 h 2790765"/>
                      <a:gd name="connsiteX33" fmla="*/ 95303 w 971841"/>
                      <a:gd name="connsiteY33" fmla="*/ 629864 h 2790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</a:cxnLst>
                    <a:rect l="l" t="t" r="r" b="b"/>
                    <a:pathLst>
                      <a:path w="971841" h="2790765">
                        <a:moveTo>
                          <a:pt x="95303" y="629864"/>
                        </a:moveTo>
                        <a:cubicBezTo>
                          <a:pt x="134461" y="626689"/>
                          <a:pt x="192670" y="779089"/>
                          <a:pt x="241353" y="826714"/>
                        </a:cubicBezTo>
                        <a:cubicBezTo>
                          <a:pt x="290036" y="874339"/>
                          <a:pt x="341895" y="897622"/>
                          <a:pt x="387403" y="915614"/>
                        </a:cubicBezTo>
                        <a:cubicBezTo>
                          <a:pt x="432911" y="933606"/>
                          <a:pt x="475245" y="950539"/>
                          <a:pt x="514403" y="934664"/>
                        </a:cubicBezTo>
                        <a:cubicBezTo>
                          <a:pt x="553561" y="918789"/>
                          <a:pt x="602245" y="901856"/>
                          <a:pt x="622353" y="820364"/>
                        </a:cubicBezTo>
                        <a:cubicBezTo>
                          <a:pt x="642461" y="738872"/>
                          <a:pt x="637170" y="579064"/>
                          <a:pt x="635053" y="445714"/>
                        </a:cubicBezTo>
                        <a:cubicBezTo>
                          <a:pt x="632936" y="312364"/>
                          <a:pt x="591661" y="83764"/>
                          <a:pt x="609653" y="20264"/>
                        </a:cubicBezTo>
                        <a:cubicBezTo>
                          <a:pt x="627645" y="-43236"/>
                          <a:pt x="698553" y="62597"/>
                          <a:pt x="743003" y="64714"/>
                        </a:cubicBezTo>
                        <a:cubicBezTo>
                          <a:pt x="787453" y="66831"/>
                          <a:pt x="853070" y="29789"/>
                          <a:pt x="876353" y="32964"/>
                        </a:cubicBezTo>
                        <a:cubicBezTo>
                          <a:pt x="899636" y="36139"/>
                          <a:pt x="884820" y="7564"/>
                          <a:pt x="882703" y="83764"/>
                        </a:cubicBezTo>
                        <a:cubicBezTo>
                          <a:pt x="880586" y="159964"/>
                          <a:pt x="853070" y="165256"/>
                          <a:pt x="863653" y="490164"/>
                        </a:cubicBezTo>
                        <a:cubicBezTo>
                          <a:pt x="874236" y="815072"/>
                          <a:pt x="930328" y="1658564"/>
                          <a:pt x="946203" y="2033214"/>
                        </a:cubicBezTo>
                        <a:cubicBezTo>
                          <a:pt x="962078" y="2407864"/>
                          <a:pt x="987478" y="2623764"/>
                          <a:pt x="958903" y="2738064"/>
                        </a:cubicBezTo>
                        <a:cubicBezTo>
                          <a:pt x="930328" y="2852364"/>
                          <a:pt x="818145" y="2749706"/>
                          <a:pt x="774753" y="2719014"/>
                        </a:cubicBezTo>
                        <a:cubicBezTo>
                          <a:pt x="731361" y="2688322"/>
                          <a:pt x="704903" y="2672447"/>
                          <a:pt x="698553" y="2553914"/>
                        </a:cubicBezTo>
                        <a:cubicBezTo>
                          <a:pt x="692203" y="2435381"/>
                          <a:pt x="738770" y="2208897"/>
                          <a:pt x="736653" y="2007814"/>
                        </a:cubicBezTo>
                        <a:cubicBezTo>
                          <a:pt x="734536" y="1806731"/>
                          <a:pt x="713370" y="1464889"/>
                          <a:pt x="685853" y="1347414"/>
                        </a:cubicBezTo>
                        <a:cubicBezTo>
                          <a:pt x="658336" y="1229939"/>
                          <a:pt x="625528" y="1284972"/>
                          <a:pt x="571553" y="1302964"/>
                        </a:cubicBezTo>
                        <a:cubicBezTo>
                          <a:pt x="517578" y="1320956"/>
                          <a:pt x="425503" y="1389747"/>
                          <a:pt x="362003" y="1455364"/>
                        </a:cubicBezTo>
                        <a:cubicBezTo>
                          <a:pt x="298503" y="1520981"/>
                          <a:pt x="224420" y="1650098"/>
                          <a:pt x="190553" y="1696664"/>
                        </a:cubicBezTo>
                        <a:cubicBezTo>
                          <a:pt x="156686" y="1743230"/>
                          <a:pt x="174678" y="1745347"/>
                          <a:pt x="158803" y="1734764"/>
                        </a:cubicBezTo>
                        <a:cubicBezTo>
                          <a:pt x="142928" y="1724181"/>
                          <a:pt x="84720" y="1683964"/>
                          <a:pt x="95303" y="1633164"/>
                        </a:cubicBezTo>
                        <a:cubicBezTo>
                          <a:pt x="105886" y="1582364"/>
                          <a:pt x="176795" y="1484997"/>
                          <a:pt x="222303" y="1429964"/>
                        </a:cubicBezTo>
                        <a:cubicBezTo>
                          <a:pt x="267811" y="1374931"/>
                          <a:pt x="332370" y="1336831"/>
                          <a:pt x="368353" y="1302964"/>
                        </a:cubicBezTo>
                        <a:cubicBezTo>
                          <a:pt x="404336" y="1269097"/>
                          <a:pt x="473128" y="1236289"/>
                          <a:pt x="438203" y="1226764"/>
                        </a:cubicBezTo>
                        <a:cubicBezTo>
                          <a:pt x="403278" y="1217239"/>
                          <a:pt x="227595" y="1243697"/>
                          <a:pt x="158803" y="1245814"/>
                        </a:cubicBezTo>
                        <a:cubicBezTo>
                          <a:pt x="90011" y="1247931"/>
                          <a:pt x="48736" y="1262747"/>
                          <a:pt x="25453" y="1239464"/>
                        </a:cubicBezTo>
                        <a:cubicBezTo>
                          <a:pt x="2170" y="1216181"/>
                          <a:pt x="-14764" y="1128339"/>
                          <a:pt x="19103" y="1106114"/>
                        </a:cubicBezTo>
                        <a:cubicBezTo>
                          <a:pt x="52970" y="1083889"/>
                          <a:pt x="161978" y="1101881"/>
                          <a:pt x="228653" y="1106114"/>
                        </a:cubicBezTo>
                        <a:cubicBezTo>
                          <a:pt x="295328" y="1110347"/>
                          <a:pt x="385286" y="1143156"/>
                          <a:pt x="419153" y="1131514"/>
                        </a:cubicBezTo>
                        <a:cubicBezTo>
                          <a:pt x="453020" y="1119872"/>
                          <a:pt x="467836" y="1070131"/>
                          <a:pt x="431853" y="1036264"/>
                        </a:cubicBezTo>
                        <a:cubicBezTo>
                          <a:pt x="395870" y="1002397"/>
                          <a:pt x="274161" y="960064"/>
                          <a:pt x="203253" y="928314"/>
                        </a:cubicBezTo>
                        <a:cubicBezTo>
                          <a:pt x="132345" y="896564"/>
                          <a:pt x="25453" y="892331"/>
                          <a:pt x="6403" y="845764"/>
                        </a:cubicBezTo>
                        <a:cubicBezTo>
                          <a:pt x="-12647" y="799197"/>
                          <a:pt x="56145" y="633039"/>
                          <a:pt x="95303" y="629864"/>
                        </a:cubicBezTo>
                        <a:close/>
                      </a:path>
                    </a:pathLst>
                  </a:custGeom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80" name="Forma libre: forma 184">
                    <a:extLst>
                      <a:ext uri="{FF2B5EF4-FFF2-40B4-BE49-F238E27FC236}">
                        <a16:creationId xmlns:a16="http://schemas.microsoft.com/office/drawing/2014/main" id="{0B7F38BB-4C64-50CC-F77B-0AB09B5743A0}"/>
                      </a:ext>
                    </a:extLst>
                  </p:cNvPr>
                  <p:cNvSpPr/>
                  <p:nvPr/>
                </p:nvSpPr>
                <p:spPr>
                  <a:xfrm>
                    <a:off x="6691520" y="2280215"/>
                    <a:ext cx="1916526" cy="3347037"/>
                  </a:xfrm>
                  <a:custGeom>
                    <a:avLst/>
                    <a:gdLst>
                      <a:gd name="connsiteX0" fmla="*/ 914400 w 1916526"/>
                      <a:gd name="connsiteY0" fmla="*/ 0 h 3347037"/>
                      <a:gd name="connsiteX1" fmla="*/ 1828800 w 1916526"/>
                      <a:gd name="connsiteY1" fmla="*/ 864454 h 3347037"/>
                      <a:gd name="connsiteX2" fmla="*/ 1738631 w 1916526"/>
                      <a:gd name="connsiteY2" fmla="*/ 1239231 h 3347037"/>
                      <a:gd name="connsiteX3" fmla="*/ 1680293 w 1916526"/>
                      <a:gd name="connsiteY3" fmla="*/ 1335184 h 3347037"/>
                      <a:gd name="connsiteX4" fmla="*/ 1703909 w 1916526"/>
                      <a:gd name="connsiteY4" fmla="*/ 1394010 h 3347037"/>
                      <a:gd name="connsiteX5" fmla="*/ 1741074 w 1916526"/>
                      <a:gd name="connsiteY5" fmla="*/ 1618130 h 3347037"/>
                      <a:gd name="connsiteX6" fmla="*/ 1703909 w 1916526"/>
                      <a:gd name="connsiteY6" fmla="*/ 1842250 h 3347037"/>
                      <a:gd name="connsiteX7" fmla="*/ 1678522 w 1916526"/>
                      <a:gd name="connsiteY7" fmla="*/ 1905487 h 3347037"/>
                      <a:gd name="connsiteX8" fmla="*/ 1760361 w 1916526"/>
                      <a:gd name="connsiteY8" fmla="*/ 1999259 h 3347037"/>
                      <a:gd name="connsiteX9" fmla="*/ 1916526 w 1916526"/>
                      <a:gd name="connsiteY9" fmla="*/ 2482583 h 3347037"/>
                      <a:gd name="connsiteX10" fmla="*/ 1002126 w 1916526"/>
                      <a:gd name="connsiteY10" fmla="*/ 3347037 h 3347037"/>
                      <a:gd name="connsiteX11" fmla="*/ 87726 w 1916526"/>
                      <a:gd name="connsiteY11" fmla="*/ 2482583 h 3347037"/>
                      <a:gd name="connsiteX12" fmla="*/ 95073 w 1916526"/>
                      <a:gd name="connsiteY12" fmla="*/ 2372483 h 3347037"/>
                      <a:gd name="connsiteX13" fmla="*/ 104255 w 1916526"/>
                      <a:gd name="connsiteY13" fmla="*/ 2327114 h 3347037"/>
                      <a:gd name="connsiteX14" fmla="*/ 64964 w 1916526"/>
                      <a:gd name="connsiteY14" fmla="*/ 2261119 h 3347037"/>
                      <a:gd name="connsiteX15" fmla="*/ 0 w 1916526"/>
                      <a:gd name="connsiteY15" fmla="*/ 1967754 h 3347037"/>
                      <a:gd name="connsiteX16" fmla="*/ 16795 w 1916526"/>
                      <a:gd name="connsiteY16" fmla="*/ 1815862 h 3347037"/>
                      <a:gd name="connsiteX17" fmla="*/ 32842 w 1916526"/>
                      <a:gd name="connsiteY17" fmla="*/ 1758966 h 3347037"/>
                      <a:gd name="connsiteX18" fmla="*/ 10325 w 1916526"/>
                      <a:gd name="connsiteY18" fmla="*/ 1673548 h 3347037"/>
                      <a:gd name="connsiteX19" fmla="*/ 0 w 1916526"/>
                      <a:gd name="connsiteY19" fmla="*/ 1554097 h 3347037"/>
                      <a:gd name="connsiteX20" fmla="*/ 16795 w 1916526"/>
                      <a:gd name="connsiteY20" fmla="*/ 1402205 h 3347037"/>
                      <a:gd name="connsiteX21" fmla="*/ 32289 w 1916526"/>
                      <a:gd name="connsiteY21" fmla="*/ 1347269 h 3347037"/>
                      <a:gd name="connsiteX22" fmla="*/ 16795 w 1916526"/>
                      <a:gd name="connsiteY22" fmla="*/ 1292332 h 3347037"/>
                      <a:gd name="connsiteX23" fmla="*/ 0 w 1916526"/>
                      <a:gd name="connsiteY23" fmla="*/ 1140440 h 3347037"/>
                      <a:gd name="connsiteX24" fmla="*/ 4268 w 1916526"/>
                      <a:gd name="connsiteY24" fmla="*/ 1063381 h 3347037"/>
                      <a:gd name="connsiteX25" fmla="*/ 13583 w 1916526"/>
                      <a:gd name="connsiteY25" fmla="*/ 1007735 h 3347037"/>
                      <a:gd name="connsiteX26" fmla="*/ 4721 w 1916526"/>
                      <a:gd name="connsiteY26" fmla="*/ 952840 h 3347037"/>
                      <a:gd name="connsiteX27" fmla="*/ 0 w 1916526"/>
                      <a:gd name="connsiteY27" fmla="*/ 864454 h 3347037"/>
                      <a:gd name="connsiteX28" fmla="*/ 914400 w 1916526"/>
                      <a:gd name="connsiteY28" fmla="*/ 0 h 33470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</a:cxnLst>
                    <a:rect l="l" t="t" r="r" b="b"/>
                    <a:pathLst>
                      <a:path w="1916526" h="3347037">
                        <a:moveTo>
                          <a:pt x="914400" y="0"/>
                        </a:moveTo>
                        <a:cubicBezTo>
                          <a:pt x="1419409" y="0"/>
                          <a:pt x="1828800" y="387029"/>
                          <a:pt x="1828800" y="864454"/>
                        </a:cubicBezTo>
                        <a:cubicBezTo>
                          <a:pt x="1828800" y="998730"/>
                          <a:pt x="1796417" y="1125855"/>
                          <a:pt x="1738631" y="1239231"/>
                        </a:cubicBezTo>
                        <a:lnTo>
                          <a:pt x="1680293" y="1335184"/>
                        </a:lnTo>
                        <a:lnTo>
                          <a:pt x="1703909" y="1394010"/>
                        </a:lnTo>
                        <a:cubicBezTo>
                          <a:pt x="1728062" y="1464809"/>
                          <a:pt x="1741074" y="1540084"/>
                          <a:pt x="1741074" y="1618130"/>
                        </a:cubicBezTo>
                        <a:cubicBezTo>
                          <a:pt x="1741074" y="1696176"/>
                          <a:pt x="1728062" y="1771451"/>
                          <a:pt x="1703909" y="1842250"/>
                        </a:cubicBezTo>
                        <a:lnTo>
                          <a:pt x="1678522" y="1905487"/>
                        </a:lnTo>
                        <a:lnTo>
                          <a:pt x="1760361" y="1999259"/>
                        </a:lnTo>
                        <a:cubicBezTo>
                          <a:pt x="1858956" y="2137226"/>
                          <a:pt x="1916526" y="2303549"/>
                          <a:pt x="1916526" y="2482583"/>
                        </a:cubicBezTo>
                        <a:cubicBezTo>
                          <a:pt x="1916526" y="2960008"/>
                          <a:pt x="1507135" y="3347037"/>
                          <a:pt x="1002126" y="3347037"/>
                        </a:cubicBezTo>
                        <a:cubicBezTo>
                          <a:pt x="497117" y="3347037"/>
                          <a:pt x="87726" y="2960008"/>
                          <a:pt x="87726" y="2482583"/>
                        </a:cubicBezTo>
                        <a:cubicBezTo>
                          <a:pt x="87726" y="2445284"/>
                          <a:pt x="90225" y="2408537"/>
                          <a:pt x="95073" y="2372483"/>
                        </a:cubicBezTo>
                        <a:lnTo>
                          <a:pt x="104255" y="2327114"/>
                        </a:lnTo>
                        <a:lnTo>
                          <a:pt x="64964" y="2261119"/>
                        </a:lnTo>
                        <a:cubicBezTo>
                          <a:pt x="23132" y="2170950"/>
                          <a:pt x="0" y="2071815"/>
                          <a:pt x="0" y="1967754"/>
                        </a:cubicBezTo>
                        <a:cubicBezTo>
                          <a:pt x="0" y="1915724"/>
                          <a:pt x="5783" y="1864925"/>
                          <a:pt x="16795" y="1815862"/>
                        </a:cubicBezTo>
                        <a:lnTo>
                          <a:pt x="32842" y="1758966"/>
                        </a:lnTo>
                        <a:lnTo>
                          <a:pt x="10325" y="1673548"/>
                        </a:lnTo>
                        <a:cubicBezTo>
                          <a:pt x="3530" y="1634643"/>
                          <a:pt x="0" y="1594746"/>
                          <a:pt x="0" y="1554097"/>
                        </a:cubicBezTo>
                        <a:cubicBezTo>
                          <a:pt x="0" y="1502067"/>
                          <a:pt x="5783" y="1451268"/>
                          <a:pt x="16795" y="1402205"/>
                        </a:cubicBezTo>
                        <a:lnTo>
                          <a:pt x="32289" y="1347269"/>
                        </a:lnTo>
                        <a:lnTo>
                          <a:pt x="16795" y="1292332"/>
                        </a:lnTo>
                        <a:cubicBezTo>
                          <a:pt x="5783" y="1243270"/>
                          <a:pt x="0" y="1192471"/>
                          <a:pt x="0" y="1140440"/>
                        </a:cubicBezTo>
                        <a:cubicBezTo>
                          <a:pt x="0" y="1114425"/>
                          <a:pt x="1446" y="1088717"/>
                          <a:pt x="4268" y="1063381"/>
                        </a:cubicBezTo>
                        <a:lnTo>
                          <a:pt x="13583" y="1007735"/>
                        </a:lnTo>
                        <a:lnTo>
                          <a:pt x="4721" y="952840"/>
                        </a:lnTo>
                        <a:cubicBezTo>
                          <a:pt x="1599" y="923779"/>
                          <a:pt x="0" y="894293"/>
                          <a:pt x="0" y="864454"/>
                        </a:cubicBezTo>
                        <a:cubicBezTo>
                          <a:pt x="0" y="387029"/>
                          <a:pt x="409391" y="0"/>
                          <a:pt x="914400" y="0"/>
                        </a:cubicBezTo>
                        <a:close/>
                      </a:path>
                    </a:pathLst>
                  </a:custGeom>
                  <a:solidFill>
                    <a:srgbClr val="D04E46"/>
                  </a:solidFill>
                  <a:ln w="349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wrap="square" rtlCol="0" anchor="ctr">
                    <a:no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73" name="Forma libre: forma 177">
                <a:extLst>
                  <a:ext uri="{FF2B5EF4-FFF2-40B4-BE49-F238E27FC236}">
                    <a16:creationId xmlns:a16="http://schemas.microsoft.com/office/drawing/2014/main" id="{1A00C49A-FA2B-C926-620B-A5FE9298C32F}"/>
                  </a:ext>
                </a:extLst>
              </p:cNvPr>
              <p:cNvSpPr/>
              <p:nvPr/>
            </p:nvSpPr>
            <p:spPr>
              <a:xfrm>
                <a:off x="6782373" y="3124615"/>
                <a:ext cx="1056954" cy="842918"/>
              </a:xfrm>
              <a:custGeom>
                <a:avLst/>
                <a:gdLst>
                  <a:gd name="connsiteX0" fmla="*/ 59048 w 1056954"/>
                  <a:gd name="connsiteY0" fmla="*/ 59984 h 842918"/>
                  <a:gd name="connsiteX1" fmla="*/ 8248 w 1056954"/>
                  <a:gd name="connsiteY1" fmla="*/ 193334 h 842918"/>
                  <a:gd name="connsiteX2" fmla="*/ 1898 w 1056954"/>
                  <a:gd name="connsiteY2" fmla="*/ 390184 h 842918"/>
                  <a:gd name="connsiteX3" fmla="*/ 27298 w 1056954"/>
                  <a:gd name="connsiteY3" fmla="*/ 631484 h 842918"/>
                  <a:gd name="connsiteX4" fmla="*/ 78098 w 1056954"/>
                  <a:gd name="connsiteY4" fmla="*/ 828334 h 842918"/>
                  <a:gd name="connsiteX5" fmla="*/ 363848 w 1056954"/>
                  <a:gd name="connsiteY5" fmla="*/ 821984 h 842918"/>
                  <a:gd name="connsiteX6" fmla="*/ 713098 w 1056954"/>
                  <a:gd name="connsiteY6" fmla="*/ 771184 h 842918"/>
                  <a:gd name="connsiteX7" fmla="*/ 941698 w 1056954"/>
                  <a:gd name="connsiteY7" fmla="*/ 631484 h 842918"/>
                  <a:gd name="connsiteX8" fmla="*/ 1049648 w 1056954"/>
                  <a:gd name="connsiteY8" fmla="*/ 453684 h 842918"/>
                  <a:gd name="connsiteX9" fmla="*/ 1017898 w 1056954"/>
                  <a:gd name="connsiteY9" fmla="*/ 206034 h 842918"/>
                  <a:gd name="connsiteX10" fmla="*/ 782948 w 1056954"/>
                  <a:gd name="connsiteY10" fmla="*/ 40934 h 842918"/>
                  <a:gd name="connsiteX11" fmla="*/ 528948 w 1056954"/>
                  <a:gd name="connsiteY11" fmla="*/ 2834 h 842918"/>
                  <a:gd name="connsiteX12" fmla="*/ 141598 w 1056954"/>
                  <a:gd name="connsiteY12" fmla="*/ 9184 h 842918"/>
                  <a:gd name="connsiteX13" fmla="*/ 59048 w 1056954"/>
                  <a:gd name="connsiteY13" fmla="*/ 59984 h 8429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56954" h="842918">
                    <a:moveTo>
                      <a:pt x="59048" y="59984"/>
                    </a:moveTo>
                    <a:cubicBezTo>
                      <a:pt x="36823" y="90676"/>
                      <a:pt x="17773" y="138301"/>
                      <a:pt x="8248" y="193334"/>
                    </a:cubicBezTo>
                    <a:cubicBezTo>
                      <a:pt x="-1277" y="248367"/>
                      <a:pt x="-1277" y="317159"/>
                      <a:pt x="1898" y="390184"/>
                    </a:cubicBezTo>
                    <a:cubicBezTo>
                      <a:pt x="5073" y="463209"/>
                      <a:pt x="14598" y="558459"/>
                      <a:pt x="27298" y="631484"/>
                    </a:cubicBezTo>
                    <a:cubicBezTo>
                      <a:pt x="39998" y="704509"/>
                      <a:pt x="22006" y="796584"/>
                      <a:pt x="78098" y="828334"/>
                    </a:cubicBezTo>
                    <a:cubicBezTo>
                      <a:pt x="134190" y="860084"/>
                      <a:pt x="258015" y="831509"/>
                      <a:pt x="363848" y="821984"/>
                    </a:cubicBezTo>
                    <a:cubicBezTo>
                      <a:pt x="469681" y="812459"/>
                      <a:pt x="616790" y="802934"/>
                      <a:pt x="713098" y="771184"/>
                    </a:cubicBezTo>
                    <a:cubicBezTo>
                      <a:pt x="809406" y="739434"/>
                      <a:pt x="885606" y="684401"/>
                      <a:pt x="941698" y="631484"/>
                    </a:cubicBezTo>
                    <a:cubicBezTo>
                      <a:pt x="997790" y="578567"/>
                      <a:pt x="1036948" y="524592"/>
                      <a:pt x="1049648" y="453684"/>
                    </a:cubicBezTo>
                    <a:cubicBezTo>
                      <a:pt x="1062348" y="382776"/>
                      <a:pt x="1062348" y="274826"/>
                      <a:pt x="1017898" y="206034"/>
                    </a:cubicBezTo>
                    <a:cubicBezTo>
                      <a:pt x="973448" y="137242"/>
                      <a:pt x="864440" y="74801"/>
                      <a:pt x="782948" y="40934"/>
                    </a:cubicBezTo>
                    <a:cubicBezTo>
                      <a:pt x="701456" y="7067"/>
                      <a:pt x="635840" y="8126"/>
                      <a:pt x="528948" y="2834"/>
                    </a:cubicBezTo>
                    <a:cubicBezTo>
                      <a:pt x="422056" y="-2458"/>
                      <a:pt x="220973" y="-341"/>
                      <a:pt x="141598" y="9184"/>
                    </a:cubicBezTo>
                    <a:cubicBezTo>
                      <a:pt x="62223" y="18709"/>
                      <a:pt x="81273" y="29292"/>
                      <a:pt x="59048" y="599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74" name="Forma libre: forma 178">
                <a:extLst>
                  <a:ext uri="{FF2B5EF4-FFF2-40B4-BE49-F238E27FC236}">
                    <a16:creationId xmlns:a16="http://schemas.microsoft.com/office/drawing/2014/main" id="{B9D4C455-A9B2-9459-FE92-E84DEBE3DCCE}"/>
                  </a:ext>
                </a:extLst>
              </p:cNvPr>
              <p:cNvSpPr/>
              <p:nvPr/>
            </p:nvSpPr>
            <p:spPr>
              <a:xfrm>
                <a:off x="6863245" y="3893615"/>
                <a:ext cx="1131010" cy="793354"/>
              </a:xfrm>
              <a:custGeom>
                <a:avLst/>
                <a:gdLst>
                  <a:gd name="connsiteX0" fmla="*/ 9926 w 1131010"/>
                  <a:gd name="connsiteY0" fmla="*/ 256184 h 793354"/>
                  <a:gd name="connsiteX1" fmla="*/ 35326 w 1131010"/>
                  <a:gd name="connsiteY1" fmla="*/ 459384 h 793354"/>
                  <a:gd name="connsiteX2" fmla="*/ 187726 w 1131010"/>
                  <a:gd name="connsiteY2" fmla="*/ 630834 h 793354"/>
                  <a:gd name="connsiteX3" fmla="*/ 384576 w 1131010"/>
                  <a:gd name="connsiteY3" fmla="*/ 770534 h 793354"/>
                  <a:gd name="connsiteX4" fmla="*/ 625876 w 1131010"/>
                  <a:gd name="connsiteY4" fmla="*/ 789584 h 793354"/>
                  <a:gd name="connsiteX5" fmla="*/ 835426 w 1131010"/>
                  <a:gd name="connsiteY5" fmla="*/ 732434 h 793354"/>
                  <a:gd name="connsiteX6" fmla="*/ 1025926 w 1131010"/>
                  <a:gd name="connsiteY6" fmla="*/ 573684 h 793354"/>
                  <a:gd name="connsiteX7" fmla="*/ 1127526 w 1131010"/>
                  <a:gd name="connsiteY7" fmla="*/ 332384 h 793354"/>
                  <a:gd name="connsiteX8" fmla="*/ 1089426 w 1131010"/>
                  <a:gd name="connsiteY8" fmla="*/ 65684 h 793354"/>
                  <a:gd name="connsiteX9" fmla="*/ 917976 w 1131010"/>
                  <a:gd name="connsiteY9" fmla="*/ 2184 h 793354"/>
                  <a:gd name="connsiteX10" fmla="*/ 727476 w 1131010"/>
                  <a:gd name="connsiteY10" fmla="*/ 21234 h 793354"/>
                  <a:gd name="connsiteX11" fmla="*/ 511576 w 1131010"/>
                  <a:gd name="connsiteY11" fmla="*/ 84734 h 793354"/>
                  <a:gd name="connsiteX12" fmla="*/ 327426 w 1131010"/>
                  <a:gd name="connsiteY12" fmla="*/ 116484 h 793354"/>
                  <a:gd name="connsiteX13" fmla="*/ 168676 w 1131010"/>
                  <a:gd name="connsiteY13" fmla="*/ 122834 h 793354"/>
                  <a:gd name="connsiteX14" fmla="*/ 9926 w 1131010"/>
                  <a:gd name="connsiteY14" fmla="*/ 256184 h 793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1131010" h="793354">
                    <a:moveTo>
                      <a:pt x="9926" y="256184"/>
                    </a:moveTo>
                    <a:cubicBezTo>
                      <a:pt x="-12299" y="312276"/>
                      <a:pt x="5693" y="396942"/>
                      <a:pt x="35326" y="459384"/>
                    </a:cubicBezTo>
                    <a:cubicBezTo>
                      <a:pt x="64959" y="521826"/>
                      <a:pt x="129518" y="578976"/>
                      <a:pt x="187726" y="630834"/>
                    </a:cubicBezTo>
                    <a:cubicBezTo>
                      <a:pt x="245934" y="682692"/>
                      <a:pt x="311551" y="744076"/>
                      <a:pt x="384576" y="770534"/>
                    </a:cubicBezTo>
                    <a:cubicBezTo>
                      <a:pt x="457601" y="796992"/>
                      <a:pt x="550734" y="795934"/>
                      <a:pt x="625876" y="789584"/>
                    </a:cubicBezTo>
                    <a:cubicBezTo>
                      <a:pt x="701018" y="783234"/>
                      <a:pt x="768751" y="768417"/>
                      <a:pt x="835426" y="732434"/>
                    </a:cubicBezTo>
                    <a:cubicBezTo>
                      <a:pt x="902101" y="696451"/>
                      <a:pt x="977243" y="640359"/>
                      <a:pt x="1025926" y="573684"/>
                    </a:cubicBezTo>
                    <a:cubicBezTo>
                      <a:pt x="1074609" y="507009"/>
                      <a:pt x="1116943" y="417051"/>
                      <a:pt x="1127526" y="332384"/>
                    </a:cubicBezTo>
                    <a:cubicBezTo>
                      <a:pt x="1138109" y="247717"/>
                      <a:pt x="1124351" y="120717"/>
                      <a:pt x="1089426" y="65684"/>
                    </a:cubicBezTo>
                    <a:cubicBezTo>
                      <a:pt x="1054501" y="10651"/>
                      <a:pt x="978301" y="9592"/>
                      <a:pt x="917976" y="2184"/>
                    </a:cubicBezTo>
                    <a:cubicBezTo>
                      <a:pt x="857651" y="-5224"/>
                      <a:pt x="795209" y="7476"/>
                      <a:pt x="727476" y="21234"/>
                    </a:cubicBezTo>
                    <a:cubicBezTo>
                      <a:pt x="659743" y="34992"/>
                      <a:pt x="578251" y="68859"/>
                      <a:pt x="511576" y="84734"/>
                    </a:cubicBezTo>
                    <a:cubicBezTo>
                      <a:pt x="444901" y="100609"/>
                      <a:pt x="384576" y="110134"/>
                      <a:pt x="327426" y="116484"/>
                    </a:cubicBezTo>
                    <a:cubicBezTo>
                      <a:pt x="270276" y="122834"/>
                      <a:pt x="222651" y="104842"/>
                      <a:pt x="168676" y="122834"/>
                    </a:cubicBezTo>
                    <a:cubicBezTo>
                      <a:pt x="114701" y="140826"/>
                      <a:pt x="32151" y="200092"/>
                      <a:pt x="9926" y="2561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75" name="Forma libre: forma 179">
                <a:extLst>
                  <a:ext uri="{FF2B5EF4-FFF2-40B4-BE49-F238E27FC236}">
                    <a16:creationId xmlns:a16="http://schemas.microsoft.com/office/drawing/2014/main" id="{F9577EF5-8135-5D33-7974-916842678D3A}"/>
                  </a:ext>
                </a:extLst>
              </p:cNvPr>
              <p:cNvSpPr/>
              <p:nvPr/>
            </p:nvSpPr>
            <p:spPr>
              <a:xfrm>
                <a:off x="6790600" y="2383324"/>
                <a:ext cx="1098835" cy="717462"/>
              </a:xfrm>
              <a:custGeom>
                <a:avLst/>
                <a:gdLst>
                  <a:gd name="connsiteX0" fmla="*/ 69871 w 1098835"/>
                  <a:gd name="connsiteY0" fmla="*/ 229775 h 717462"/>
                  <a:gd name="connsiteX1" fmla="*/ 21 w 1098835"/>
                  <a:gd name="connsiteY1" fmla="*/ 394875 h 717462"/>
                  <a:gd name="connsiteX2" fmla="*/ 76221 w 1098835"/>
                  <a:gd name="connsiteY2" fmla="*/ 579025 h 717462"/>
                  <a:gd name="connsiteX3" fmla="*/ 215921 w 1098835"/>
                  <a:gd name="connsiteY3" fmla="*/ 661575 h 717462"/>
                  <a:gd name="connsiteX4" fmla="*/ 533421 w 1098835"/>
                  <a:gd name="connsiteY4" fmla="*/ 648875 h 717462"/>
                  <a:gd name="connsiteX5" fmla="*/ 857271 w 1098835"/>
                  <a:gd name="connsiteY5" fmla="*/ 712375 h 717462"/>
                  <a:gd name="connsiteX6" fmla="*/ 1003321 w 1098835"/>
                  <a:gd name="connsiteY6" fmla="*/ 686975 h 717462"/>
                  <a:gd name="connsiteX7" fmla="*/ 1098571 w 1098835"/>
                  <a:gd name="connsiteY7" fmla="*/ 477425 h 717462"/>
                  <a:gd name="connsiteX8" fmla="*/ 1022371 w 1098835"/>
                  <a:gd name="connsiteY8" fmla="*/ 153575 h 717462"/>
                  <a:gd name="connsiteX9" fmla="*/ 774721 w 1098835"/>
                  <a:gd name="connsiteY9" fmla="*/ 20225 h 717462"/>
                  <a:gd name="connsiteX10" fmla="*/ 571521 w 1098835"/>
                  <a:gd name="connsiteY10" fmla="*/ 1175 h 717462"/>
                  <a:gd name="connsiteX11" fmla="*/ 368321 w 1098835"/>
                  <a:gd name="connsiteY11" fmla="*/ 26575 h 717462"/>
                  <a:gd name="connsiteX12" fmla="*/ 196871 w 1098835"/>
                  <a:gd name="connsiteY12" fmla="*/ 115475 h 717462"/>
                  <a:gd name="connsiteX13" fmla="*/ 69871 w 1098835"/>
                  <a:gd name="connsiteY13" fmla="*/ 229775 h 7174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98835" h="717462">
                    <a:moveTo>
                      <a:pt x="69871" y="229775"/>
                    </a:moveTo>
                    <a:cubicBezTo>
                      <a:pt x="37063" y="276342"/>
                      <a:pt x="-1037" y="336667"/>
                      <a:pt x="21" y="394875"/>
                    </a:cubicBezTo>
                    <a:cubicBezTo>
                      <a:pt x="1079" y="453083"/>
                      <a:pt x="40238" y="534575"/>
                      <a:pt x="76221" y="579025"/>
                    </a:cubicBezTo>
                    <a:cubicBezTo>
                      <a:pt x="112204" y="623475"/>
                      <a:pt x="139721" y="649933"/>
                      <a:pt x="215921" y="661575"/>
                    </a:cubicBezTo>
                    <a:cubicBezTo>
                      <a:pt x="292121" y="673217"/>
                      <a:pt x="426529" y="640408"/>
                      <a:pt x="533421" y="648875"/>
                    </a:cubicBezTo>
                    <a:cubicBezTo>
                      <a:pt x="640313" y="657342"/>
                      <a:pt x="778954" y="706025"/>
                      <a:pt x="857271" y="712375"/>
                    </a:cubicBezTo>
                    <a:cubicBezTo>
                      <a:pt x="935588" y="718725"/>
                      <a:pt x="963104" y="726133"/>
                      <a:pt x="1003321" y="686975"/>
                    </a:cubicBezTo>
                    <a:cubicBezTo>
                      <a:pt x="1043538" y="647817"/>
                      <a:pt x="1095396" y="566325"/>
                      <a:pt x="1098571" y="477425"/>
                    </a:cubicBezTo>
                    <a:cubicBezTo>
                      <a:pt x="1101746" y="388525"/>
                      <a:pt x="1076346" y="229775"/>
                      <a:pt x="1022371" y="153575"/>
                    </a:cubicBezTo>
                    <a:cubicBezTo>
                      <a:pt x="968396" y="77375"/>
                      <a:pt x="849863" y="45625"/>
                      <a:pt x="774721" y="20225"/>
                    </a:cubicBezTo>
                    <a:cubicBezTo>
                      <a:pt x="699579" y="-5175"/>
                      <a:pt x="639254" y="117"/>
                      <a:pt x="571521" y="1175"/>
                    </a:cubicBezTo>
                    <a:cubicBezTo>
                      <a:pt x="503788" y="2233"/>
                      <a:pt x="430763" y="7525"/>
                      <a:pt x="368321" y="26575"/>
                    </a:cubicBezTo>
                    <a:cubicBezTo>
                      <a:pt x="305879" y="45625"/>
                      <a:pt x="243438" y="87958"/>
                      <a:pt x="196871" y="115475"/>
                    </a:cubicBezTo>
                    <a:cubicBezTo>
                      <a:pt x="150304" y="142992"/>
                      <a:pt x="102679" y="183208"/>
                      <a:pt x="69871" y="229775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  <p:grpSp>
          <p:nvGrpSpPr>
            <p:cNvPr id="46" name="Grupo 35">
              <a:extLst>
                <a:ext uri="{FF2B5EF4-FFF2-40B4-BE49-F238E27FC236}">
                  <a16:creationId xmlns:a16="http://schemas.microsoft.com/office/drawing/2014/main" id="{B14F96AF-16C3-7431-214F-AE4B1CA4419B}"/>
                </a:ext>
              </a:extLst>
            </p:cNvPr>
            <p:cNvGrpSpPr/>
            <p:nvPr/>
          </p:nvGrpSpPr>
          <p:grpSpPr>
            <a:xfrm>
              <a:off x="6201146" y="3994927"/>
              <a:ext cx="1634014" cy="1634014"/>
              <a:chOff x="6201146" y="3994927"/>
              <a:chExt cx="1634014" cy="1634014"/>
            </a:xfrm>
          </p:grpSpPr>
          <p:sp>
            <p:nvSpPr>
              <p:cNvPr id="47" name="Elipse 107">
                <a:extLst>
                  <a:ext uri="{FF2B5EF4-FFF2-40B4-BE49-F238E27FC236}">
                    <a16:creationId xmlns:a16="http://schemas.microsoft.com/office/drawing/2014/main" id="{FC3B50A2-7D67-0FF3-5B13-E7A719E245C5}"/>
                  </a:ext>
                </a:extLst>
              </p:cNvPr>
              <p:cNvSpPr/>
              <p:nvPr/>
            </p:nvSpPr>
            <p:spPr>
              <a:xfrm>
                <a:off x="6201146" y="3994927"/>
                <a:ext cx="1634014" cy="1634014"/>
              </a:xfrm>
              <a:prstGeom prst="ellipse">
                <a:avLst/>
              </a:prstGeom>
              <a:solidFill>
                <a:schemeClr val="accent4">
                  <a:lumMod val="50000"/>
                </a:schemeClr>
              </a:solidFill>
              <a:ln w="349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48" name="Elipse 108">
                <a:extLst>
                  <a:ext uri="{FF2B5EF4-FFF2-40B4-BE49-F238E27FC236}">
                    <a16:creationId xmlns:a16="http://schemas.microsoft.com/office/drawing/2014/main" id="{63E53B4E-2641-981D-A267-FBE58959AD4D}"/>
                  </a:ext>
                </a:extLst>
              </p:cNvPr>
              <p:cNvSpPr/>
              <p:nvPr/>
            </p:nvSpPr>
            <p:spPr>
              <a:xfrm>
                <a:off x="7267634" y="4218978"/>
                <a:ext cx="75892" cy="71623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49" name="Elipse 109">
                <a:extLst>
                  <a:ext uri="{FF2B5EF4-FFF2-40B4-BE49-F238E27FC236}">
                    <a16:creationId xmlns:a16="http://schemas.microsoft.com/office/drawing/2014/main" id="{2C178C22-CAD1-2783-19EE-5C140A32AB9C}"/>
                  </a:ext>
                </a:extLst>
              </p:cNvPr>
              <p:cNvSpPr/>
              <p:nvPr/>
            </p:nvSpPr>
            <p:spPr>
              <a:xfrm>
                <a:off x="6784767" y="4429329"/>
                <a:ext cx="73769" cy="696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0" name="Elipse 110">
                <a:extLst>
                  <a:ext uri="{FF2B5EF4-FFF2-40B4-BE49-F238E27FC236}">
                    <a16:creationId xmlns:a16="http://schemas.microsoft.com/office/drawing/2014/main" id="{617EF777-A781-BD5A-21FD-8B6B50D8B6DB}"/>
                  </a:ext>
                </a:extLst>
              </p:cNvPr>
              <p:cNvSpPr/>
              <p:nvPr/>
            </p:nvSpPr>
            <p:spPr>
              <a:xfrm>
                <a:off x="7227723" y="4859808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1" name="Elipse 111">
                <a:extLst>
                  <a:ext uri="{FF2B5EF4-FFF2-40B4-BE49-F238E27FC236}">
                    <a16:creationId xmlns:a16="http://schemas.microsoft.com/office/drawing/2014/main" id="{128B7AC4-619A-A4D5-4614-AD1D97100508}"/>
                  </a:ext>
                </a:extLst>
              </p:cNvPr>
              <p:cNvSpPr/>
              <p:nvPr/>
            </p:nvSpPr>
            <p:spPr>
              <a:xfrm>
                <a:off x="6771980" y="4829898"/>
                <a:ext cx="93125" cy="8024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2" name="Elipse 112">
                <a:extLst>
                  <a:ext uri="{FF2B5EF4-FFF2-40B4-BE49-F238E27FC236}">
                    <a16:creationId xmlns:a16="http://schemas.microsoft.com/office/drawing/2014/main" id="{CD6BBB2E-00FF-F6C8-33A4-FD59F602C03B}"/>
                  </a:ext>
                </a:extLst>
              </p:cNvPr>
              <p:cNvSpPr/>
              <p:nvPr/>
            </p:nvSpPr>
            <p:spPr>
              <a:xfrm>
                <a:off x="6919714" y="5332084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3" name="Elipse 113">
                <a:extLst>
                  <a:ext uri="{FF2B5EF4-FFF2-40B4-BE49-F238E27FC236}">
                    <a16:creationId xmlns:a16="http://schemas.microsoft.com/office/drawing/2014/main" id="{44EB9C50-A8BE-0542-4E43-8AADE45240EB}"/>
                  </a:ext>
                </a:extLst>
              </p:cNvPr>
              <p:cNvSpPr/>
              <p:nvPr/>
            </p:nvSpPr>
            <p:spPr>
              <a:xfrm>
                <a:off x="6220566" y="4675069"/>
                <a:ext cx="115373" cy="108884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54" name="Elipse 114">
                <a:extLst>
                  <a:ext uri="{FF2B5EF4-FFF2-40B4-BE49-F238E27FC236}">
                    <a16:creationId xmlns:a16="http://schemas.microsoft.com/office/drawing/2014/main" id="{1023FD42-7A02-78BE-F90A-CBE0F2595309}"/>
                  </a:ext>
                </a:extLst>
              </p:cNvPr>
              <p:cNvSpPr/>
              <p:nvPr/>
            </p:nvSpPr>
            <p:spPr>
              <a:xfrm>
                <a:off x="7441076" y="5062660"/>
                <a:ext cx="55942" cy="52795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5" name="Elipse 1">
                <a:extLst>
                  <a:ext uri="{FF2B5EF4-FFF2-40B4-BE49-F238E27FC236}">
                    <a16:creationId xmlns:a16="http://schemas.microsoft.com/office/drawing/2014/main" id="{94C68D56-D218-572E-7586-2ECF97D81506}"/>
                  </a:ext>
                </a:extLst>
              </p:cNvPr>
              <p:cNvSpPr/>
              <p:nvPr/>
            </p:nvSpPr>
            <p:spPr>
              <a:xfrm>
                <a:off x="7122249" y="4665980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6" name="Elipse 2">
                <a:extLst>
                  <a:ext uri="{FF2B5EF4-FFF2-40B4-BE49-F238E27FC236}">
                    <a16:creationId xmlns:a16="http://schemas.microsoft.com/office/drawing/2014/main" id="{5FDC7C0A-F7AC-37B6-7E56-1F888B6AF222}"/>
                  </a:ext>
                </a:extLst>
              </p:cNvPr>
              <p:cNvSpPr/>
              <p:nvPr/>
            </p:nvSpPr>
            <p:spPr>
              <a:xfrm>
                <a:off x="6748445" y="5066197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7" name="Elipse 3">
                <a:extLst>
                  <a:ext uri="{FF2B5EF4-FFF2-40B4-BE49-F238E27FC236}">
                    <a16:creationId xmlns:a16="http://schemas.microsoft.com/office/drawing/2014/main" id="{5554BD6B-FE74-DFB1-81EF-405A88182EB8}"/>
                  </a:ext>
                </a:extLst>
              </p:cNvPr>
              <p:cNvSpPr/>
              <p:nvPr/>
            </p:nvSpPr>
            <p:spPr>
              <a:xfrm>
                <a:off x="7219190" y="5182244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8" name="Elipse 4">
                <a:extLst>
                  <a:ext uri="{FF2B5EF4-FFF2-40B4-BE49-F238E27FC236}">
                    <a16:creationId xmlns:a16="http://schemas.microsoft.com/office/drawing/2014/main" id="{6C24F6E9-0D12-D891-740C-C911619010FC}"/>
                  </a:ext>
                </a:extLst>
              </p:cNvPr>
              <p:cNvSpPr/>
              <p:nvPr/>
            </p:nvSpPr>
            <p:spPr>
              <a:xfrm>
                <a:off x="6581311" y="4406469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59" name="Elipse 5">
                <a:extLst>
                  <a:ext uri="{FF2B5EF4-FFF2-40B4-BE49-F238E27FC236}">
                    <a16:creationId xmlns:a16="http://schemas.microsoft.com/office/drawing/2014/main" id="{136F7C87-70E6-395B-F928-2B42B7E96A7A}"/>
                  </a:ext>
                </a:extLst>
              </p:cNvPr>
              <p:cNvSpPr/>
              <p:nvPr/>
            </p:nvSpPr>
            <p:spPr>
              <a:xfrm>
                <a:off x="7003350" y="4258046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0" name="Elipse 6">
                <a:extLst>
                  <a:ext uri="{FF2B5EF4-FFF2-40B4-BE49-F238E27FC236}">
                    <a16:creationId xmlns:a16="http://schemas.microsoft.com/office/drawing/2014/main" id="{1DA8B222-1297-4C17-CEC6-3149D0830240}"/>
                  </a:ext>
                </a:extLst>
              </p:cNvPr>
              <p:cNvSpPr/>
              <p:nvPr/>
            </p:nvSpPr>
            <p:spPr>
              <a:xfrm>
                <a:off x="7649407" y="4532491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1" name="Elipse 7">
                <a:extLst>
                  <a:ext uri="{FF2B5EF4-FFF2-40B4-BE49-F238E27FC236}">
                    <a16:creationId xmlns:a16="http://schemas.microsoft.com/office/drawing/2014/main" id="{6F32ED3A-F0D3-08A6-A0BA-BDEB920ED254}"/>
                  </a:ext>
                </a:extLst>
              </p:cNvPr>
              <p:cNvSpPr/>
              <p:nvPr/>
            </p:nvSpPr>
            <p:spPr>
              <a:xfrm>
                <a:off x="7672271" y="4853206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2" name="Elipse 8">
                <a:extLst>
                  <a:ext uri="{FF2B5EF4-FFF2-40B4-BE49-F238E27FC236}">
                    <a16:creationId xmlns:a16="http://schemas.microsoft.com/office/drawing/2014/main" id="{218A6C82-0371-4AC3-F089-110F4B8223F4}"/>
                  </a:ext>
                </a:extLst>
              </p:cNvPr>
              <p:cNvSpPr/>
              <p:nvPr/>
            </p:nvSpPr>
            <p:spPr>
              <a:xfrm>
                <a:off x="7218628" y="5451297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3" name="Elipse 10">
                <a:extLst>
                  <a:ext uri="{FF2B5EF4-FFF2-40B4-BE49-F238E27FC236}">
                    <a16:creationId xmlns:a16="http://schemas.microsoft.com/office/drawing/2014/main" id="{C707DE11-BE61-C2F9-DBE1-010AA608F6BC}"/>
                  </a:ext>
                </a:extLst>
              </p:cNvPr>
              <p:cNvSpPr/>
              <p:nvPr/>
            </p:nvSpPr>
            <p:spPr>
              <a:xfrm>
                <a:off x="6559681" y="5245249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4" name="Elipse 11">
                <a:extLst>
                  <a:ext uri="{FF2B5EF4-FFF2-40B4-BE49-F238E27FC236}">
                    <a16:creationId xmlns:a16="http://schemas.microsoft.com/office/drawing/2014/main" id="{B94E07E7-7361-9C83-ED2A-066168DCD278}"/>
                  </a:ext>
                </a:extLst>
              </p:cNvPr>
              <p:cNvSpPr/>
              <p:nvPr/>
            </p:nvSpPr>
            <p:spPr>
              <a:xfrm>
                <a:off x="6390452" y="4905527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5" name="Elipse 12">
                <a:extLst>
                  <a:ext uri="{FF2B5EF4-FFF2-40B4-BE49-F238E27FC236}">
                    <a16:creationId xmlns:a16="http://schemas.microsoft.com/office/drawing/2014/main" id="{78EA69C8-A9B4-9F7B-B073-47C65A2266B3}"/>
                  </a:ext>
                </a:extLst>
              </p:cNvPr>
              <p:cNvSpPr/>
              <p:nvPr/>
            </p:nvSpPr>
            <p:spPr>
              <a:xfrm>
                <a:off x="6923162" y="4620261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6" name="Elipse 13">
                <a:extLst>
                  <a:ext uri="{FF2B5EF4-FFF2-40B4-BE49-F238E27FC236}">
                    <a16:creationId xmlns:a16="http://schemas.microsoft.com/office/drawing/2014/main" id="{9EFFE93C-DE75-241A-FBBC-2904DD0C772B}"/>
                  </a:ext>
                </a:extLst>
              </p:cNvPr>
              <p:cNvSpPr/>
              <p:nvPr/>
            </p:nvSpPr>
            <p:spPr>
              <a:xfrm>
                <a:off x="7343526" y="5268108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7" name="Elipse 14">
                <a:extLst>
                  <a:ext uri="{FF2B5EF4-FFF2-40B4-BE49-F238E27FC236}">
                    <a16:creationId xmlns:a16="http://schemas.microsoft.com/office/drawing/2014/main" id="{BA9598DD-B842-835D-9264-03CBF8875AC7}"/>
                  </a:ext>
                </a:extLst>
              </p:cNvPr>
              <p:cNvSpPr/>
              <p:nvPr/>
            </p:nvSpPr>
            <p:spPr>
              <a:xfrm>
                <a:off x="6750104" y="4111095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8" name="Elipse 15">
                <a:extLst>
                  <a:ext uri="{FF2B5EF4-FFF2-40B4-BE49-F238E27FC236}">
                    <a16:creationId xmlns:a16="http://schemas.microsoft.com/office/drawing/2014/main" id="{A263CFF6-E52D-49A0-24F3-4094FFC166C0}"/>
                  </a:ext>
                </a:extLst>
              </p:cNvPr>
              <p:cNvSpPr/>
              <p:nvPr/>
            </p:nvSpPr>
            <p:spPr>
              <a:xfrm>
                <a:off x="6414674" y="5147803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69" name="Elipse 16">
                <a:extLst>
                  <a:ext uri="{FF2B5EF4-FFF2-40B4-BE49-F238E27FC236}">
                    <a16:creationId xmlns:a16="http://schemas.microsoft.com/office/drawing/2014/main" id="{DF29906F-DD74-57B0-36B6-80A4EF159BA0}"/>
                  </a:ext>
                </a:extLst>
              </p:cNvPr>
              <p:cNvSpPr/>
              <p:nvPr/>
            </p:nvSpPr>
            <p:spPr>
              <a:xfrm>
                <a:off x="6398030" y="4464139"/>
                <a:ext cx="48444" cy="45719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5875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70" name="Forma libre: forma 27">
                <a:extLst>
                  <a:ext uri="{FF2B5EF4-FFF2-40B4-BE49-F238E27FC236}">
                    <a16:creationId xmlns:a16="http://schemas.microsoft.com/office/drawing/2014/main" id="{19522AD2-B3CB-4AD4-00D5-304DAFDEF015}"/>
                  </a:ext>
                </a:extLst>
              </p:cNvPr>
              <p:cNvSpPr/>
              <p:nvPr/>
            </p:nvSpPr>
            <p:spPr>
              <a:xfrm>
                <a:off x="7364324" y="5307729"/>
                <a:ext cx="255192" cy="217067"/>
              </a:xfrm>
              <a:custGeom>
                <a:avLst/>
                <a:gdLst>
                  <a:gd name="connsiteX0" fmla="*/ 8539 w 255192"/>
                  <a:gd name="connsiteY0" fmla="*/ 215906 h 217067"/>
                  <a:gd name="connsiteX1" fmla="*/ 8539 w 255192"/>
                  <a:gd name="connsiteY1" fmla="*/ 139706 h 217067"/>
                  <a:gd name="connsiteX2" fmla="*/ 63573 w 255192"/>
                  <a:gd name="connsiteY2" fmla="*/ 42339 h 217067"/>
                  <a:gd name="connsiteX3" fmla="*/ 160939 w 255192"/>
                  <a:gd name="connsiteY3" fmla="*/ 67739 h 217067"/>
                  <a:gd name="connsiteX4" fmla="*/ 211739 w 255192"/>
                  <a:gd name="connsiteY4" fmla="*/ 8473 h 217067"/>
                  <a:gd name="connsiteX5" fmla="*/ 254073 w 255192"/>
                  <a:gd name="connsiteY5" fmla="*/ 12706 h 217067"/>
                  <a:gd name="connsiteX6" fmla="*/ 165173 w 255192"/>
                  <a:gd name="connsiteY6" fmla="*/ 122773 h 217067"/>
                  <a:gd name="connsiteX7" fmla="*/ 88973 w 255192"/>
                  <a:gd name="connsiteY7" fmla="*/ 182039 h 217067"/>
                  <a:gd name="connsiteX8" fmla="*/ 8539 w 255192"/>
                  <a:gd name="connsiteY8" fmla="*/ 215906 h 2170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55192" h="217067">
                    <a:moveTo>
                      <a:pt x="8539" y="215906"/>
                    </a:moveTo>
                    <a:cubicBezTo>
                      <a:pt x="-4867" y="208851"/>
                      <a:pt x="-633" y="168634"/>
                      <a:pt x="8539" y="139706"/>
                    </a:cubicBezTo>
                    <a:cubicBezTo>
                      <a:pt x="17711" y="110778"/>
                      <a:pt x="38173" y="54334"/>
                      <a:pt x="63573" y="42339"/>
                    </a:cubicBezTo>
                    <a:cubicBezTo>
                      <a:pt x="88973" y="30344"/>
                      <a:pt x="136245" y="73383"/>
                      <a:pt x="160939" y="67739"/>
                    </a:cubicBezTo>
                    <a:cubicBezTo>
                      <a:pt x="185633" y="62095"/>
                      <a:pt x="196217" y="17645"/>
                      <a:pt x="211739" y="8473"/>
                    </a:cubicBezTo>
                    <a:cubicBezTo>
                      <a:pt x="227261" y="-699"/>
                      <a:pt x="261834" y="-6344"/>
                      <a:pt x="254073" y="12706"/>
                    </a:cubicBezTo>
                    <a:cubicBezTo>
                      <a:pt x="246312" y="31756"/>
                      <a:pt x="192690" y="94551"/>
                      <a:pt x="165173" y="122773"/>
                    </a:cubicBezTo>
                    <a:cubicBezTo>
                      <a:pt x="137656" y="150995"/>
                      <a:pt x="114373" y="167928"/>
                      <a:pt x="88973" y="182039"/>
                    </a:cubicBezTo>
                    <a:cubicBezTo>
                      <a:pt x="63573" y="196150"/>
                      <a:pt x="21945" y="222961"/>
                      <a:pt x="8539" y="215906"/>
                    </a:cubicBezTo>
                    <a:close/>
                  </a:path>
                </a:pathLst>
              </a:custGeom>
              <a:solidFill>
                <a:schemeClr val="accent4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71" name="Forma libre: forma 28">
                <a:extLst>
                  <a:ext uri="{FF2B5EF4-FFF2-40B4-BE49-F238E27FC236}">
                    <a16:creationId xmlns:a16="http://schemas.microsoft.com/office/drawing/2014/main" id="{2077F9CB-AB7E-DE2B-A3D4-868A3C175857}"/>
                  </a:ext>
                </a:extLst>
              </p:cNvPr>
              <p:cNvSpPr/>
              <p:nvPr/>
            </p:nvSpPr>
            <p:spPr>
              <a:xfrm rot="10971800">
                <a:off x="6389540" y="4120187"/>
                <a:ext cx="255192" cy="217067"/>
              </a:xfrm>
              <a:custGeom>
                <a:avLst/>
                <a:gdLst>
                  <a:gd name="connsiteX0" fmla="*/ 8539 w 255192"/>
                  <a:gd name="connsiteY0" fmla="*/ 215906 h 217067"/>
                  <a:gd name="connsiteX1" fmla="*/ 8539 w 255192"/>
                  <a:gd name="connsiteY1" fmla="*/ 139706 h 217067"/>
                  <a:gd name="connsiteX2" fmla="*/ 63573 w 255192"/>
                  <a:gd name="connsiteY2" fmla="*/ 42339 h 217067"/>
                  <a:gd name="connsiteX3" fmla="*/ 160939 w 255192"/>
                  <a:gd name="connsiteY3" fmla="*/ 67739 h 217067"/>
                  <a:gd name="connsiteX4" fmla="*/ 211739 w 255192"/>
                  <a:gd name="connsiteY4" fmla="*/ 8473 h 217067"/>
                  <a:gd name="connsiteX5" fmla="*/ 254073 w 255192"/>
                  <a:gd name="connsiteY5" fmla="*/ 12706 h 217067"/>
                  <a:gd name="connsiteX6" fmla="*/ 165173 w 255192"/>
                  <a:gd name="connsiteY6" fmla="*/ 122773 h 217067"/>
                  <a:gd name="connsiteX7" fmla="*/ 88973 w 255192"/>
                  <a:gd name="connsiteY7" fmla="*/ 182039 h 217067"/>
                  <a:gd name="connsiteX8" fmla="*/ 8539 w 255192"/>
                  <a:gd name="connsiteY8" fmla="*/ 215906 h 2170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55192" h="217067">
                    <a:moveTo>
                      <a:pt x="8539" y="215906"/>
                    </a:moveTo>
                    <a:cubicBezTo>
                      <a:pt x="-4867" y="208851"/>
                      <a:pt x="-633" y="168634"/>
                      <a:pt x="8539" y="139706"/>
                    </a:cubicBezTo>
                    <a:cubicBezTo>
                      <a:pt x="17711" y="110778"/>
                      <a:pt x="38173" y="54334"/>
                      <a:pt x="63573" y="42339"/>
                    </a:cubicBezTo>
                    <a:cubicBezTo>
                      <a:pt x="88973" y="30344"/>
                      <a:pt x="136245" y="73383"/>
                      <a:pt x="160939" y="67739"/>
                    </a:cubicBezTo>
                    <a:cubicBezTo>
                      <a:pt x="185633" y="62095"/>
                      <a:pt x="196217" y="17645"/>
                      <a:pt x="211739" y="8473"/>
                    </a:cubicBezTo>
                    <a:cubicBezTo>
                      <a:pt x="227261" y="-699"/>
                      <a:pt x="261834" y="-6344"/>
                      <a:pt x="254073" y="12706"/>
                    </a:cubicBezTo>
                    <a:cubicBezTo>
                      <a:pt x="246312" y="31756"/>
                      <a:pt x="192690" y="94551"/>
                      <a:pt x="165173" y="122773"/>
                    </a:cubicBezTo>
                    <a:cubicBezTo>
                      <a:pt x="137656" y="150995"/>
                      <a:pt x="114373" y="167928"/>
                      <a:pt x="88973" y="182039"/>
                    </a:cubicBezTo>
                    <a:cubicBezTo>
                      <a:pt x="63573" y="196150"/>
                      <a:pt x="21945" y="222961"/>
                      <a:pt x="8539" y="215906"/>
                    </a:cubicBezTo>
                    <a:close/>
                  </a:path>
                </a:pathLst>
              </a:custGeom>
              <a:solidFill>
                <a:schemeClr val="accent4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</p:grpSp>
      <p:grpSp>
        <p:nvGrpSpPr>
          <p:cNvPr id="8" name="Grupo 36">
            <a:extLst>
              <a:ext uri="{FF2B5EF4-FFF2-40B4-BE49-F238E27FC236}">
                <a16:creationId xmlns:a16="http://schemas.microsoft.com/office/drawing/2014/main" id="{0E7DEE69-37AB-0B47-3E96-F8AFCD01B497}"/>
              </a:ext>
            </a:extLst>
          </p:cNvPr>
          <p:cNvGrpSpPr/>
          <p:nvPr/>
        </p:nvGrpSpPr>
        <p:grpSpPr>
          <a:xfrm>
            <a:off x="170045" y="2258931"/>
            <a:ext cx="1573772" cy="2050479"/>
            <a:chOff x="123741" y="2321810"/>
            <a:chExt cx="2736387" cy="3265304"/>
          </a:xfrm>
        </p:grpSpPr>
        <p:grpSp>
          <p:nvGrpSpPr>
            <p:cNvPr id="31" name="Grupo 165">
              <a:extLst>
                <a:ext uri="{FF2B5EF4-FFF2-40B4-BE49-F238E27FC236}">
                  <a16:creationId xmlns:a16="http://schemas.microsoft.com/office/drawing/2014/main" id="{44954138-D8D5-74E1-3E8D-3C8BF19FCAF7}"/>
                </a:ext>
              </a:extLst>
            </p:cNvPr>
            <p:cNvGrpSpPr/>
            <p:nvPr/>
          </p:nvGrpSpPr>
          <p:grpSpPr>
            <a:xfrm>
              <a:off x="810891" y="2321810"/>
              <a:ext cx="2049237" cy="2724101"/>
              <a:chOff x="810891" y="2321810"/>
              <a:chExt cx="2049237" cy="2724101"/>
            </a:xfrm>
          </p:grpSpPr>
          <p:grpSp>
            <p:nvGrpSpPr>
              <p:cNvPr id="36" name="Grupo 166">
                <a:extLst>
                  <a:ext uri="{FF2B5EF4-FFF2-40B4-BE49-F238E27FC236}">
                    <a16:creationId xmlns:a16="http://schemas.microsoft.com/office/drawing/2014/main" id="{23FA13DD-6B16-F06D-1C61-02042989504D}"/>
                  </a:ext>
                </a:extLst>
              </p:cNvPr>
              <p:cNvGrpSpPr/>
              <p:nvPr/>
            </p:nvGrpSpPr>
            <p:grpSpPr>
              <a:xfrm>
                <a:off x="810891" y="2321810"/>
                <a:ext cx="2049237" cy="2724101"/>
                <a:chOff x="810891" y="2321809"/>
                <a:chExt cx="2735801" cy="3628021"/>
              </a:xfrm>
            </p:grpSpPr>
            <p:sp>
              <p:nvSpPr>
                <p:cNvPr id="40" name="Forma libre: forma 170">
                  <a:extLst>
                    <a:ext uri="{FF2B5EF4-FFF2-40B4-BE49-F238E27FC236}">
                      <a16:creationId xmlns:a16="http://schemas.microsoft.com/office/drawing/2014/main" id="{DEDC6A46-5453-523E-97B1-872473AD7F81}"/>
                    </a:ext>
                  </a:extLst>
                </p:cNvPr>
                <p:cNvSpPr/>
                <p:nvPr/>
              </p:nvSpPr>
              <p:spPr>
                <a:xfrm>
                  <a:off x="2341875" y="3887989"/>
                  <a:ext cx="625792" cy="2061841"/>
                </a:xfrm>
                <a:custGeom>
                  <a:avLst/>
                  <a:gdLst>
                    <a:gd name="connsiteX0" fmla="*/ 83858 w 625792"/>
                    <a:gd name="connsiteY0" fmla="*/ 3352 h 2061841"/>
                    <a:gd name="connsiteX1" fmla="*/ 382308 w 625792"/>
                    <a:gd name="connsiteY1" fmla="*/ 149402 h 2061841"/>
                    <a:gd name="connsiteX2" fmla="*/ 490258 w 625792"/>
                    <a:gd name="connsiteY2" fmla="*/ 358952 h 2061841"/>
                    <a:gd name="connsiteX3" fmla="*/ 579158 w 625792"/>
                    <a:gd name="connsiteY3" fmla="*/ 720902 h 2061841"/>
                    <a:gd name="connsiteX4" fmla="*/ 572808 w 625792"/>
                    <a:gd name="connsiteY4" fmla="*/ 1209852 h 2061841"/>
                    <a:gd name="connsiteX5" fmla="*/ 623608 w 625792"/>
                    <a:gd name="connsiteY5" fmla="*/ 1800402 h 2061841"/>
                    <a:gd name="connsiteX6" fmla="*/ 598208 w 625792"/>
                    <a:gd name="connsiteY6" fmla="*/ 2029002 h 2061841"/>
                    <a:gd name="connsiteX7" fmla="*/ 439458 w 625792"/>
                    <a:gd name="connsiteY7" fmla="*/ 2041702 h 2061841"/>
                    <a:gd name="connsiteX8" fmla="*/ 433108 w 625792"/>
                    <a:gd name="connsiteY8" fmla="*/ 1851202 h 2061841"/>
                    <a:gd name="connsiteX9" fmla="*/ 433108 w 625792"/>
                    <a:gd name="connsiteY9" fmla="*/ 1292402 h 2061841"/>
                    <a:gd name="connsiteX10" fmla="*/ 401358 w 625792"/>
                    <a:gd name="connsiteY10" fmla="*/ 886002 h 2061841"/>
                    <a:gd name="connsiteX11" fmla="*/ 337858 w 625792"/>
                    <a:gd name="connsiteY11" fmla="*/ 651052 h 2061841"/>
                    <a:gd name="connsiteX12" fmla="*/ 160058 w 625792"/>
                    <a:gd name="connsiteY12" fmla="*/ 657402 h 2061841"/>
                    <a:gd name="connsiteX13" fmla="*/ 77508 w 625792"/>
                    <a:gd name="connsiteY13" fmla="*/ 714552 h 2061841"/>
                    <a:gd name="connsiteX14" fmla="*/ 39408 w 625792"/>
                    <a:gd name="connsiteY14" fmla="*/ 670102 h 2061841"/>
                    <a:gd name="connsiteX15" fmla="*/ 52108 w 625792"/>
                    <a:gd name="connsiteY15" fmla="*/ 498652 h 2061841"/>
                    <a:gd name="connsiteX16" fmla="*/ 52108 w 625792"/>
                    <a:gd name="connsiteY16" fmla="*/ 276402 h 2061841"/>
                    <a:gd name="connsiteX17" fmla="*/ 1308 w 625792"/>
                    <a:gd name="connsiteY17" fmla="*/ 149402 h 2061841"/>
                    <a:gd name="connsiteX18" fmla="*/ 20358 w 625792"/>
                    <a:gd name="connsiteY18" fmla="*/ 54152 h 2061841"/>
                    <a:gd name="connsiteX19" fmla="*/ 83858 w 625792"/>
                    <a:gd name="connsiteY19" fmla="*/ 3352 h 20618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625792" h="2061841">
                      <a:moveTo>
                        <a:pt x="83858" y="3352"/>
                      </a:moveTo>
                      <a:cubicBezTo>
                        <a:pt x="144183" y="19227"/>
                        <a:pt x="314575" y="90135"/>
                        <a:pt x="382308" y="149402"/>
                      </a:cubicBezTo>
                      <a:cubicBezTo>
                        <a:pt x="450041" y="208669"/>
                        <a:pt x="457450" y="263702"/>
                        <a:pt x="490258" y="358952"/>
                      </a:cubicBezTo>
                      <a:cubicBezTo>
                        <a:pt x="523066" y="454202"/>
                        <a:pt x="565400" y="579085"/>
                        <a:pt x="579158" y="720902"/>
                      </a:cubicBezTo>
                      <a:cubicBezTo>
                        <a:pt x="592916" y="862719"/>
                        <a:pt x="565400" y="1029935"/>
                        <a:pt x="572808" y="1209852"/>
                      </a:cubicBezTo>
                      <a:cubicBezTo>
                        <a:pt x="580216" y="1389769"/>
                        <a:pt x="619375" y="1663877"/>
                        <a:pt x="623608" y="1800402"/>
                      </a:cubicBezTo>
                      <a:cubicBezTo>
                        <a:pt x="627841" y="1936927"/>
                        <a:pt x="628900" y="1988785"/>
                        <a:pt x="598208" y="2029002"/>
                      </a:cubicBezTo>
                      <a:cubicBezTo>
                        <a:pt x="567516" y="2069219"/>
                        <a:pt x="466975" y="2071335"/>
                        <a:pt x="439458" y="2041702"/>
                      </a:cubicBezTo>
                      <a:cubicBezTo>
                        <a:pt x="411941" y="2012069"/>
                        <a:pt x="434166" y="1976085"/>
                        <a:pt x="433108" y="1851202"/>
                      </a:cubicBezTo>
                      <a:cubicBezTo>
                        <a:pt x="432050" y="1726319"/>
                        <a:pt x="438400" y="1453269"/>
                        <a:pt x="433108" y="1292402"/>
                      </a:cubicBezTo>
                      <a:cubicBezTo>
                        <a:pt x="427816" y="1131535"/>
                        <a:pt x="417233" y="992894"/>
                        <a:pt x="401358" y="886002"/>
                      </a:cubicBezTo>
                      <a:cubicBezTo>
                        <a:pt x="385483" y="779110"/>
                        <a:pt x="378075" y="689152"/>
                        <a:pt x="337858" y="651052"/>
                      </a:cubicBezTo>
                      <a:cubicBezTo>
                        <a:pt x="297641" y="612952"/>
                        <a:pt x="203450" y="646819"/>
                        <a:pt x="160058" y="657402"/>
                      </a:cubicBezTo>
                      <a:cubicBezTo>
                        <a:pt x="116666" y="667985"/>
                        <a:pt x="97616" y="712435"/>
                        <a:pt x="77508" y="714552"/>
                      </a:cubicBezTo>
                      <a:cubicBezTo>
                        <a:pt x="57400" y="716669"/>
                        <a:pt x="43641" y="706085"/>
                        <a:pt x="39408" y="670102"/>
                      </a:cubicBezTo>
                      <a:cubicBezTo>
                        <a:pt x="35175" y="634119"/>
                        <a:pt x="49991" y="564269"/>
                        <a:pt x="52108" y="498652"/>
                      </a:cubicBezTo>
                      <a:cubicBezTo>
                        <a:pt x="54225" y="433035"/>
                        <a:pt x="60575" y="334610"/>
                        <a:pt x="52108" y="276402"/>
                      </a:cubicBezTo>
                      <a:cubicBezTo>
                        <a:pt x="43641" y="218194"/>
                        <a:pt x="6600" y="186444"/>
                        <a:pt x="1308" y="149402"/>
                      </a:cubicBezTo>
                      <a:cubicBezTo>
                        <a:pt x="-3984" y="112360"/>
                        <a:pt x="7658" y="76377"/>
                        <a:pt x="20358" y="54152"/>
                      </a:cubicBezTo>
                      <a:cubicBezTo>
                        <a:pt x="33058" y="31927"/>
                        <a:pt x="23533" y="-12523"/>
                        <a:pt x="83858" y="3352"/>
                      </a:cubicBezTo>
                      <a:close/>
                    </a:path>
                  </a:pathLst>
                </a:custGeom>
                <a:solidFill>
                  <a:srgbClr val="FECC96"/>
                </a:solidFill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  <p:grpSp>
              <p:nvGrpSpPr>
                <p:cNvPr id="41" name="Grupo 171">
                  <a:extLst>
                    <a:ext uri="{FF2B5EF4-FFF2-40B4-BE49-F238E27FC236}">
                      <a16:creationId xmlns:a16="http://schemas.microsoft.com/office/drawing/2014/main" id="{1E4246DF-D57B-9DE2-5DF3-31695371E365}"/>
                    </a:ext>
                  </a:extLst>
                </p:cNvPr>
                <p:cNvGrpSpPr/>
                <p:nvPr/>
              </p:nvGrpSpPr>
              <p:grpSpPr>
                <a:xfrm>
                  <a:off x="810891" y="2321809"/>
                  <a:ext cx="2735801" cy="3347037"/>
                  <a:chOff x="810891" y="2321809"/>
                  <a:chExt cx="2735801" cy="3347037"/>
                </a:xfrm>
              </p:grpSpPr>
              <p:sp>
                <p:nvSpPr>
                  <p:cNvPr id="42" name="Forma libre: forma 172">
                    <a:extLst>
                      <a:ext uri="{FF2B5EF4-FFF2-40B4-BE49-F238E27FC236}">
                        <a16:creationId xmlns:a16="http://schemas.microsoft.com/office/drawing/2014/main" id="{EBA82C15-48B2-5CB2-74B5-78A694EC2B2D}"/>
                      </a:ext>
                    </a:extLst>
                  </p:cNvPr>
                  <p:cNvSpPr/>
                  <p:nvPr/>
                </p:nvSpPr>
                <p:spPr>
                  <a:xfrm>
                    <a:off x="2219608" y="2991727"/>
                    <a:ext cx="1327084" cy="2494234"/>
                  </a:xfrm>
                  <a:custGeom>
                    <a:avLst/>
                    <a:gdLst>
                      <a:gd name="connsiteX0" fmla="*/ 937009 w 1327084"/>
                      <a:gd name="connsiteY0" fmla="*/ 1557 h 2494234"/>
                      <a:gd name="connsiteX1" fmla="*/ 1114809 w 1327084"/>
                      <a:gd name="connsiteY1" fmla="*/ 26957 h 2494234"/>
                      <a:gd name="connsiteX2" fmla="*/ 1324359 w 1327084"/>
                      <a:gd name="connsiteY2" fmla="*/ 33307 h 2494234"/>
                      <a:gd name="connsiteX3" fmla="*/ 1235459 w 1327084"/>
                      <a:gd name="connsiteY3" fmla="*/ 280957 h 2494234"/>
                      <a:gd name="connsiteX4" fmla="*/ 1254509 w 1327084"/>
                      <a:gd name="connsiteY4" fmla="*/ 693707 h 2494234"/>
                      <a:gd name="connsiteX5" fmla="*/ 1254509 w 1327084"/>
                      <a:gd name="connsiteY5" fmla="*/ 852457 h 2494234"/>
                      <a:gd name="connsiteX6" fmla="*/ 1254509 w 1327084"/>
                      <a:gd name="connsiteY6" fmla="*/ 2236757 h 2494234"/>
                      <a:gd name="connsiteX7" fmla="*/ 1292609 w 1327084"/>
                      <a:gd name="connsiteY7" fmla="*/ 2459007 h 2494234"/>
                      <a:gd name="connsiteX8" fmla="*/ 1051309 w 1327084"/>
                      <a:gd name="connsiteY8" fmla="*/ 2484407 h 2494234"/>
                      <a:gd name="connsiteX9" fmla="*/ 911609 w 1327084"/>
                      <a:gd name="connsiteY9" fmla="*/ 2363757 h 2494234"/>
                      <a:gd name="connsiteX10" fmla="*/ 917959 w 1327084"/>
                      <a:gd name="connsiteY10" fmla="*/ 1785907 h 2494234"/>
                      <a:gd name="connsiteX11" fmla="*/ 848109 w 1327084"/>
                      <a:gd name="connsiteY11" fmla="*/ 1182657 h 2494234"/>
                      <a:gd name="connsiteX12" fmla="*/ 721109 w 1327084"/>
                      <a:gd name="connsiteY12" fmla="*/ 1277907 h 2494234"/>
                      <a:gd name="connsiteX13" fmla="*/ 251209 w 1327084"/>
                      <a:gd name="connsiteY13" fmla="*/ 1487457 h 2494234"/>
                      <a:gd name="connsiteX14" fmla="*/ 124209 w 1327084"/>
                      <a:gd name="connsiteY14" fmla="*/ 1493807 h 2494234"/>
                      <a:gd name="connsiteX15" fmla="*/ 73409 w 1327084"/>
                      <a:gd name="connsiteY15" fmla="*/ 1398557 h 2494234"/>
                      <a:gd name="connsiteX16" fmla="*/ 321059 w 1327084"/>
                      <a:gd name="connsiteY16" fmla="*/ 1309657 h 2494234"/>
                      <a:gd name="connsiteX17" fmla="*/ 651259 w 1327084"/>
                      <a:gd name="connsiteY17" fmla="*/ 1087407 h 2494234"/>
                      <a:gd name="connsiteX18" fmla="*/ 587759 w 1327084"/>
                      <a:gd name="connsiteY18" fmla="*/ 985807 h 2494234"/>
                      <a:gd name="connsiteX19" fmla="*/ 422659 w 1327084"/>
                      <a:gd name="connsiteY19" fmla="*/ 1087407 h 2494234"/>
                      <a:gd name="connsiteX20" fmla="*/ 244859 w 1327084"/>
                      <a:gd name="connsiteY20" fmla="*/ 1163607 h 2494234"/>
                      <a:gd name="connsiteX21" fmla="*/ 48009 w 1327084"/>
                      <a:gd name="connsiteY21" fmla="*/ 1176307 h 2494234"/>
                      <a:gd name="connsiteX22" fmla="*/ 16259 w 1327084"/>
                      <a:gd name="connsiteY22" fmla="*/ 992157 h 2494234"/>
                      <a:gd name="connsiteX23" fmla="*/ 263909 w 1327084"/>
                      <a:gd name="connsiteY23" fmla="*/ 960407 h 2494234"/>
                      <a:gd name="connsiteX24" fmla="*/ 492509 w 1327084"/>
                      <a:gd name="connsiteY24" fmla="*/ 903257 h 2494234"/>
                      <a:gd name="connsiteX25" fmla="*/ 632209 w 1327084"/>
                      <a:gd name="connsiteY25" fmla="*/ 801657 h 2494234"/>
                      <a:gd name="connsiteX26" fmla="*/ 441709 w 1327084"/>
                      <a:gd name="connsiteY26" fmla="*/ 655607 h 2494234"/>
                      <a:gd name="connsiteX27" fmla="*/ 257559 w 1327084"/>
                      <a:gd name="connsiteY27" fmla="*/ 592107 h 2494234"/>
                      <a:gd name="connsiteX28" fmla="*/ 130559 w 1327084"/>
                      <a:gd name="connsiteY28" fmla="*/ 547657 h 2494234"/>
                      <a:gd name="connsiteX29" fmla="*/ 130559 w 1327084"/>
                      <a:gd name="connsiteY29" fmla="*/ 401607 h 2494234"/>
                      <a:gd name="connsiteX30" fmla="*/ 225809 w 1327084"/>
                      <a:gd name="connsiteY30" fmla="*/ 369857 h 2494234"/>
                      <a:gd name="connsiteX31" fmla="*/ 454409 w 1327084"/>
                      <a:gd name="connsiteY31" fmla="*/ 554007 h 2494234"/>
                      <a:gd name="connsiteX32" fmla="*/ 625859 w 1327084"/>
                      <a:gd name="connsiteY32" fmla="*/ 630207 h 2494234"/>
                      <a:gd name="connsiteX33" fmla="*/ 746509 w 1327084"/>
                      <a:gd name="connsiteY33" fmla="*/ 725457 h 2494234"/>
                      <a:gd name="connsiteX34" fmla="*/ 841759 w 1327084"/>
                      <a:gd name="connsiteY34" fmla="*/ 674657 h 2494234"/>
                      <a:gd name="connsiteX35" fmla="*/ 854459 w 1327084"/>
                      <a:gd name="connsiteY35" fmla="*/ 357157 h 2494234"/>
                      <a:gd name="connsiteX36" fmla="*/ 860809 w 1327084"/>
                      <a:gd name="connsiteY36" fmla="*/ 77757 h 2494234"/>
                      <a:gd name="connsiteX37" fmla="*/ 937009 w 1327084"/>
                      <a:gd name="connsiteY37" fmla="*/ 1557 h 249423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</a:cxnLst>
                    <a:rect l="l" t="t" r="r" b="b"/>
                    <a:pathLst>
                      <a:path w="1327084" h="2494234">
                        <a:moveTo>
                          <a:pt x="937009" y="1557"/>
                        </a:moveTo>
                        <a:cubicBezTo>
                          <a:pt x="979342" y="-6910"/>
                          <a:pt x="1050251" y="21665"/>
                          <a:pt x="1114809" y="26957"/>
                        </a:cubicBezTo>
                        <a:cubicBezTo>
                          <a:pt x="1179367" y="32249"/>
                          <a:pt x="1304251" y="-9026"/>
                          <a:pt x="1324359" y="33307"/>
                        </a:cubicBezTo>
                        <a:cubicBezTo>
                          <a:pt x="1344467" y="75640"/>
                          <a:pt x="1247101" y="170890"/>
                          <a:pt x="1235459" y="280957"/>
                        </a:cubicBezTo>
                        <a:cubicBezTo>
                          <a:pt x="1223817" y="391024"/>
                          <a:pt x="1251334" y="598457"/>
                          <a:pt x="1254509" y="693707"/>
                        </a:cubicBezTo>
                        <a:cubicBezTo>
                          <a:pt x="1257684" y="788957"/>
                          <a:pt x="1254509" y="852457"/>
                          <a:pt x="1254509" y="852457"/>
                        </a:cubicBezTo>
                        <a:cubicBezTo>
                          <a:pt x="1254509" y="1109632"/>
                          <a:pt x="1248159" y="1968999"/>
                          <a:pt x="1254509" y="2236757"/>
                        </a:cubicBezTo>
                        <a:cubicBezTo>
                          <a:pt x="1260859" y="2504515"/>
                          <a:pt x="1326476" y="2417732"/>
                          <a:pt x="1292609" y="2459007"/>
                        </a:cubicBezTo>
                        <a:cubicBezTo>
                          <a:pt x="1258742" y="2500282"/>
                          <a:pt x="1114809" y="2500282"/>
                          <a:pt x="1051309" y="2484407"/>
                        </a:cubicBezTo>
                        <a:cubicBezTo>
                          <a:pt x="987809" y="2468532"/>
                          <a:pt x="933834" y="2480174"/>
                          <a:pt x="911609" y="2363757"/>
                        </a:cubicBezTo>
                        <a:cubicBezTo>
                          <a:pt x="889384" y="2247340"/>
                          <a:pt x="928542" y="1982757"/>
                          <a:pt x="917959" y="1785907"/>
                        </a:cubicBezTo>
                        <a:cubicBezTo>
                          <a:pt x="907376" y="1589057"/>
                          <a:pt x="880917" y="1267324"/>
                          <a:pt x="848109" y="1182657"/>
                        </a:cubicBezTo>
                        <a:cubicBezTo>
                          <a:pt x="815301" y="1097990"/>
                          <a:pt x="820592" y="1227107"/>
                          <a:pt x="721109" y="1277907"/>
                        </a:cubicBezTo>
                        <a:cubicBezTo>
                          <a:pt x="621626" y="1328707"/>
                          <a:pt x="350692" y="1451474"/>
                          <a:pt x="251209" y="1487457"/>
                        </a:cubicBezTo>
                        <a:cubicBezTo>
                          <a:pt x="151726" y="1523440"/>
                          <a:pt x="153842" y="1508624"/>
                          <a:pt x="124209" y="1493807"/>
                        </a:cubicBezTo>
                        <a:cubicBezTo>
                          <a:pt x="94576" y="1478990"/>
                          <a:pt x="40601" y="1429249"/>
                          <a:pt x="73409" y="1398557"/>
                        </a:cubicBezTo>
                        <a:cubicBezTo>
                          <a:pt x="106217" y="1367865"/>
                          <a:pt x="224751" y="1361515"/>
                          <a:pt x="321059" y="1309657"/>
                        </a:cubicBezTo>
                        <a:cubicBezTo>
                          <a:pt x="417367" y="1257799"/>
                          <a:pt x="606809" y="1141382"/>
                          <a:pt x="651259" y="1087407"/>
                        </a:cubicBezTo>
                        <a:cubicBezTo>
                          <a:pt x="695709" y="1033432"/>
                          <a:pt x="625859" y="985807"/>
                          <a:pt x="587759" y="985807"/>
                        </a:cubicBezTo>
                        <a:cubicBezTo>
                          <a:pt x="549659" y="985807"/>
                          <a:pt x="479809" y="1057774"/>
                          <a:pt x="422659" y="1087407"/>
                        </a:cubicBezTo>
                        <a:cubicBezTo>
                          <a:pt x="365509" y="1117040"/>
                          <a:pt x="307301" y="1148790"/>
                          <a:pt x="244859" y="1163607"/>
                        </a:cubicBezTo>
                        <a:cubicBezTo>
                          <a:pt x="182417" y="1178424"/>
                          <a:pt x="86109" y="1204882"/>
                          <a:pt x="48009" y="1176307"/>
                        </a:cubicBezTo>
                        <a:cubicBezTo>
                          <a:pt x="9909" y="1147732"/>
                          <a:pt x="-19724" y="1028140"/>
                          <a:pt x="16259" y="992157"/>
                        </a:cubicBezTo>
                        <a:cubicBezTo>
                          <a:pt x="52242" y="956174"/>
                          <a:pt x="184534" y="975224"/>
                          <a:pt x="263909" y="960407"/>
                        </a:cubicBezTo>
                        <a:cubicBezTo>
                          <a:pt x="343284" y="945590"/>
                          <a:pt x="431126" y="929715"/>
                          <a:pt x="492509" y="903257"/>
                        </a:cubicBezTo>
                        <a:cubicBezTo>
                          <a:pt x="553892" y="876799"/>
                          <a:pt x="640676" y="842932"/>
                          <a:pt x="632209" y="801657"/>
                        </a:cubicBezTo>
                        <a:cubicBezTo>
                          <a:pt x="623742" y="760382"/>
                          <a:pt x="504151" y="690532"/>
                          <a:pt x="441709" y="655607"/>
                        </a:cubicBezTo>
                        <a:cubicBezTo>
                          <a:pt x="379267" y="620682"/>
                          <a:pt x="257559" y="592107"/>
                          <a:pt x="257559" y="592107"/>
                        </a:cubicBezTo>
                        <a:cubicBezTo>
                          <a:pt x="205701" y="574115"/>
                          <a:pt x="151726" y="579407"/>
                          <a:pt x="130559" y="547657"/>
                        </a:cubicBezTo>
                        <a:cubicBezTo>
                          <a:pt x="109392" y="515907"/>
                          <a:pt x="114684" y="431240"/>
                          <a:pt x="130559" y="401607"/>
                        </a:cubicBezTo>
                        <a:cubicBezTo>
                          <a:pt x="146434" y="371974"/>
                          <a:pt x="171834" y="344457"/>
                          <a:pt x="225809" y="369857"/>
                        </a:cubicBezTo>
                        <a:cubicBezTo>
                          <a:pt x="279784" y="395257"/>
                          <a:pt x="387734" y="510615"/>
                          <a:pt x="454409" y="554007"/>
                        </a:cubicBezTo>
                        <a:cubicBezTo>
                          <a:pt x="521084" y="597399"/>
                          <a:pt x="577176" y="601632"/>
                          <a:pt x="625859" y="630207"/>
                        </a:cubicBezTo>
                        <a:cubicBezTo>
                          <a:pt x="674542" y="658782"/>
                          <a:pt x="710526" y="718049"/>
                          <a:pt x="746509" y="725457"/>
                        </a:cubicBezTo>
                        <a:cubicBezTo>
                          <a:pt x="782492" y="732865"/>
                          <a:pt x="823767" y="736040"/>
                          <a:pt x="841759" y="674657"/>
                        </a:cubicBezTo>
                        <a:cubicBezTo>
                          <a:pt x="859751" y="613274"/>
                          <a:pt x="851284" y="456640"/>
                          <a:pt x="854459" y="357157"/>
                        </a:cubicBezTo>
                        <a:cubicBezTo>
                          <a:pt x="857634" y="257674"/>
                          <a:pt x="851284" y="138082"/>
                          <a:pt x="860809" y="77757"/>
                        </a:cubicBezTo>
                        <a:cubicBezTo>
                          <a:pt x="870334" y="17432"/>
                          <a:pt x="894676" y="10024"/>
                          <a:pt x="937009" y="1557"/>
                        </a:cubicBezTo>
                        <a:close/>
                      </a:path>
                    </a:pathLst>
                  </a:custGeom>
                  <a:solidFill>
                    <a:srgbClr val="F47258"/>
                  </a:solidFill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3" name="Forma libre: forma 173">
                    <a:extLst>
                      <a:ext uri="{FF2B5EF4-FFF2-40B4-BE49-F238E27FC236}">
                        <a16:creationId xmlns:a16="http://schemas.microsoft.com/office/drawing/2014/main" id="{29FE7F9F-4A23-F509-4A9A-B840E2893D84}"/>
                      </a:ext>
                    </a:extLst>
                  </p:cNvPr>
                  <p:cNvSpPr/>
                  <p:nvPr/>
                </p:nvSpPr>
                <p:spPr>
                  <a:xfrm>
                    <a:off x="2397863" y="2818374"/>
                    <a:ext cx="971841" cy="2790765"/>
                  </a:xfrm>
                  <a:custGeom>
                    <a:avLst/>
                    <a:gdLst>
                      <a:gd name="connsiteX0" fmla="*/ 95303 w 971841"/>
                      <a:gd name="connsiteY0" fmla="*/ 629864 h 2790765"/>
                      <a:gd name="connsiteX1" fmla="*/ 241353 w 971841"/>
                      <a:gd name="connsiteY1" fmla="*/ 826714 h 2790765"/>
                      <a:gd name="connsiteX2" fmla="*/ 387403 w 971841"/>
                      <a:gd name="connsiteY2" fmla="*/ 915614 h 2790765"/>
                      <a:gd name="connsiteX3" fmla="*/ 514403 w 971841"/>
                      <a:gd name="connsiteY3" fmla="*/ 934664 h 2790765"/>
                      <a:gd name="connsiteX4" fmla="*/ 622353 w 971841"/>
                      <a:gd name="connsiteY4" fmla="*/ 820364 h 2790765"/>
                      <a:gd name="connsiteX5" fmla="*/ 635053 w 971841"/>
                      <a:gd name="connsiteY5" fmla="*/ 445714 h 2790765"/>
                      <a:gd name="connsiteX6" fmla="*/ 609653 w 971841"/>
                      <a:gd name="connsiteY6" fmla="*/ 20264 h 2790765"/>
                      <a:gd name="connsiteX7" fmla="*/ 743003 w 971841"/>
                      <a:gd name="connsiteY7" fmla="*/ 64714 h 2790765"/>
                      <a:gd name="connsiteX8" fmla="*/ 876353 w 971841"/>
                      <a:gd name="connsiteY8" fmla="*/ 32964 h 2790765"/>
                      <a:gd name="connsiteX9" fmla="*/ 882703 w 971841"/>
                      <a:gd name="connsiteY9" fmla="*/ 83764 h 2790765"/>
                      <a:gd name="connsiteX10" fmla="*/ 863653 w 971841"/>
                      <a:gd name="connsiteY10" fmla="*/ 490164 h 2790765"/>
                      <a:gd name="connsiteX11" fmla="*/ 946203 w 971841"/>
                      <a:gd name="connsiteY11" fmla="*/ 2033214 h 2790765"/>
                      <a:gd name="connsiteX12" fmla="*/ 958903 w 971841"/>
                      <a:gd name="connsiteY12" fmla="*/ 2738064 h 2790765"/>
                      <a:gd name="connsiteX13" fmla="*/ 774753 w 971841"/>
                      <a:gd name="connsiteY13" fmla="*/ 2719014 h 2790765"/>
                      <a:gd name="connsiteX14" fmla="*/ 698553 w 971841"/>
                      <a:gd name="connsiteY14" fmla="*/ 2553914 h 2790765"/>
                      <a:gd name="connsiteX15" fmla="*/ 736653 w 971841"/>
                      <a:gd name="connsiteY15" fmla="*/ 2007814 h 2790765"/>
                      <a:gd name="connsiteX16" fmla="*/ 685853 w 971841"/>
                      <a:gd name="connsiteY16" fmla="*/ 1347414 h 2790765"/>
                      <a:gd name="connsiteX17" fmla="*/ 571553 w 971841"/>
                      <a:gd name="connsiteY17" fmla="*/ 1302964 h 2790765"/>
                      <a:gd name="connsiteX18" fmla="*/ 362003 w 971841"/>
                      <a:gd name="connsiteY18" fmla="*/ 1455364 h 2790765"/>
                      <a:gd name="connsiteX19" fmla="*/ 190553 w 971841"/>
                      <a:gd name="connsiteY19" fmla="*/ 1696664 h 2790765"/>
                      <a:gd name="connsiteX20" fmla="*/ 158803 w 971841"/>
                      <a:gd name="connsiteY20" fmla="*/ 1734764 h 2790765"/>
                      <a:gd name="connsiteX21" fmla="*/ 95303 w 971841"/>
                      <a:gd name="connsiteY21" fmla="*/ 1633164 h 2790765"/>
                      <a:gd name="connsiteX22" fmla="*/ 222303 w 971841"/>
                      <a:gd name="connsiteY22" fmla="*/ 1429964 h 2790765"/>
                      <a:gd name="connsiteX23" fmla="*/ 368353 w 971841"/>
                      <a:gd name="connsiteY23" fmla="*/ 1302964 h 2790765"/>
                      <a:gd name="connsiteX24" fmla="*/ 438203 w 971841"/>
                      <a:gd name="connsiteY24" fmla="*/ 1226764 h 2790765"/>
                      <a:gd name="connsiteX25" fmla="*/ 158803 w 971841"/>
                      <a:gd name="connsiteY25" fmla="*/ 1245814 h 2790765"/>
                      <a:gd name="connsiteX26" fmla="*/ 25453 w 971841"/>
                      <a:gd name="connsiteY26" fmla="*/ 1239464 h 2790765"/>
                      <a:gd name="connsiteX27" fmla="*/ 19103 w 971841"/>
                      <a:gd name="connsiteY27" fmla="*/ 1106114 h 2790765"/>
                      <a:gd name="connsiteX28" fmla="*/ 228653 w 971841"/>
                      <a:gd name="connsiteY28" fmla="*/ 1106114 h 2790765"/>
                      <a:gd name="connsiteX29" fmla="*/ 419153 w 971841"/>
                      <a:gd name="connsiteY29" fmla="*/ 1131514 h 2790765"/>
                      <a:gd name="connsiteX30" fmla="*/ 431853 w 971841"/>
                      <a:gd name="connsiteY30" fmla="*/ 1036264 h 2790765"/>
                      <a:gd name="connsiteX31" fmla="*/ 203253 w 971841"/>
                      <a:gd name="connsiteY31" fmla="*/ 928314 h 2790765"/>
                      <a:gd name="connsiteX32" fmla="*/ 6403 w 971841"/>
                      <a:gd name="connsiteY32" fmla="*/ 845764 h 2790765"/>
                      <a:gd name="connsiteX33" fmla="*/ 95303 w 971841"/>
                      <a:gd name="connsiteY33" fmla="*/ 629864 h 2790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</a:cxnLst>
                    <a:rect l="l" t="t" r="r" b="b"/>
                    <a:pathLst>
                      <a:path w="971841" h="2790765">
                        <a:moveTo>
                          <a:pt x="95303" y="629864"/>
                        </a:moveTo>
                        <a:cubicBezTo>
                          <a:pt x="134461" y="626689"/>
                          <a:pt x="192670" y="779089"/>
                          <a:pt x="241353" y="826714"/>
                        </a:cubicBezTo>
                        <a:cubicBezTo>
                          <a:pt x="290036" y="874339"/>
                          <a:pt x="341895" y="897622"/>
                          <a:pt x="387403" y="915614"/>
                        </a:cubicBezTo>
                        <a:cubicBezTo>
                          <a:pt x="432911" y="933606"/>
                          <a:pt x="475245" y="950539"/>
                          <a:pt x="514403" y="934664"/>
                        </a:cubicBezTo>
                        <a:cubicBezTo>
                          <a:pt x="553561" y="918789"/>
                          <a:pt x="602245" y="901856"/>
                          <a:pt x="622353" y="820364"/>
                        </a:cubicBezTo>
                        <a:cubicBezTo>
                          <a:pt x="642461" y="738872"/>
                          <a:pt x="637170" y="579064"/>
                          <a:pt x="635053" y="445714"/>
                        </a:cubicBezTo>
                        <a:cubicBezTo>
                          <a:pt x="632936" y="312364"/>
                          <a:pt x="591661" y="83764"/>
                          <a:pt x="609653" y="20264"/>
                        </a:cubicBezTo>
                        <a:cubicBezTo>
                          <a:pt x="627645" y="-43236"/>
                          <a:pt x="698553" y="62597"/>
                          <a:pt x="743003" y="64714"/>
                        </a:cubicBezTo>
                        <a:cubicBezTo>
                          <a:pt x="787453" y="66831"/>
                          <a:pt x="853070" y="29789"/>
                          <a:pt x="876353" y="32964"/>
                        </a:cubicBezTo>
                        <a:cubicBezTo>
                          <a:pt x="899636" y="36139"/>
                          <a:pt x="884820" y="7564"/>
                          <a:pt x="882703" y="83764"/>
                        </a:cubicBezTo>
                        <a:cubicBezTo>
                          <a:pt x="880586" y="159964"/>
                          <a:pt x="853070" y="165256"/>
                          <a:pt x="863653" y="490164"/>
                        </a:cubicBezTo>
                        <a:cubicBezTo>
                          <a:pt x="874236" y="815072"/>
                          <a:pt x="930328" y="1658564"/>
                          <a:pt x="946203" y="2033214"/>
                        </a:cubicBezTo>
                        <a:cubicBezTo>
                          <a:pt x="962078" y="2407864"/>
                          <a:pt x="987478" y="2623764"/>
                          <a:pt x="958903" y="2738064"/>
                        </a:cubicBezTo>
                        <a:cubicBezTo>
                          <a:pt x="930328" y="2852364"/>
                          <a:pt x="818145" y="2749706"/>
                          <a:pt x="774753" y="2719014"/>
                        </a:cubicBezTo>
                        <a:cubicBezTo>
                          <a:pt x="731361" y="2688322"/>
                          <a:pt x="704903" y="2672447"/>
                          <a:pt x="698553" y="2553914"/>
                        </a:cubicBezTo>
                        <a:cubicBezTo>
                          <a:pt x="692203" y="2435381"/>
                          <a:pt x="738770" y="2208897"/>
                          <a:pt x="736653" y="2007814"/>
                        </a:cubicBezTo>
                        <a:cubicBezTo>
                          <a:pt x="734536" y="1806731"/>
                          <a:pt x="713370" y="1464889"/>
                          <a:pt x="685853" y="1347414"/>
                        </a:cubicBezTo>
                        <a:cubicBezTo>
                          <a:pt x="658336" y="1229939"/>
                          <a:pt x="625528" y="1284972"/>
                          <a:pt x="571553" y="1302964"/>
                        </a:cubicBezTo>
                        <a:cubicBezTo>
                          <a:pt x="517578" y="1320956"/>
                          <a:pt x="425503" y="1389747"/>
                          <a:pt x="362003" y="1455364"/>
                        </a:cubicBezTo>
                        <a:cubicBezTo>
                          <a:pt x="298503" y="1520981"/>
                          <a:pt x="224420" y="1650098"/>
                          <a:pt x="190553" y="1696664"/>
                        </a:cubicBezTo>
                        <a:cubicBezTo>
                          <a:pt x="156686" y="1743230"/>
                          <a:pt x="174678" y="1745347"/>
                          <a:pt x="158803" y="1734764"/>
                        </a:cubicBezTo>
                        <a:cubicBezTo>
                          <a:pt x="142928" y="1724181"/>
                          <a:pt x="84720" y="1683964"/>
                          <a:pt x="95303" y="1633164"/>
                        </a:cubicBezTo>
                        <a:cubicBezTo>
                          <a:pt x="105886" y="1582364"/>
                          <a:pt x="176795" y="1484997"/>
                          <a:pt x="222303" y="1429964"/>
                        </a:cubicBezTo>
                        <a:cubicBezTo>
                          <a:pt x="267811" y="1374931"/>
                          <a:pt x="332370" y="1336831"/>
                          <a:pt x="368353" y="1302964"/>
                        </a:cubicBezTo>
                        <a:cubicBezTo>
                          <a:pt x="404336" y="1269097"/>
                          <a:pt x="473128" y="1236289"/>
                          <a:pt x="438203" y="1226764"/>
                        </a:cubicBezTo>
                        <a:cubicBezTo>
                          <a:pt x="403278" y="1217239"/>
                          <a:pt x="227595" y="1243697"/>
                          <a:pt x="158803" y="1245814"/>
                        </a:cubicBezTo>
                        <a:cubicBezTo>
                          <a:pt x="90011" y="1247931"/>
                          <a:pt x="48736" y="1262747"/>
                          <a:pt x="25453" y="1239464"/>
                        </a:cubicBezTo>
                        <a:cubicBezTo>
                          <a:pt x="2170" y="1216181"/>
                          <a:pt x="-14764" y="1128339"/>
                          <a:pt x="19103" y="1106114"/>
                        </a:cubicBezTo>
                        <a:cubicBezTo>
                          <a:pt x="52970" y="1083889"/>
                          <a:pt x="161978" y="1101881"/>
                          <a:pt x="228653" y="1106114"/>
                        </a:cubicBezTo>
                        <a:cubicBezTo>
                          <a:pt x="295328" y="1110347"/>
                          <a:pt x="385286" y="1143156"/>
                          <a:pt x="419153" y="1131514"/>
                        </a:cubicBezTo>
                        <a:cubicBezTo>
                          <a:pt x="453020" y="1119872"/>
                          <a:pt x="467836" y="1070131"/>
                          <a:pt x="431853" y="1036264"/>
                        </a:cubicBezTo>
                        <a:cubicBezTo>
                          <a:pt x="395870" y="1002397"/>
                          <a:pt x="274161" y="960064"/>
                          <a:pt x="203253" y="928314"/>
                        </a:cubicBezTo>
                        <a:cubicBezTo>
                          <a:pt x="132345" y="896564"/>
                          <a:pt x="25453" y="892331"/>
                          <a:pt x="6403" y="845764"/>
                        </a:cubicBezTo>
                        <a:cubicBezTo>
                          <a:pt x="-12647" y="799197"/>
                          <a:pt x="56145" y="633039"/>
                          <a:pt x="95303" y="629864"/>
                        </a:cubicBezTo>
                        <a:close/>
                      </a:path>
                    </a:pathLst>
                  </a:custGeom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44" name="Forma libre: forma 174">
                    <a:extLst>
                      <a:ext uri="{FF2B5EF4-FFF2-40B4-BE49-F238E27FC236}">
                        <a16:creationId xmlns:a16="http://schemas.microsoft.com/office/drawing/2014/main" id="{621D8BDB-EF9D-57C1-FB18-5E57FB7FF4A2}"/>
                      </a:ext>
                    </a:extLst>
                  </p:cNvPr>
                  <p:cNvSpPr/>
                  <p:nvPr/>
                </p:nvSpPr>
                <p:spPr>
                  <a:xfrm>
                    <a:off x="810891" y="2321809"/>
                    <a:ext cx="1916526" cy="3347037"/>
                  </a:xfrm>
                  <a:custGeom>
                    <a:avLst/>
                    <a:gdLst>
                      <a:gd name="connsiteX0" fmla="*/ 914400 w 1916526"/>
                      <a:gd name="connsiteY0" fmla="*/ 0 h 3347037"/>
                      <a:gd name="connsiteX1" fmla="*/ 1828800 w 1916526"/>
                      <a:gd name="connsiteY1" fmla="*/ 864454 h 3347037"/>
                      <a:gd name="connsiteX2" fmla="*/ 1738631 w 1916526"/>
                      <a:gd name="connsiteY2" fmla="*/ 1239231 h 3347037"/>
                      <a:gd name="connsiteX3" fmla="*/ 1680293 w 1916526"/>
                      <a:gd name="connsiteY3" fmla="*/ 1335184 h 3347037"/>
                      <a:gd name="connsiteX4" fmla="*/ 1703909 w 1916526"/>
                      <a:gd name="connsiteY4" fmla="*/ 1394010 h 3347037"/>
                      <a:gd name="connsiteX5" fmla="*/ 1741074 w 1916526"/>
                      <a:gd name="connsiteY5" fmla="*/ 1618130 h 3347037"/>
                      <a:gd name="connsiteX6" fmla="*/ 1703909 w 1916526"/>
                      <a:gd name="connsiteY6" fmla="*/ 1842250 h 3347037"/>
                      <a:gd name="connsiteX7" fmla="*/ 1678522 w 1916526"/>
                      <a:gd name="connsiteY7" fmla="*/ 1905487 h 3347037"/>
                      <a:gd name="connsiteX8" fmla="*/ 1760361 w 1916526"/>
                      <a:gd name="connsiteY8" fmla="*/ 1999259 h 3347037"/>
                      <a:gd name="connsiteX9" fmla="*/ 1916526 w 1916526"/>
                      <a:gd name="connsiteY9" fmla="*/ 2482583 h 3347037"/>
                      <a:gd name="connsiteX10" fmla="*/ 1002126 w 1916526"/>
                      <a:gd name="connsiteY10" fmla="*/ 3347037 h 3347037"/>
                      <a:gd name="connsiteX11" fmla="*/ 87726 w 1916526"/>
                      <a:gd name="connsiteY11" fmla="*/ 2482583 h 3347037"/>
                      <a:gd name="connsiteX12" fmla="*/ 95073 w 1916526"/>
                      <a:gd name="connsiteY12" fmla="*/ 2372483 h 3347037"/>
                      <a:gd name="connsiteX13" fmla="*/ 104255 w 1916526"/>
                      <a:gd name="connsiteY13" fmla="*/ 2327114 h 3347037"/>
                      <a:gd name="connsiteX14" fmla="*/ 64964 w 1916526"/>
                      <a:gd name="connsiteY14" fmla="*/ 2261119 h 3347037"/>
                      <a:gd name="connsiteX15" fmla="*/ 0 w 1916526"/>
                      <a:gd name="connsiteY15" fmla="*/ 1967754 h 3347037"/>
                      <a:gd name="connsiteX16" fmla="*/ 16795 w 1916526"/>
                      <a:gd name="connsiteY16" fmla="*/ 1815862 h 3347037"/>
                      <a:gd name="connsiteX17" fmla="*/ 32842 w 1916526"/>
                      <a:gd name="connsiteY17" fmla="*/ 1758966 h 3347037"/>
                      <a:gd name="connsiteX18" fmla="*/ 10325 w 1916526"/>
                      <a:gd name="connsiteY18" fmla="*/ 1673548 h 3347037"/>
                      <a:gd name="connsiteX19" fmla="*/ 0 w 1916526"/>
                      <a:gd name="connsiteY19" fmla="*/ 1554097 h 3347037"/>
                      <a:gd name="connsiteX20" fmla="*/ 16795 w 1916526"/>
                      <a:gd name="connsiteY20" fmla="*/ 1402205 h 3347037"/>
                      <a:gd name="connsiteX21" fmla="*/ 32289 w 1916526"/>
                      <a:gd name="connsiteY21" fmla="*/ 1347269 h 3347037"/>
                      <a:gd name="connsiteX22" fmla="*/ 16795 w 1916526"/>
                      <a:gd name="connsiteY22" fmla="*/ 1292332 h 3347037"/>
                      <a:gd name="connsiteX23" fmla="*/ 0 w 1916526"/>
                      <a:gd name="connsiteY23" fmla="*/ 1140440 h 3347037"/>
                      <a:gd name="connsiteX24" fmla="*/ 4268 w 1916526"/>
                      <a:gd name="connsiteY24" fmla="*/ 1063381 h 3347037"/>
                      <a:gd name="connsiteX25" fmla="*/ 13583 w 1916526"/>
                      <a:gd name="connsiteY25" fmla="*/ 1007735 h 3347037"/>
                      <a:gd name="connsiteX26" fmla="*/ 4721 w 1916526"/>
                      <a:gd name="connsiteY26" fmla="*/ 952840 h 3347037"/>
                      <a:gd name="connsiteX27" fmla="*/ 0 w 1916526"/>
                      <a:gd name="connsiteY27" fmla="*/ 864454 h 3347037"/>
                      <a:gd name="connsiteX28" fmla="*/ 914400 w 1916526"/>
                      <a:gd name="connsiteY28" fmla="*/ 0 h 33470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</a:cxnLst>
                    <a:rect l="l" t="t" r="r" b="b"/>
                    <a:pathLst>
                      <a:path w="1916526" h="3347037">
                        <a:moveTo>
                          <a:pt x="914400" y="0"/>
                        </a:moveTo>
                        <a:cubicBezTo>
                          <a:pt x="1419409" y="0"/>
                          <a:pt x="1828800" y="387029"/>
                          <a:pt x="1828800" y="864454"/>
                        </a:cubicBezTo>
                        <a:cubicBezTo>
                          <a:pt x="1828800" y="998730"/>
                          <a:pt x="1796417" y="1125855"/>
                          <a:pt x="1738631" y="1239231"/>
                        </a:cubicBezTo>
                        <a:lnTo>
                          <a:pt x="1680293" y="1335184"/>
                        </a:lnTo>
                        <a:lnTo>
                          <a:pt x="1703909" y="1394010"/>
                        </a:lnTo>
                        <a:cubicBezTo>
                          <a:pt x="1728062" y="1464809"/>
                          <a:pt x="1741074" y="1540084"/>
                          <a:pt x="1741074" y="1618130"/>
                        </a:cubicBezTo>
                        <a:cubicBezTo>
                          <a:pt x="1741074" y="1696176"/>
                          <a:pt x="1728062" y="1771451"/>
                          <a:pt x="1703909" y="1842250"/>
                        </a:cubicBezTo>
                        <a:lnTo>
                          <a:pt x="1678522" y="1905487"/>
                        </a:lnTo>
                        <a:lnTo>
                          <a:pt x="1760361" y="1999259"/>
                        </a:lnTo>
                        <a:cubicBezTo>
                          <a:pt x="1858956" y="2137226"/>
                          <a:pt x="1916526" y="2303549"/>
                          <a:pt x="1916526" y="2482583"/>
                        </a:cubicBezTo>
                        <a:cubicBezTo>
                          <a:pt x="1916526" y="2960008"/>
                          <a:pt x="1507135" y="3347037"/>
                          <a:pt x="1002126" y="3347037"/>
                        </a:cubicBezTo>
                        <a:cubicBezTo>
                          <a:pt x="497117" y="3347037"/>
                          <a:pt x="87726" y="2960008"/>
                          <a:pt x="87726" y="2482583"/>
                        </a:cubicBezTo>
                        <a:cubicBezTo>
                          <a:pt x="87726" y="2445284"/>
                          <a:pt x="90225" y="2408537"/>
                          <a:pt x="95073" y="2372483"/>
                        </a:cubicBezTo>
                        <a:lnTo>
                          <a:pt x="104255" y="2327114"/>
                        </a:lnTo>
                        <a:lnTo>
                          <a:pt x="64964" y="2261119"/>
                        </a:lnTo>
                        <a:cubicBezTo>
                          <a:pt x="23132" y="2170950"/>
                          <a:pt x="0" y="2071815"/>
                          <a:pt x="0" y="1967754"/>
                        </a:cubicBezTo>
                        <a:cubicBezTo>
                          <a:pt x="0" y="1915724"/>
                          <a:pt x="5783" y="1864925"/>
                          <a:pt x="16795" y="1815862"/>
                        </a:cubicBezTo>
                        <a:lnTo>
                          <a:pt x="32842" y="1758966"/>
                        </a:lnTo>
                        <a:lnTo>
                          <a:pt x="10325" y="1673548"/>
                        </a:lnTo>
                        <a:cubicBezTo>
                          <a:pt x="3530" y="1634643"/>
                          <a:pt x="0" y="1594746"/>
                          <a:pt x="0" y="1554097"/>
                        </a:cubicBezTo>
                        <a:cubicBezTo>
                          <a:pt x="0" y="1502067"/>
                          <a:pt x="5783" y="1451268"/>
                          <a:pt x="16795" y="1402205"/>
                        </a:cubicBezTo>
                        <a:lnTo>
                          <a:pt x="32289" y="1347269"/>
                        </a:lnTo>
                        <a:lnTo>
                          <a:pt x="16795" y="1292332"/>
                        </a:lnTo>
                        <a:cubicBezTo>
                          <a:pt x="5783" y="1243270"/>
                          <a:pt x="0" y="1192471"/>
                          <a:pt x="0" y="1140440"/>
                        </a:cubicBezTo>
                        <a:cubicBezTo>
                          <a:pt x="0" y="1114425"/>
                          <a:pt x="1446" y="1088717"/>
                          <a:pt x="4268" y="1063381"/>
                        </a:cubicBezTo>
                        <a:lnTo>
                          <a:pt x="13583" y="1007735"/>
                        </a:lnTo>
                        <a:lnTo>
                          <a:pt x="4721" y="952840"/>
                        </a:lnTo>
                        <a:cubicBezTo>
                          <a:pt x="1599" y="923779"/>
                          <a:pt x="0" y="894293"/>
                          <a:pt x="0" y="864454"/>
                        </a:cubicBezTo>
                        <a:cubicBezTo>
                          <a:pt x="0" y="387029"/>
                          <a:pt x="409391" y="0"/>
                          <a:pt x="914400" y="0"/>
                        </a:cubicBezTo>
                        <a:close/>
                      </a:path>
                    </a:pathLst>
                  </a:custGeom>
                  <a:solidFill>
                    <a:srgbClr val="D04E46"/>
                  </a:solidFill>
                  <a:ln w="349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wrap="square" rtlCol="0" anchor="ctr">
                    <a:no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37" name="Forma libre: forma 167">
                <a:extLst>
                  <a:ext uri="{FF2B5EF4-FFF2-40B4-BE49-F238E27FC236}">
                    <a16:creationId xmlns:a16="http://schemas.microsoft.com/office/drawing/2014/main" id="{30D50718-5A7E-0F1E-87ED-F359E835B1AA}"/>
                  </a:ext>
                </a:extLst>
              </p:cNvPr>
              <p:cNvSpPr/>
              <p:nvPr/>
            </p:nvSpPr>
            <p:spPr>
              <a:xfrm>
                <a:off x="901744" y="3166209"/>
                <a:ext cx="1056954" cy="842918"/>
              </a:xfrm>
              <a:custGeom>
                <a:avLst/>
                <a:gdLst>
                  <a:gd name="connsiteX0" fmla="*/ 59048 w 1056954"/>
                  <a:gd name="connsiteY0" fmla="*/ 59984 h 842918"/>
                  <a:gd name="connsiteX1" fmla="*/ 8248 w 1056954"/>
                  <a:gd name="connsiteY1" fmla="*/ 193334 h 842918"/>
                  <a:gd name="connsiteX2" fmla="*/ 1898 w 1056954"/>
                  <a:gd name="connsiteY2" fmla="*/ 390184 h 842918"/>
                  <a:gd name="connsiteX3" fmla="*/ 27298 w 1056954"/>
                  <a:gd name="connsiteY3" fmla="*/ 631484 h 842918"/>
                  <a:gd name="connsiteX4" fmla="*/ 78098 w 1056954"/>
                  <a:gd name="connsiteY4" fmla="*/ 828334 h 842918"/>
                  <a:gd name="connsiteX5" fmla="*/ 363848 w 1056954"/>
                  <a:gd name="connsiteY5" fmla="*/ 821984 h 842918"/>
                  <a:gd name="connsiteX6" fmla="*/ 713098 w 1056954"/>
                  <a:gd name="connsiteY6" fmla="*/ 771184 h 842918"/>
                  <a:gd name="connsiteX7" fmla="*/ 941698 w 1056954"/>
                  <a:gd name="connsiteY7" fmla="*/ 631484 h 842918"/>
                  <a:gd name="connsiteX8" fmla="*/ 1049648 w 1056954"/>
                  <a:gd name="connsiteY8" fmla="*/ 453684 h 842918"/>
                  <a:gd name="connsiteX9" fmla="*/ 1017898 w 1056954"/>
                  <a:gd name="connsiteY9" fmla="*/ 206034 h 842918"/>
                  <a:gd name="connsiteX10" fmla="*/ 782948 w 1056954"/>
                  <a:gd name="connsiteY10" fmla="*/ 40934 h 842918"/>
                  <a:gd name="connsiteX11" fmla="*/ 528948 w 1056954"/>
                  <a:gd name="connsiteY11" fmla="*/ 2834 h 842918"/>
                  <a:gd name="connsiteX12" fmla="*/ 141598 w 1056954"/>
                  <a:gd name="connsiteY12" fmla="*/ 9184 h 842918"/>
                  <a:gd name="connsiteX13" fmla="*/ 59048 w 1056954"/>
                  <a:gd name="connsiteY13" fmla="*/ 59984 h 8429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56954" h="842918">
                    <a:moveTo>
                      <a:pt x="59048" y="59984"/>
                    </a:moveTo>
                    <a:cubicBezTo>
                      <a:pt x="36823" y="90676"/>
                      <a:pt x="17773" y="138301"/>
                      <a:pt x="8248" y="193334"/>
                    </a:cubicBezTo>
                    <a:cubicBezTo>
                      <a:pt x="-1277" y="248367"/>
                      <a:pt x="-1277" y="317159"/>
                      <a:pt x="1898" y="390184"/>
                    </a:cubicBezTo>
                    <a:cubicBezTo>
                      <a:pt x="5073" y="463209"/>
                      <a:pt x="14598" y="558459"/>
                      <a:pt x="27298" y="631484"/>
                    </a:cubicBezTo>
                    <a:cubicBezTo>
                      <a:pt x="39998" y="704509"/>
                      <a:pt x="22006" y="796584"/>
                      <a:pt x="78098" y="828334"/>
                    </a:cubicBezTo>
                    <a:cubicBezTo>
                      <a:pt x="134190" y="860084"/>
                      <a:pt x="258015" y="831509"/>
                      <a:pt x="363848" y="821984"/>
                    </a:cubicBezTo>
                    <a:cubicBezTo>
                      <a:pt x="469681" y="812459"/>
                      <a:pt x="616790" y="802934"/>
                      <a:pt x="713098" y="771184"/>
                    </a:cubicBezTo>
                    <a:cubicBezTo>
                      <a:pt x="809406" y="739434"/>
                      <a:pt x="885606" y="684401"/>
                      <a:pt x="941698" y="631484"/>
                    </a:cubicBezTo>
                    <a:cubicBezTo>
                      <a:pt x="997790" y="578567"/>
                      <a:pt x="1036948" y="524592"/>
                      <a:pt x="1049648" y="453684"/>
                    </a:cubicBezTo>
                    <a:cubicBezTo>
                      <a:pt x="1062348" y="382776"/>
                      <a:pt x="1062348" y="274826"/>
                      <a:pt x="1017898" y="206034"/>
                    </a:cubicBezTo>
                    <a:cubicBezTo>
                      <a:pt x="973448" y="137242"/>
                      <a:pt x="864440" y="74801"/>
                      <a:pt x="782948" y="40934"/>
                    </a:cubicBezTo>
                    <a:cubicBezTo>
                      <a:pt x="701456" y="7067"/>
                      <a:pt x="635840" y="8126"/>
                      <a:pt x="528948" y="2834"/>
                    </a:cubicBezTo>
                    <a:cubicBezTo>
                      <a:pt x="422056" y="-2458"/>
                      <a:pt x="220973" y="-341"/>
                      <a:pt x="141598" y="9184"/>
                    </a:cubicBezTo>
                    <a:cubicBezTo>
                      <a:pt x="62223" y="18709"/>
                      <a:pt x="81273" y="29292"/>
                      <a:pt x="59048" y="599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38" name="Forma libre: forma 168">
                <a:extLst>
                  <a:ext uri="{FF2B5EF4-FFF2-40B4-BE49-F238E27FC236}">
                    <a16:creationId xmlns:a16="http://schemas.microsoft.com/office/drawing/2014/main" id="{4015D90A-8AFD-DBAA-E9A0-E37CB9F38FB3}"/>
                  </a:ext>
                </a:extLst>
              </p:cNvPr>
              <p:cNvSpPr/>
              <p:nvPr/>
            </p:nvSpPr>
            <p:spPr>
              <a:xfrm>
                <a:off x="982616" y="3935209"/>
                <a:ext cx="1131010" cy="793354"/>
              </a:xfrm>
              <a:custGeom>
                <a:avLst/>
                <a:gdLst>
                  <a:gd name="connsiteX0" fmla="*/ 9926 w 1131010"/>
                  <a:gd name="connsiteY0" fmla="*/ 256184 h 793354"/>
                  <a:gd name="connsiteX1" fmla="*/ 35326 w 1131010"/>
                  <a:gd name="connsiteY1" fmla="*/ 459384 h 793354"/>
                  <a:gd name="connsiteX2" fmla="*/ 187726 w 1131010"/>
                  <a:gd name="connsiteY2" fmla="*/ 630834 h 793354"/>
                  <a:gd name="connsiteX3" fmla="*/ 384576 w 1131010"/>
                  <a:gd name="connsiteY3" fmla="*/ 770534 h 793354"/>
                  <a:gd name="connsiteX4" fmla="*/ 625876 w 1131010"/>
                  <a:gd name="connsiteY4" fmla="*/ 789584 h 793354"/>
                  <a:gd name="connsiteX5" fmla="*/ 835426 w 1131010"/>
                  <a:gd name="connsiteY5" fmla="*/ 732434 h 793354"/>
                  <a:gd name="connsiteX6" fmla="*/ 1025926 w 1131010"/>
                  <a:gd name="connsiteY6" fmla="*/ 573684 h 793354"/>
                  <a:gd name="connsiteX7" fmla="*/ 1127526 w 1131010"/>
                  <a:gd name="connsiteY7" fmla="*/ 332384 h 793354"/>
                  <a:gd name="connsiteX8" fmla="*/ 1089426 w 1131010"/>
                  <a:gd name="connsiteY8" fmla="*/ 65684 h 793354"/>
                  <a:gd name="connsiteX9" fmla="*/ 917976 w 1131010"/>
                  <a:gd name="connsiteY9" fmla="*/ 2184 h 793354"/>
                  <a:gd name="connsiteX10" fmla="*/ 727476 w 1131010"/>
                  <a:gd name="connsiteY10" fmla="*/ 21234 h 793354"/>
                  <a:gd name="connsiteX11" fmla="*/ 511576 w 1131010"/>
                  <a:gd name="connsiteY11" fmla="*/ 84734 h 793354"/>
                  <a:gd name="connsiteX12" fmla="*/ 327426 w 1131010"/>
                  <a:gd name="connsiteY12" fmla="*/ 116484 h 793354"/>
                  <a:gd name="connsiteX13" fmla="*/ 168676 w 1131010"/>
                  <a:gd name="connsiteY13" fmla="*/ 122834 h 793354"/>
                  <a:gd name="connsiteX14" fmla="*/ 9926 w 1131010"/>
                  <a:gd name="connsiteY14" fmla="*/ 256184 h 793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1131010" h="793354">
                    <a:moveTo>
                      <a:pt x="9926" y="256184"/>
                    </a:moveTo>
                    <a:cubicBezTo>
                      <a:pt x="-12299" y="312276"/>
                      <a:pt x="5693" y="396942"/>
                      <a:pt x="35326" y="459384"/>
                    </a:cubicBezTo>
                    <a:cubicBezTo>
                      <a:pt x="64959" y="521826"/>
                      <a:pt x="129518" y="578976"/>
                      <a:pt x="187726" y="630834"/>
                    </a:cubicBezTo>
                    <a:cubicBezTo>
                      <a:pt x="245934" y="682692"/>
                      <a:pt x="311551" y="744076"/>
                      <a:pt x="384576" y="770534"/>
                    </a:cubicBezTo>
                    <a:cubicBezTo>
                      <a:pt x="457601" y="796992"/>
                      <a:pt x="550734" y="795934"/>
                      <a:pt x="625876" y="789584"/>
                    </a:cubicBezTo>
                    <a:cubicBezTo>
                      <a:pt x="701018" y="783234"/>
                      <a:pt x="768751" y="768417"/>
                      <a:pt x="835426" y="732434"/>
                    </a:cubicBezTo>
                    <a:cubicBezTo>
                      <a:pt x="902101" y="696451"/>
                      <a:pt x="977243" y="640359"/>
                      <a:pt x="1025926" y="573684"/>
                    </a:cubicBezTo>
                    <a:cubicBezTo>
                      <a:pt x="1074609" y="507009"/>
                      <a:pt x="1116943" y="417051"/>
                      <a:pt x="1127526" y="332384"/>
                    </a:cubicBezTo>
                    <a:cubicBezTo>
                      <a:pt x="1138109" y="247717"/>
                      <a:pt x="1124351" y="120717"/>
                      <a:pt x="1089426" y="65684"/>
                    </a:cubicBezTo>
                    <a:cubicBezTo>
                      <a:pt x="1054501" y="10651"/>
                      <a:pt x="978301" y="9592"/>
                      <a:pt x="917976" y="2184"/>
                    </a:cubicBezTo>
                    <a:cubicBezTo>
                      <a:pt x="857651" y="-5224"/>
                      <a:pt x="795209" y="7476"/>
                      <a:pt x="727476" y="21234"/>
                    </a:cubicBezTo>
                    <a:cubicBezTo>
                      <a:pt x="659743" y="34992"/>
                      <a:pt x="578251" y="68859"/>
                      <a:pt x="511576" y="84734"/>
                    </a:cubicBezTo>
                    <a:cubicBezTo>
                      <a:pt x="444901" y="100609"/>
                      <a:pt x="384576" y="110134"/>
                      <a:pt x="327426" y="116484"/>
                    </a:cubicBezTo>
                    <a:cubicBezTo>
                      <a:pt x="270276" y="122834"/>
                      <a:pt x="222651" y="104842"/>
                      <a:pt x="168676" y="122834"/>
                    </a:cubicBezTo>
                    <a:cubicBezTo>
                      <a:pt x="114701" y="140826"/>
                      <a:pt x="32151" y="200092"/>
                      <a:pt x="9926" y="2561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39" name="Forma libre: forma 169">
                <a:extLst>
                  <a:ext uri="{FF2B5EF4-FFF2-40B4-BE49-F238E27FC236}">
                    <a16:creationId xmlns:a16="http://schemas.microsoft.com/office/drawing/2014/main" id="{E3D93585-3F9C-2EFC-E2F2-513ECD42F6C6}"/>
                  </a:ext>
                </a:extLst>
              </p:cNvPr>
              <p:cNvSpPr/>
              <p:nvPr/>
            </p:nvSpPr>
            <p:spPr>
              <a:xfrm>
                <a:off x="909971" y="2424918"/>
                <a:ext cx="1098835" cy="717462"/>
              </a:xfrm>
              <a:custGeom>
                <a:avLst/>
                <a:gdLst>
                  <a:gd name="connsiteX0" fmla="*/ 69871 w 1098835"/>
                  <a:gd name="connsiteY0" fmla="*/ 229775 h 717462"/>
                  <a:gd name="connsiteX1" fmla="*/ 21 w 1098835"/>
                  <a:gd name="connsiteY1" fmla="*/ 394875 h 717462"/>
                  <a:gd name="connsiteX2" fmla="*/ 76221 w 1098835"/>
                  <a:gd name="connsiteY2" fmla="*/ 579025 h 717462"/>
                  <a:gd name="connsiteX3" fmla="*/ 215921 w 1098835"/>
                  <a:gd name="connsiteY3" fmla="*/ 661575 h 717462"/>
                  <a:gd name="connsiteX4" fmla="*/ 533421 w 1098835"/>
                  <a:gd name="connsiteY4" fmla="*/ 648875 h 717462"/>
                  <a:gd name="connsiteX5" fmla="*/ 857271 w 1098835"/>
                  <a:gd name="connsiteY5" fmla="*/ 712375 h 717462"/>
                  <a:gd name="connsiteX6" fmla="*/ 1003321 w 1098835"/>
                  <a:gd name="connsiteY6" fmla="*/ 686975 h 717462"/>
                  <a:gd name="connsiteX7" fmla="*/ 1098571 w 1098835"/>
                  <a:gd name="connsiteY7" fmla="*/ 477425 h 717462"/>
                  <a:gd name="connsiteX8" fmla="*/ 1022371 w 1098835"/>
                  <a:gd name="connsiteY8" fmla="*/ 153575 h 717462"/>
                  <a:gd name="connsiteX9" fmla="*/ 774721 w 1098835"/>
                  <a:gd name="connsiteY9" fmla="*/ 20225 h 717462"/>
                  <a:gd name="connsiteX10" fmla="*/ 571521 w 1098835"/>
                  <a:gd name="connsiteY10" fmla="*/ 1175 h 717462"/>
                  <a:gd name="connsiteX11" fmla="*/ 368321 w 1098835"/>
                  <a:gd name="connsiteY11" fmla="*/ 26575 h 717462"/>
                  <a:gd name="connsiteX12" fmla="*/ 196871 w 1098835"/>
                  <a:gd name="connsiteY12" fmla="*/ 115475 h 717462"/>
                  <a:gd name="connsiteX13" fmla="*/ 69871 w 1098835"/>
                  <a:gd name="connsiteY13" fmla="*/ 229775 h 7174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98835" h="717462">
                    <a:moveTo>
                      <a:pt x="69871" y="229775"/>
                    </a:moveTo>
                    <a:cubicBezTo>
                      <a:pt x="37063" y="276342"/>
                      <a:pt x="-1037" y="336667"/>
                      <a:pt x="21" y="394875"/>
                    </a:cubicBezTo>
                    <a:cubicBezTo>
                      <a:pt x="1079" y="453083"/>
                      <a:pt x="40238" y="534575"/>
                      <a:pt x="76221" y="579025"/>
                    </a:cubicBezTo>
                    <a:cubicBezTo>
                      <a:pt x="112204" y="623475"/>
                      <a:pt x="139721" y="649933"/>
                      <a:pt x="215921" y="661575"/>
                    </a:cubicBezTo>
                    <a:cubicBezTo>
                      <a:pt x="292121" y="673217"/>
                      <a:pt x="426529" y="640408"/>
                      <a:pt x="533421" y="648875"/>
                    </a:cubicBezTo>
                    <a:cubicBezTo>
                      <a:pt x="640313" y="657342"/>
                      <a:pt x="778954" y="706025"/>
                      <a:pt x="857271" y="712375"/>
                    </a:cubicBezTo>
                    <a:cubicBezTo>
                      <a:pt x="935588" y="718725"/>
                      <a:pt x="963104" y="726133"/>
                      <a:pt x="1003321" y="686975"/>
                    </a:cubicBezTo>
                    <a:cubicBezTo>
                      <a:pt x="1043538" y="647817"/>
                      <a:pt x="1095396" y="566325"/>
                      <a:pt x="1098571" y="477425"/>
                    </a:cubicBezTo>
                    <a:cubicBezTo>
                      <a:pt x="1101746" y="388525"/>
                      <a:pt x="1076346" y="229775"/>
                      <a:pt x="1022371" y="153575"/>
                    </a:cubicBezTo>
                    <a:cubicBezTo>
                      <a:pt x="968396" y="77375"/>
                      <a:pt x="849863" y="45625"/>
                      <a:pt x="774721" y="20225"/>
                    </a:cubicBezTo>
                    <a:cubicBezTo>
                      <a:pt x="699579" y="-5175"/>
                      <a:pt x="639254" y="117"/>
                      <a:pt x="571521" y="1175"/>
                    </a:cubicBezTo>
                    <a:cubicBezTo>
                      <a:pt x="503788" y="2233"/>
                      <a:pt x="430763" y="7525"/>
                      <a:pt x="368321" y="26575"/>
                    </a:cubicBezTo>
                    <a:cubicBezTo>
                      <a:pt x="305879" y="45625"/>
                      <a:pt x="243438" y="87958"/>
                      <a:pt x="196871" y="115475"/>
                    </a:cubicBezTo>
                    <a:cubicBezTo>
                      <a:pt x="150304" y="142992"/>
                      <a:pt x="102679" y="183208"/>
                      <a:pt x="69871" y="229775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</p:grpSp>
        <p:grpSp>
          <p:nvGrpSpPr>
            <p:cNvPr id="32" name="Grupo 29">
              <a:extLst>
                <a:ext uri="{FF2B5EF4-FFF2-40B4-BE49-F238E27FC236}">
                  <a16:creationId xmlns:a16="http://schemas.microsoft.com/office/drawing/2014/main" id="{E6342060-E49D-6ED3-FE44-BD732FB0A409}"/>
                </a:ext>
              </a:extLst>
            </p:cNvPr>
            <p:cNvGrpSpPr/>
            <p:nvPr/>
          </p:nvGrpSpPr>
          <p:grpSpPr>
            <a:xfrm>
              <a:off x="123741" y="3953100"/>
              <a:ext cx="1634014" cy="1634014"/>
              <a:chOff x="123741" y="3953100"/>
              <a:chExt cx="1634014" cy="1634014"/>
            </a:xfrm>
          </p:grpSpPr>
          <p:sp>
            <p:nvSpPr>
              <p:cNvPr id="33" name="Elipse 73">
                <a:extLst>
                  <a:ext uri="{FF2B5EF4-FFF2-40B4-BE49-F238E27FC236}">
                    <a16:creationId xmlns:a16="http://schemas.microsoft.com/office/drawing/2014/main" id="{8C6D9FB5-495D-CD20-5216-8A7BBE6D89EF}"/>
                  </a:ext>
                </a:extLst>
              </p:cNvPr>
              <p:cNvSpPr/>
              <p:nvPr/>
            </p:nvSpPr>
            <p:spPr>
              <a:xfrm>
                <a:off x="123741" y="3953100"/>
                <a:ext cx="1634014" cy="1634014"/>
              </a:xfrm>
              <a:prstGeom prst="ellipse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 w="349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34" name="Forma libre: forma 21">
                <a:extLst>
                  <a:ext uri="{FF2B5EF4-FFF2-40B4-BE49-F238E27FC236}">
                    <a16:creationId xmlns:a16="http://schemas.microsoft.com/office/drawing/2014/main" id="{9E40A713-8617-AC80-361D-DB20F757D4A3}"/>
                  </a:ext>
                </a:extLst>
              </p:cNvPr>
              <p:cNvSpPr/>
              <p:nvPr/>
            </p:nvSpPr>
            <p:spPr>
              <a:xfrm>
                <a:off x="527855" y="4325549"/>
                <a:ext cx="1078413" cy="1147252"/>
              </a:xfrm>
              <a:custGeom>
                <a:avLst/>
                <a:gdLst>
                  <a:gd name="connsiteX0" fmla="*/ 725820 w 1078413"/>
                  <a:gd name="connsiteY0" fmla="*/ 1058374 h 1147252"/>
                  <a:gd name="connsiteX1" fmla="*/ 796940 w 1078413"/>
                  <a:gd name="connsiteY1" fmla="*/ 1073614 h 1147252"/>
                  <a:gd name="connsiteX2" fmla="*/ 827420 w 1078413"/>
                  <a:gd name="connsiteY2" fmla="*/ 992334 h 1147252"/>
                  <a:gd name="connsiteX3" fmla="*/ 959500 w 1078413"/>
                  <a:gd name="connsiteY3" fmla="*/ 931374 h 1147252"/>
                  <a:gd name="connsiteX4" fmla="*/ 1020460 w 1078413"/>
                  <a:gd name="connsiteY4" fmla="*/ 799294 h 1147252"/>
                  <a:gd name="connsiteX5" fmla="*/ 1076340 w 1078413"/>
                  <a:gd name="connsiteY5" fmla="*/ 667214 h 1147252"/>
                  <a:gd name="connsiteX6" fmla="*/ 1056020 w 1078413"/>
                  <a:gd name="connsiteY6" fmla="*/ 530054 h 1147252"/>
                  <a:gd name="connsiteX7" fmla="*/ 1076340 w 1078413"/>
                  <a:gd name="connsiteY7" fmla="*/ 377654 h 1147252"/>
                  <a:gd name="connsiteX8" fmla="*/ 995060 w 1078413"/>
                  <a:gd name="connsiteY8" fmla="*/ 199854 h 1147252"/>
                  <a:gd name="connsiteX9" fmla="*/ 959500 w 1078413"/>
                  <a:gd name="connsiteY9" fmla="*/ 11894 h 1147252"/>
                  <a:gd name="connsiteX10" fmla="*/ 893460 w 1078413"/>
                  <a:gd name="connsiteY10" fmla="*/ 42374 h 1147252"/>
                  <a:gd name="connsiteX11" fmla="*/ 796940 w 1078413"/>
                  <a:gd name="connsiteY11" fmla="*/ 230334 h 1147252"/>
                  <a:gd name="connsiteX12" fmla="*/ 685180 w 1078413"/>
                  <a:gd name="connsiteY12" fmla="*/ 331934 h 1147252"/>
                  <a:gd name="connsiteX13" fmla="*/ 598820 w 1078413"/>
                  <a:gd name="connsiteY13" fmla="*/ 337014 h 1147252"/>
                  <a:gd name="connsiteX14" fmla="*/ 537860 w 1078413"/>
                  <a:gd name="connsiteY14" fmla="*/ 458934 h 1147252"/>
                  <a:gd name="connsiteX15" fmla="*/ 426100 w 1078413"/>
                  <a:gd name="connsiteY15" fmla="*/ 606254 h 1147252"/>
                  <a:gd name="connsiteX16" fmla="*/ 167020 w 1078413"/>
                  <a:gd name="connsiteY16" fmla="*/ 662134 h 1147252"/>
                  <a:gd name="connsiteX17" fmla="*/ 126380 w 1078413"/>
                  <a:gd name="connsiteY17" fmla="*/ 758654 h 1147252"/>
                  <a:gd name="connsiteX18" fmla="*/ 9540 w 1078413"/>
                  <a:gd name="connsiteY18" fmla="*/ 916134 h 1147252"/>
                  <a:gd name="connsiteX19" fmla="*/ 24780 w 1078413"/>
                  <a:gd name="connsiteY19" fmla="*/ 1002494 h 1147252"/>
                  <a:gd name="connsiteX20" fmla="*/ 167020 w 1078413"/>
                  <a:gd name="connsiteY20" fmla="*/ 1104094 h 1147252"/>
                  <a:gd name="connsiteX21" fmla="*/ 344820 w 1078413"/>
                  <a:gd name="connsiteY21" fmla="*/ 1083774 h 1147252"/>
                  <a:gd name="connsiteX22" fmla="*/ 441340 w 1078413"/>
                  <a:gd name="connsiteY22" fmla="*/ 1144734 h 1147252"/>
                  <a:gd name="connsiteX23" fmla="*/ 593740 w 1078413"/>
                  <a:gd name="connsiteY23" fmla="*/ 1129494 h 1147252"/>
                  <a:gd name="connsiteX24" fmla="*/ 725820 w 1078413"/>
                  <a:gd name="connsiteY24" fmla="*/ 1058374 h 11472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</a:cxnLst>
                <a:rect l="l" t="t" r="r" b="b"/>
                <a:pathLst>
                  <a:path w="1078413" h="1147252">
                    <a:moveTo>
                      <a:pt x="725820" y="1058374"/>
                    </a:moveTo>
                    <a:cubicBezTo>
                      <a:pt x="759687" y="1049061"/>
                      <a:pt x="780007" y="1084621"/>
                      <a:pt x="796940" y="1073614"/>
                    </a:cubicBezTo>
                    <a:cubicBezTo>
                      <a:pt x="813873" y="1062607"/>
                      <a:pt x="800327" y="1016041"/>
                      <a:pt x="827420" y="992334"/>
                    </a:cubicBezTo>
                    <a:cubicBezTo>
                      <a:pt x="854513" y="968627"/>
                      <a:pt x="927327" y="963547"/>
                      <a:pt x="959500" y="931374"/>
                    </a:cubicBezTo>
                    <a:cubicBezTo>
                      <a:pt x="991673" y="899201"/>
                      <a:pt x="1000987" y="843321"/>
                      <a:pt x="1020460" y="799294"/>
                    </a:cubicBezTo>
                    <a:cubicBezTo>
                      <a:pt x="1039933" y="755267"/>
                      <a:pt x="1070413" y="712087"/>
                      <a:pt x="1076340" y="667214"/>
                    </a:cubicBezTo>
                    <a:cubicBezTo>
                      <a:pt x="1082267" y="622341"/>
                      <a:pt x="1056020" y="578314"/>
                      <a:pt x="1056020" y="530054"/>
                    </a:cubicBezTo>
                    <a:cubicBezTo>
                      <a:pt x="1056020" y="481794"/>
                      <a:pt x="1086500" y="432687"/>
                      <a:pt x="1076340" y="377654"/>
                    </a:cubicBezTo>
                    <a:cubicBezTo>
                      <a:pt x="1066180" y="322621"/>
                      <a:pt x="1014533" y="260814"/>
                      <a:pt x="995060" y="199854"/>
                    </a:cubicBezTo>
                    <a:cubicBezTo>
                      <a:pt x="975587" y="138894"/>
                      <a:pt x="976433" y="38141"/>
                      <a:pt x="959500" y="11894"/>
                    </a:cubicBezTo>
                    <a:cubicBezTo>
                      <a:pt x="942567" y="-14353"/>
                      <a:pt x="920553" y="5967"/>
                      <a:pt x="893460" y="42374"/>
                    </a:cubicBezTo>
                    <a:cubicBezTo>
                      <a:pt x="866367" y="78781"/>
                      <a:pt x="831653" y="182074"/>
                      <a:pt x="796940" y="230334"/>
                    </a:cubicBezTo>
                    <a:cubicBezTo>
                      <a:pt x="762227" y="278594"/>
                      <a:pt x="718200" y="314154"/>
                      <a:pt x="685180" y="331934"/>
                    </a:cubicBezTo>
                    <a:cubicBezTo>
                      <a:pt x="652160" y="349714"/>
                      <a:pt x="623373" y="315847"/>
                      <a:pt x="598820" y="337014"/>
                    </a:cubicBezTo>
                    <a:cubicBezTo>
                      <a:pt x="574267" y="358181"/>
                      <a:pt x="566647" y="414061"/>
                      <a:pt x="537860" y="458934"/>
                    </a:cubicBezTo>
                    <a:cubicBezTo>
                      <a:pt x="509073" y="503807"/>
                      <a:pt x="487907" y="572387"/>
                      <a:pt x="426100" y="606254"/>
                    </a:cubicBezTo>
                    <a:cubicBezTo>
                      <a:pt x="364293" y="640121"/>
                      <a:pt x="216973" y="636734"/>
                      <a:pt x="167020" y="662134"/>
                    </a:cubicBezTo>
                    <a:cubicBezTo>
                      <a:pt x="117067" y="687534"/>
                      <a:pt x="152627" y="716321"/>
                      <a:pt x="126380" y="758654"/>
                    </a:cubicBezTo>
                    <a:cubicBezTo>
                      <a:pt x="100133" y="800987"/>
                      <a:pt x="26473" y="875494"/>
                      <a:pt x="9540" y="916134"/>
                    </a:cubicBezTo>
                    <a:cubicBezTo>
                      <a:pt x="-7393" y="956774"/>
                      <a:pt x="-1467" y="971167"/>
                      <a:pt x="24780" y="1002494"/>
                    </a:cubicBezTo>
                    <a:cubicBezTo>
                      <a:pt x="51027" y="1033821"/>
                      <a:pt x="113680" y="1090547"/>
                      <a:pt x="167020" y="1104094"/>
                    </a:cubicBezTo>
                    <a:cubicBezTo>
                      <a:pt x="220360" y="1117641"/>
                      <a:pt x="299100" y="1077001"/>
                      <a:pt x="344820" y="1083774"/>
                    </a:cubicBezTo>
                    <a:cubicBezTo>
                      <a:pt x="390540" y="1090547"/>
                      <a:pt x="399853" y="1137114"/>
                      <a:pt x="441340" y="1144734"/>
                    </a:cubicBezTo>
                    <a:cubicBezTo>
                      <a:pt x="482827" y="1152354"/>
                      <a:pt x="548867" y="1141347"/>
                      <a:pt x="593740" y="1129494"/>
                    </a:cubicBezTo>
                    <a:cubicBezTo>
                      <a:pt x="638613" y="1117641"/>
                      <a:pt x="691953" y="1067687"/>
                      <a:pt x="725820" y="1058374"/>
                    </a:cubicBezTo>
                    <a:close/>
                  </a:path>
                </a:pathLst>
              </a:cu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35" name="Forma libre: forma 22">
                <a:extLst>
                  <a:ext uri="{FF2B5EF4-FFF2-40B4-BE49-F238E27FC236}">
                    <a16:creationId xmlns:a16="http://schemas.microsoft.com/office/drawing/2014/main" id="{B3090AA6-B04B-90DE-B6C6-9A6173BF7E46}"/>
                  </a:ext>
                </a:extLst>
              </p:cNvPr>
              <p:cNvSpPr/>
              <p:nvPr/>
            </p:nvSpPr>
            <p:spPr>
              <a:xfrm>
                <a:off x="247480" y="4068187"/>
                <a:ext cx="1094283" cy="1145406"/>
              </a:xfrm>
              <a:custGeom>
                <a:avLst/>
                <a:gdLst>
                  <a:gd name="connsiteX0" fmla="*/ 234035 w 1094283"/>
                  <a:gd name="connsiteY0" fmla="*/ 1127776 h 1145406"/>
                  <a:gd name="connsiteX1" fmla="*/ 325475 w 1094283"/>
                  <a:gd name="connsiteY1" fmla="*/ 1000776 h 1145406"/>
                  <a:gd name="connsiteX2" fmla="*/ 366115 w 1094283"/>
                  <a:gd name="connsiteY2" fmla="*/ 878856 h 1145406"/>
                  <a:gd name="connsiteX3" fmla="*/ 513435 w 1094283"/>
                  <a:gd name="connsiteY3" fmla="*/ 838216 h 1145406"/>
                  <a:gd name="connsiteX4" fmla="*/ 665835 w 1094283"/>
                  <a:gd name="connsiteY4" fmla="*/ 812816 h 1145406"/>
                  <a:gd name="connsiteX5" fmla="*/ 757275 w 1094283"/>
                  <a:gd name="connsiteY5" fmla="*/ 706136 h 1145406"/>
                  <a:gd name="connsiteX6" fmla="*/ 782675 w 1094283"/>
                  <a:gd name="connsiteY6" fmla="*/ 563896 h 1145406"/>
                  <a:gd name="connsiteX7" fmla="*/ 838555 w 1094283"/>
                  <a:gd name="connsiteY7" fmla="*/ 497856 h 1145406"/>
                  <a:gd name="connsiteX8" fmla="*/ 985875 w 1094283"/>
                  <a:gd name="connsiteY8" fmla="*/ 508016 h 1145406"/>
                  <a:gd name="connsiteX9" fmla="*/ 1041755 w 1094283"/>
                  <a:gd name="connsiteY9" fmla="*/ 355616 h 1145406"/>
                  <a:gd name="connsiteX10" fmla="*/ 1092555 w 1094283"/>
                  <a:gd name="connsiteY10" fmla="*/ 218456 h 1145406"/>
                  <a:gd name="connsiteX11" fmla="*/ 1072235 w 1094283"/>
                  <a:gd name="connsiteY11" fmla="*/ 86376 h 1145406"/>
                  <a:gd name="connsiteX12" fmla="*/ 975715 w 1094283"/>
                  <a:gd name="connsiteY12" fmla="*/ 86376 h 1145406"/>
                  <a:gd name="connsiteX13" fmla="*/ 869035 w 1094283"/>
                  <a:gd name="connsiteY13" fmla="*/ 50816 h 1145406"/>
                  <a:gd name="connsiteX14" fmla="*/ 767435 w 1094283"/>
                  <a:gd name="connsiteY14" fmla="*/ 16 h 1145406"/>
                  <a:gd name="connsiteX15" fmla="*/ 660755 w 1094283"/>
                  <a:gd name="connsiteY15" fmla="*/ 45736 h 1145406"/>
                  <a:gd name="connsiteX16" fmla="*/ 543915 w 1094283"/>
                  <a:gd name="connsiteY16" fmla="*/ 86376 h 1145406"/>
                  <a:gd name="connsiteX17" fmla="*/ 406755 w 1094283"/>
                  <a:gd name="connsiteY17" fmla="*/ 35576 h 1145406"/>
                  <a:gd name="connsiteX18" fmla="*/ 279755 w 1094283"/>
                  <a:gd name="connsiteY18" fmla="*/ 172736 h 1145406"/>
                  <a:gd name="connsiteX19" fmla="*/ 198475 w 1094283"/>
                  <a:gd name="connsiteY19" fmla="*/ 264176 h 1145406"/>
                  <a:gd name="connsiteX20" fmla="*/ 66395 w 1094283"/>
                  <a:gd name="connsiteY20" fmla="*/ 396256 h 1145406"/>
                  <a:gd name="connsiteX21" fmla="*/ 66395 w 1094283"/>
                  <a:gd name="connsiteY21" fmla="*/ 543576 h 1145406"/>
                  <a:gd name="connsiteX22" fmla="*/ 355 w 1094283"/>
                  <a:gd name="connsiteY22" fmla="*/ 685816 h 1145406"/>
                  <a:gd name="connsiteX23" fmla="*/ 40995 w 1094283"/>
                  <a:gd name="connsiteY23" fmla="*/ 899176 h 1145406"/>
                  <a:gd name="connsiteX24" fmla="*/ 61315 w 1094283"/>
                  <a:gd name="connsiteY24" fmla="*/ 1066816 h 1145406"/>
                  <a:gd name="connsiteX25" fmla="*/ 173075 w 1094283"/>
                  <a:gd name="connsiteY25" fmla="*/ 1137936 h 1145406"/>
                  <a:gd name="connsiteX26" fmla="*/ 234035 w 1094283"/>
                  <a:gd name="connsiteY26" fmla="*/ 1127776 h 114540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</a:cxnLst>
                <a:rect l="l" t="t" r="r" b="b"/>
                <a:pathLst>
                  <a:path w="1094283" h="1145406">
                    <a:moveTo>
                      <a:pt x="234035" y="1127776"/>
                    </a:moveTo>
                    <a:cubicBezTo>
                      <a:pt x="259435" y="1104916"/>
                      <a:pt x="303462" y="1042263"/>
                      <a:pt x="325475" y="1000776"/>
                    </a:cubicBezTo>
                    <a:cubicBezTo>
                      <a:pt x="347488" y="959289"/>
                      <a:pt x="334788" y="905949"/>
                      <a:pt x="366115" y="878856"/>
                    </a:cubicBezTo>
                    <a:cubicBezTo>
                      <a:pt x="397442" y="851763"/>
                      <a:pt x="463482" y="849223"/>
                      <a:pt x="513435" y="838216"/>
                    </a:cubicBezTo>
                    <a:cubicBezTo>
                      <a:pt x="563388" y="827209"/>
                      <a:pt x="625195" y="834829"/>
                      <a:pt x="665835" y="812816"/>
                    </a:cubicBezTo>
                    <a:cubicBezTo>
                      <a:pt x="706475" y="790803"/>
                      <a:pt x="737802" y="747623"/>
                      <a:pt x="757275" y="706136"/>
                    </a:cubicBezTo>
                    <a:cubicBezTo>
                      <a:pt x="776748" y="664649"/>
                      <a:pt x="769128" y="598609"/>
                      <a:pt x="782675" y="563896"/>
                    </a:cubicBezTo>
                    <a:cubicBezTo>
                      <a:pt x="796222" y="529183"/>
                      <a:pt x="804688" y="507169"/>
                      <a:pt x="838555" y="497856"/>
                    </a:cubicBezTo>
                    <a:cubicBezTo>
                      <a:pt x="872422" y="488543"/>
                      <a:pt x="952008" y="531723"/>
                      <a:pt x="985875" y="508016"/>
                    </a:cubicBezTo>
                    <a:cubicBezTo>
                      <a:pt x="1019742" y="484309"/>
                      <a:pt x="1023975" y="403876"/>
                      <a:pt x="1041755" y="355616"/>
                    </a:cubicBezTo>
                    <a:cubicBezTo>
                      <a:pt x="1059535" y="307356"/>
                      <a:pt x="1087475" y="263329"/>
                      <a:pt x="1092555" y="218456"/>
                    </a:cubicBezTo>
                    <a:cubicBezTo>
                      <a:pt x="1097635" y="173583"/>
                      <a:pt x="1091708" y="108389"/>
                      <a:pt x="1072235" y="86376"/>
                    </a:cubicBezTo>
                    <a:cubicBezTo>
                      <a:pt x="1052762" y="64363"/>
                      <a:pt x="1009582" y="92303"/>
                      <a:pt x="975715" y="86376"/>
                    </a:cubicBezTo>
                    <a:cubicBezTo>
                      <a:pt x="941848" y="80449"/>
                      <a:pt x="903748" y="65209"/>
                      <a:pt x="869035" y="50816"/>
                    </a:cubicBezTo>
                    <a:cubicBezTo>
                      <a:pt x="834322" y="36423"/>
                      <a:pt x="802148" y="863"/>
                      <a:pt x="767435" y="16"/>
                    </a:cubicBezTo>
                    <a:cubicBezTo>
                      <a:pt x="732722" y="-831"/>
                      <a:pt x="698008" y="31343"/>
                      <a:pt x="660755" y="45736"/>
                    </a:cubicBezTo>
                    <a:cubicBezTo>
                      <a:pt x="623502" y="60129"/>
                      <a:pt x="586248" y="88069"/>
                      <a:pt x="543915" y="86376"/>
                    </a:cubicBezTo>
                    <a:cubicBezTo>
                      <a:pt x="501582" y="84683"/>
                      <a:pt x="450782" y="21183"/>
                      <a:pt x="406755" y="35576"/>
                    </a:cubicBezTo>
                    <a:cubicBezTo>
                      <a:pt x="362728" y="49969"/>
                      <a:pt x="314468" y="134636"/>
                      <a:pt x="279755" y="172736"/>
                    </a:cubicBezTo>
                    <a:cubicBezTo>
                      <a:pt x="245042" y="210836"/>
                      <a:pt x="234035" y="226923"/>
                      <a:pt x="198475" y="264176"/>
                    </a:cubicBezTo>
                    <a:cubicBezTo>
                      <a:pt x="162915" y="301429"/>
                      <a:pt x="88408" y="349689"/>
                      <a:pt x="66395" y="396256"/>
                    </a:cubicBezTo>
                    <a:cubicBezTo>
                      <a:pt x="44382" y="442823"/>
                      <a:pt x="77402" y="495316"/>
                      <a:pt x="66395" y="543576"/>
                    </a:cubicBezTo>
                    <a:cubicBezTo>
                      <a:pt x="55388" y="591836"/>
                      <a:pt x="4588" y="626549"/>
                      <a:pt x="355" y="685816"/>
                    </a:cubicBezTo>
                    <a:cubicBezTo>
                      <a:pt x="-3878" y="745083"/>
                      <a:pt x="30835" y="835676"/>
                      <a:pt x="40995" y="899176"/>
                    </a:cubicBezTo>
                    <a:cubicBezTo>
                      <a:pt x="51155" y="962676"/>
                      <a:pt x="39302" y="1027023"/>
                      <a:pt x="61315" y="1066816"/>
                    </a:cubicBezTo>
                    <a:cubicBezTo>
                      <a:pt x="83328" y="1106609"/>
                      <a:pt x="141748" y="1127776"/>
                      <a:pt x="173075" y="1137936"/>
                    </a:cubicBezTo>
                    <a:cubicBezTo>
                      <a:pt x="204402" y="1148096"/>
                      <a:pt x="208635" y="1150636"/>
                      <a:pt x="234035" y="1127776"/>
                    </a:cubicBezTo>
                    <a:close/>
                  </a:path>
                </a:pathLst>
              </a:cu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</p:grpSp>
      <p:grpSp>
        <p:nvGrpSpPr>
          <p:cNvPr id="9" name="Grupo 37">
            <a:extLst>
              <a:ext uri="{FF2B5EF4-FFF2-40B4-BE49-F238E27FC236}">
                <a16:creationId xmlns:a16="http://schemas.microsoft.com/office/drawing/2014/main" id="{1042DCD0-A44B-664E-6288-7E7930FF9B8E}"/>
              </a:ext>
            </a:extLst>
          </p:cNvPr>
          <p:cNvGrpSpPr/>
          <p:nvPr/>
        </p:nvGrpSpPr>
        <p:grpSpPr>
          <a:xfrm>
            <a:off x="2077792" y="2255705"/>
            <a:ext cx="1466598" cy="1970416"/>
            <a:chOff x="3314114" y="2274191"/>
            <a:chExt cx="2452067" cy="3360898"/>
          </a:xfrm>
        </p:grpSpPr>
        <p:grpSp>
          <p:nvGrpSpPr>
            <p:cNvPr id="15" name="Grupo 134">
              <a:extLst>
                <a:ext uri="{FF2B5EF4-FFF2-40B4-BE49-F238E27FC236}">
                  <a16:creationId xmlns:a16="http://schemas.microsoft.com/office/drawing/2014/main" id="{5EEC7AB9-87D1-A358-F4DB-AA3B01754C60}"/>
                </a:ext>
              </a:extLst>
            </p:cNvPr>
            <p:cNvGrpSpPr/>
            <p:nvPr/>
          </p:nvGrpSpPr>
          <p:grpSpPr>
            <a:xfrm>
              <a:off x="3716944" y="2274191"/>
              <a:ext cx="2049237" cy="2724101"/>
              <a:chOff x="3716944" y="2274191"/>
              <a:chExt cx="2049237" cy="2724101"/>
            </a:xfrm>
          </p:grpSpPr>
          <p:grpSp>
            <p:nvGrpSpPr>
              <p:cNvPr id="22" name="Grupo 24">
                <a:extLst>
                  <a:ext uri="{FF2B5EF4-FFF2-40B4-BE49-F238E27FC236}">
                    <a16:creationId xmlns:a16="http://schemas.microsoft.com/office/drawing/2014/main" id="{EB5B824C-4DE3-1EDF-5BEB-4C55E0CD3645}"/>
                  </a:ext>
                </a:extLst>
              </p:cNvPr>
              <p:cNvGrpSpPr/>
              <p:nvPr/>
            </p:nvGrpSpPr>
            <p:grpSpPr>
              <a:xfrm>
                <a:off x="3716944" y="2274191"/>
                <a:ext cx="2049237" cy="2724101"/>
                <a:chOff x="3716944" y="2274190"/>
                <a:chExt cx="2735801" cy="3628021"/>
              </a:xfrm>
            </p:grpSpPr>
            <p:sp>
              <p:nvSpPr>
                <p:cNvPr id="26" name="Forma libre: forma 19">
                  <a:extLst>
                    <a:ext uri="{FF2B5EF4-FFF2-40B4-BE49-F238E27FC236}">
                      <a16:creationId xmlns:a16="http://schemas.microsoft.com/office/drawing/2014/main" id="{DA9342AF-0B81-444B-E98A-3B6631660CC4}"/>
                    </a:ext>
                  </a:extLst>
                </p:cNvPr>
                <p:cNvSpPr/>
                <p:nvPr/>
              </p:nvSpPr>
              <p:spPr>
                <a:xfrm>
                  <a:off x="5247928" y="3840370"/>
                  <a:ext cx="625792" cy="2061841"/>
                </a:xfrm>
                <a:custGeom>
                  <a:avLst/>
                  <a:gdLst>
                    <a:gd name="connsiteX0" fmla="*/ 83858 w 625792"/>
                    <a:gd name="connsiteY0" fmla="*/ 3352 h 2061841"/>
                    <a:gd name="connsiteX1" fmla="*/ 382308 w 625792"/>
                    <a:gd name="connsiteY1" fmla="*/ 149402 h 2061841"/>
                    <a:gd name="connsiteX2" fmla="*/ 490258 w 625792"/>
                    <a:gd name="connsiteY2" fmla="*/ 358952 h 2061841"/>
                    <a:gd name="connsiteX3" fmla="*/ 579158 w 625792"/>
                    <a:gd name="connsiteY3" fmla="*/ 720902 h 2061841"/>
                    <a:gd name="connsiteX4" fmla="*/ 572808 w 625792"/>
                    <a:gd name="connsiteY4" fmla="*/ 1209852 h 2061841"/>
                    <a:gd name="connsiteX5" fmla="*/ 623608 w 625792"/>
                    <a:gd name="connsiteY5" fmla="*/ 1800402 h 2061841"/>
                    <a:gd name="connsiteX6" fmla="*/ 598208 w 625792"/>
                    <a:gd name="connsiteY6" fmla="*/ 2029002 h 2061841"/>
                    <a:gd name="connsiteX7" fmla="*/ 439458 w 625792"/>
                    <a:gd name="connsiteY7" fmla="*/ 2041702 h 2061841"/>
                    <a:gd name="connsiteX8" fmla="*/ 433108 w 625792"/>
                    <a:gd name="connsiteY8" fmla="*/ 1851202 h 2061841"/>
                    <a:gd name="connsiteX9" fmla="*/ 433108 w 625792"/>
                    <a:gd name="connsiteY9" fmla="*/ 1292402 h 2061841"/>
                    <a:gd name="connsiteX10" fmla="*/ 401358 w 625792"/>
                    <a:gd name="connsiteY10" fmla="*/ 886002 h 2061841"/>
                    <a:gd name="connsiteX11" fmla="*/ 337858 w 625792"/>
                    <a:gd name="connsiteY11" fmla="*/ 651052 h 2061841"/>
                    <a:gd name="connsiteX12" fmla="*/ 160058 w 625792"/>
                    <a:gd name="connsiteY12" fmla="*/ 657402 h 2061841"/>
                    <a:gd name="connsiteX13" fmla="*/ 77508 w 625792"/>
                    <a:gd name="connsiteY13" fmla="*/ 714552 h 2061841"/>
                    <a:gd name="connsiteX14" fmla="*/ 39408 w 625792"/>
                    <a:gd name="connsiteY14" fmla="*/ 670102 h 2061841"/>
                    <a:gd name="connsiteX15" fmla="*/ 52108 w 625792"/>
                    <a:gd name="connsiteY15" fmla="*/ 498652 h 2061841"/>
                    <a:gd name="connsiteX16" fmla="*/ 52108 w 625792"/>
                    <a:gd name="connsiteY16" fmla="*/ 276402 h 2061841"/>
                    <a:gd name="connsiteX17" fmla="*/ 1308 w 625792"/>
                    <a:gd name="connsiteY17" fmla="*/ 149402 h 2061841"/>
                    <a:gd name="connsiteX18" fmla="*/ 20358 w 625792"/>
                    <a:gd name="connsiteY18" fmla="*/ 54152 h 2061841"/>
                    <a:gd name="connsiteX19" fmla="*/ 83858 w 625792"/>
                    <a:gd name="connsiteY19" fmla="*/ 3352 h 20618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625792" h="2061841">
                      <a:moveTo>
                        <a:pt x="83858" y="3352"/>
                      </a:moveTo>
                      <a:cubicBezTo>
                        <a:pt x="144183" y="19227"/>
                        <a:pt x="314575" y="90135"/>
                        <a:pt x="382308" y="149402"/>
                      </a:cubicBezTo>
                      <a:cubicBezTo>
                        <a:pt x="450041" y="208669"/>
                        <a:pt x="457450" y="263702"/>
                        <a:pt x="490258" y="358952"/>
                      </a:cubicBezTo>
                      <a:cubicBezTo>
                        <a:pt x="523066" y="454202"/>
                        <a:pt x="565400" y="579085"/>
                        <a:pt x="579158" y="720902"/>
                      </a:cubicBezTo>
                      <a:cubicBezTo>
                        <a:pt x="592916" y="862719"/>
                        <a:pt x="565400" y="1029935"/>
                        <a:pt x="572808" y="1209852"/>
                      </a:cubicBezTo>
                      <a:cubicBezTo>
                        <a:pt x="580216" y="1389769"/>
                        <a:pt x="619375" y="1663877"/>
                        <a:pt x="623608" y="1800402"/>
                      </a:cubicBezTo>
                      <a:cubicBezTo>
                        <a:pt x="627841" y="1936927"/>
                        <a:pt x="628900" y="1988785"/>
                        <a:pt x="598208" y="2029002"/>
                      </a:cubicBezTo>
                      <a:cubicBezTo>
                        <a:pt x="567516" y="2069219"/>
                        <a:pt x="466975" y="2071335"/>
                        <a:pt x="439458" y="2041702"/>
                      </a:cubicBezTo>
                      <a:cubicBezTo>
                        <a:pt x="411941" y="2012069"/>
                        <a:pt x="434166" y="1976085"/>
                        <a:pt x="433108" y="1851202"/>
                      </a:cubicBezTo>
                      <a:cubicBezTo>
                        <a:pt x="432050" y="1726319"/>
                        <a:pt x="438400" y="1453269"/>
                        <a:pt x="433108" y="1292402"/>
                      </a:cubicBezTo>
                      <a:cubicBezTo>
                        <a:pt x="427816" y="1131535"/>
                        <a:pt x="417233" y="992894"/>
                        <a:pt x="401358" y="886002"/>
                      </a:cubicBezTo>
                      <a:cubicBezTo>
                        <a:pt x="385483" y="779110"/>
                        <a:pt x="378075" y="689152"/>
                        <a:pt x="337858" y="651052"/>
                      </a:cubicBezTo>
                      <a:cubicBezTo>
                        <a:pt x="297641" y="612952"/>
                        <a:pt x="203450" y="646819"/>
                        <a:pt x="160058" y="657402"/>
                      </a:cubicBezTo>
                      <a:cubicBezTo>
                        <a:pt x="116666" y="667985"/>
                        <a:pt x="97616" y="712435"/>
                        <a:pt x="77508" y="714552"/>
                      </a:cubicBezTo>
                      <a:cubicBezTo>
                        <a:pt x="57400" y="716669"/>
                        <a:pt x="43641" y="706085"/>
                        <a:pt x="39408" y="670102"/>
                      </a:cubicBezTo>
                      <a:cubicBezTo>
                        <a:pt x="35175" y="634119"/>
                        <a:pt x="49991" y="564269"/>
                        <a:pt x="52108" y="498652"/>
                      </a:cubicBezTo>
                      <a:cubicBezTo>
                        <a:pt x="54225" y="433035"/>
                        <a:pt x="60575" y="334610"/>
                        <a:pt x="52108" y="276402"/>
                      </a:cubicBezTo>
                      <a:cubicBezTo>
                        <a:pt x="43641" y="218194"/>
                        <a:pt x="6600" y="186444"/>
                        <a:pt x="1308" y="149402"/>
                      </a:cubicBezTo>
                      <a:cubicBezTo>
                        <a:pt x="-3984" y="112360"/>
                        <a:pt x="7658" y="76377"/>
                        <a:pt x="20358" y="54152"/>
                      </a:cubicBezTo>
                      <a:cubicBezTo>
                        <a:pt x="33058" y="31927"/>
                        <a:pt x="23533" y="-12523"/>
                        <a:pt x="83858" y="3352"/>
                      </a:cubicBezTo>
                      <a:close/>
                    </a:path>
                  </a:pathLst>
                </a:custGeom>
                <a:solidFill>
                  <a:srgbClr val="FECC96"/>
                </a:solidFill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/>
                </a:p>
              </p:txBody>
            </p:sp>
            <p:grpSp>
              <p:nvGrpSpPr>
                <p:cNvPr id="27" name="Grupo 23">
                  <a:extLst>
                    <a:ext uri="{FF2B5EF4-FFF2-40B4-BE49-F238E27FC236}">
                      <a16:creationId xmlns:a16="http://schemas.microsoft.com/office/drawing/2014/main" id="{AEB1A232-B922-0F73-C072-78F70A04F573}"/>
                    </a:ext>
                  </a:extLst>
                </p:cNvPr>
                <p:cNvGrpSpPr/>
                <p:nvPr/>
              </p:nvGrpSpPr>
              <p:grpSpPr>
                <a:xfrm>
                  <a:off x="3716944" y="2274190"/>
                  <a:ext cx="2735801" cy="3347037"/>
                  <a:chOff x="3716944" y="2274190"/>
                  <a:chExt cx="2735801" cy="3347037"/>
                </a:xfrm>
              </p:grpSpPr>
              <p:sp>
                <p:nvSpPr>
                  <p:cNvPr id="28" name="Forma libre: forma 20">
                    <a:extLst>
                      <a:ext uri="{FF2B5EF4-FFF2-40B4-BE49-F238E27FC236}">
                        <a16:creationId xmlns:a16="http://schemas.microsoft.com/office/drawing/2014/main" id="{D27E2980-4EA1-B85A-335E-AEFB054A79B7}"/>
                      </a:ext>
                    </a:extLst>
                  </p:cNvPr>
                  <p:cNvSpPr/>
                  <p:nvPr/>
                </p:nvSpPr>
                <p:spPr>
                  <a:xfrm>
                    <a:off x="5125661" y="2944108"/>
                    <a:ext cx="1327084" cy="2494234"/>
                  </a:xfrm>
                  <a:custGeom>
                    <a:avLst/>
                    <a:gdLst>
                      <a:gd name="connsiteX0" fmla="*/ 937009 w 1327084"/>
                      <a:gd name="connsiteY0" fmla="*/ 1557 h 2494234"/>
                      <a:gd name="connsiteX1" fmla="*/ 1114809 w 1327084"/>
                      <a:gd name="connsiteY1" fmla="*/ 26957 h 2494234"/>
                      <a:gd name="connsiteX2" fmla="*/ 1324359 w 1327084"/>
                      <a:gd name="connsiteY2" fmla="*/ 33307 h 2494234"/>
                      <a:gd name="connsiteX3" fmla="*/ 1235459 w 1327084"/>
                      <a:gd name="connsiteY3" fmla="*/ 280957 h 2494234"/>
                      <a:gd name="connsiteX4" fmla="*/ 1254509 w 1327084"/>
                      <a:gd name="connsiteY4" fmla="*/ 693707 h 2494234"/>
                      <a:gd name="connsiteX5" fmla="*/ 1254509 w 1327084"/>
                      <a:gd name="connsiteY5" fmla="*/ 852457 h 2494234"/>
                      <a:gd name="connsiteX6" fmla="*/ 1254509 w 1327084"/>
                      <a:gd name="connsiteY6" fmla="*/ 2236757 h 2494234"/>
                      <a:gd name="connsiteX7" fmla="*/ 1292609 w 1327084"/>
                      <a:gd name="connsiteY7" fmla="*/ 2459007 h 2494234"/>
                      <a:gd name="connsiteX8" fmla="*/ 1051309 w 1327084"/>
                      <a:gd name="connsiteY8" fmla="*/ 2484407 h 2494234"/>
                      <a:gd name="connsiteX9" fmla="*/ 911609 w 1327084"/>
                      <a:gd name="connsiteY9" fmla="*/ 2363757 h 2494234"/>
                      <a:gd name="connsiteX10" fmla="*/ 917959 w 1327084"/>
                      <a:gd name="connsiteY10" fmla="*/ 1785907 h 2494234"/>
                      <a:gd name="connsiteX11" fmla="*/ 848109 w 1327084"/>
                      <a:gd name="connsiteY11" fmla="*/ 1182657 h 2494234"/>
                      <a:gd name="connsiteX12" fmla="*/ 721109 w 1327084"/>
                      <a:gd name="connsiteY12" fmla="*/ 1277907 h 2494234"/>
                      <a:gd name="connsiteX13" fmla="*/ 251209 w 1327084"/>
                      <a:gd name="connsiteY13" fmla="*/ 1487457 h 2494234"/>
                      <a:gd name="connsiteX14" fmla="*/ 124209 w 1327084"/>
                      <a:gd name="connsiteY14" fmla="*/ 1493807 h 2494234"/>
                      <a:gd name="connsiteX15" fmla="*/ 73409 w 1327084"/>
                      <a:gd name="connsiteY15" fmla="*/ 1398557 h 2494234"/>
                      <a:gd name="connsiteX16" fmla="*/ 321059 w 1327084"/>
                      <a:gd name="connsiteY16" fmla="*/ 1309657 h 2494234"/>
                      <a:gd name="connsiteX17" fmla="*/ 651259 w 1327084"/>
                      <a:gd name="connsiteY17" fmla="*/ 1087407 h 2494234"/>
                      <a:gd name="connsiteX18" fmla="*/ 587759 w 1327084"/>
                      <a:gd name="connsiteY18" fmla="*/ 985807 h 2494234"/>
                      <a:gd name="connsiteX19" fmla="*/ 422659 w 1327084"/>
                      <a:gd name="connsiteY19" fmla="*/ 1087407 h 2494234"/>
                      <a:gd name="connsiteX20" fmla="*/ 244859 w 1327084"/>
                      <a:gd name="connsiteY20" fmla="*/ 1163607 h 2494234"/>
                      <a:gd name="connsiteX21" fmla="*/ 48009 w 1327084"/>
                      <a:gd name="connsiteY21" fmla="*/ 1176307 h 2494234"/>
                      <a:gd name="connsiteX22" fmla="*/ 16259 w 1327084"/>
                      <a:gd name="connsiteY22" fmla="*/ 992157 h 2494234"/>
                      <a:gd name="connsiteX23" fmla="*/ 263909 w 1327084"/>
                      <a:gd name="connsiteY23" fmla="*/ 960407 h 2494234"/>
                      <a:gd name="connsiteX24" fmla="*/ 492509 w 1327084"/>
                      <a:gd name="connsiteY24" fmla="*/ 903257 h 2494234"/>
                      <a:gd name="connsiteX25" fmla="*/ 632209 w 1327084"/>
                      <a:gd name="connsiteY25" fmla="*/ 801657 h 2494234"/>
                      <a:gd name="connsiteX26" fmla="*/ 441709 w 1327084"/>
                      <a:gd name="connsiteY26" fmla="*/ 655607 h 2494234"/>
                      <a:gd name="connsiteX27" fmla="*/ 257559 w 1327084"/>
                      <a:gd name="connsiteY27" fmla="*/ 592107 h 2494234"/>
                      <a:gd name="connsiteX28" fmla="*/ 130559 w 1327084"/>
                      <a:gd name="connsiteY28" fmla="*/ 547657 h 2494234"/>
                      <a:gd name="connsiteX29" fmla="*/ 130559 w 1327084"/>
                      <a:gd name="connsiteY29" fmla="*/ 401607 h 2494234"/>
                      <a:gd name="connsiteX30" fmla="*/ 225809 w 1327084"/>
                      <a:gd name="connsiteY30" fmla="*/ 369857 h 2494234"/>
                      <a:gd name="connsiteX31" fmla="*/ 454409 w 1327084"/>
                      <a:gd name="connsiteY31" fmla="*/ 554007 h 2494234"/>
                      <a:gd name="connsiteX32" fmla="*/ 625859 w 1327084"/>
                      <a:gd name="connsiteY32" fmla="*/ 630207 h 2494234"/>
                      <a:gd name="connsiteX33" fmla="*/ 746509 w 1327084"/>
                      <a:gd name="connsiteY33" fmla="*/ 725457 h 2494234"/>
                      <a:gd name="connsiteX34" fmla="*/ 841759 w 1327084"/>
                      <a:gd name="connsiteY34" fmla="*/ 674657 h 2494234"/>
                      <a:gd name="connsiteX35" fmla="*/ 854459 w 1327084"/>
                      <a:gd name="connsiteY35" fmla="*/ 357157 h 2494234"/>
                      <a:gd name="connsiteX36" fmla="*/ 860809 w 1327084"/>
                      <a:gd name="connsiteY36" fmla="*/ 77757 h 2494234"/>
                      <a:gd name="connsiteX37" fmla="*/ 937009 w 1327084"/>
                      <a:gd name="connsiteY37" fmla="*/ 1557 h 249423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</a:cxnLst>
                    <a:rect l="l" t="t" r="r" b="b"/>
                    <a:pathLst>
                      <a:path w="1327084" h="2494234">
                        <a:moveTo>
                          <a:pt x="937009" y="1557"/>
                        </a:moveTo>
                        <a:cubicBezTo>
                          <a:pt x="979342" y="-6910"/>
                          <a:pt x="1050251" y="21665"/>
                          <a:pt x="1114809" y="26957"/>
                        </a:cubicBezTo>
                        <a:cubicBezTo>
                          <a:pt x="1179367" y="32249"/>
                          <a:pt x="1304251" y="-9026"/>
                          <a:pt x="1324359" y="33307"/>
                        </a:cubicBezTo>
                        <a:cubicBezTo>
                          <a:pt x="1344467" y="75640"/>
                          <a:pt x="1247101" y="170890"/>
                          <a:pt x="1235459" y="280957"/>
                        </a:cubicBezTo>
                        <a:cubicBezTo>
                          <a:pt x="1223817" y="391024"/>
                          <a:pt x="1251334" y="598457"/>
                          <a:pt x="1254509" y="693707"/>
                        </a:cubicBezTo>
                        <a:cubicBezTo>
                          <a:pt x="1257684" y="788957"/>
                          <a:pt x="1254509" y="852457"/>
                          <a:pt x="1254509" y="852457"/>
                        </a:cubicBezTo>
                        <a:cubicBezTo>
                          <a:pt x="1254509" y="1109632"/>
                          <a:pt x="1248159" y="1968999"/>
                          <a:pt x="1254509" y="2236757"/>
                        </a:cubicBezTo>
                        <a:cubicBezTo>
                          <a:pt x="1260859" y="2504515"/>
                          <a:pt x="1326476" y="2417732"/>
                          <a:pt x="1292609" y="2459007"/>
                        </a:cubicBezTo>
                        <a:cubicBezTo>
                          <a:pt x="1258742" y="2500282"/>
                          <a:pt x="1114809" y="2500282"/>
                          <a:pt x="1051309" y="2484407"/>
                        </a:cubicBezTo>
                        <a:cubicBezTo>
                          <a:pt x="987809" y="2468532"/>
                          <a:pt x="933834" y="2480174"/>
                          <a:pt x="911609" y="2363757"/>
                        </a:cubicBezTo>
                        <a:cubicBezTo>
                          <a:pt x="889384" y="2247340"/>
                          <a:pt x="928542" y="1982757"/>
                          <a:pt x="917959" y="1785907"/>
                        </a:cubicBezTo>
                        <a:cubicBezTo>
                          <a:pt x="907376" y="1589057"/>
                          <a:pt x="880917" y="1267324"/>
                          <a:pt x="848109" y="1182657"/>
                        </a:cubicBezTo>
                        <a:cubicBezTo>
                          <a:pt x="815301" y="1097990"/>
                          <a:pt x="820592" y="1227107"/>
                          <a:pt x="721109" y="1277907"/>
                        </a:cubicBezTo>
                        <a:cubicBezTo>
                          <a:pt x="621626" y="1328707"/>
                          <a:pt x="350692" y="1451474"/>
                          <a:pt x="251209" y="1487457"/>
                        </a:cubicBezTo>
                        <a:cubicBezTo>
                          <a:pt x="151726" y="1523440"/>
                          <a:pt x="153842" y="1508624"/>
                          <a:pt x="124209" y="1493807"/>
                        </a:cubicBezTo>
                        <a:cubicBezTo>
                          <a:pt x="94576" y="1478990"/>
                          <a:pt x="40601" y="1429249"/>
                          <a:pt x="73409" y="1398557"/>
                        </a:cubicBezTo>
                        <a:cubicBezTo>
                          <a:pt x="106217" y="1367865"/>
                          <a:pt x="224751" y="1361515"/>
                          <a:pt x="321059" y="1309657"/>
                        </a:cubicBezTo>
                        <a:cubicBezTo>
                          <a:pt x="417367" y="1257799"/>
                          <a:pt x="606809" y="1141382"/>
                          <a:pt x="651259" y="1087407"/>
                        </a:cubicBezTo>
                        <a:cubicBezTo>
                          <a:pt x="695709" y="1033432"/>
                          <a:pt x="625859" y="985807"/>
                          <a:pt x="587759" y="985807"/>
                        </a:cubicBezTo>
                        <a:cubicBezTo>
                          <a:pt x="549659" y="985807"/>
                          <a:pt x="479809" y="1057774"/>
                          <a:pt x="422659" y="1087407"/>
                        </a:cubicBezTo>
                        <a:cubicBezTo>
                          <a:pt x="365509" y="1117040"/>
                          <a:pt x="307301" y="1148790"/>
                          <a:pt x="244859" y="1163607"/>
                        </a:cubicBezTo>
                        <a:cubicBezTo>
                          <a:pt x="182417" y="1178424"/>
                          <a:pt x="86109" y="1204882"/>
                          <a:pt x="48009" y="1176307"/>
                        </a:cubicBezTo>
                        <a:cubicBezTo>
                          <a:pt x="9909" y="1147732"/>
                          <a:pt x="-19724" y="1028140"/>
                          <a:pt x="16259" y="992157"/>
                        </a:cubicBezTo>
                        <a:cubicBezTo>
                          <a:pt x="52242" y="956174"/>
                          <a:pt x="184534" y="975224"/>
                          <a:pt x="263909" y="960407"/>
                        </a:cubicBezTo>
                        <a:cubicBezTo>
                          <a:pt x="343284" y="945590"/>
                          <a:pt x="431126" y="929715"/>
                          <a:pt x="492509" y="903257"/>
                        </a:cubicBezTo>
                        <a:cubicBezTo>
                          <a:pt x="553892" y="876799"/>
                          <a:pt x="640676" y="842932"/>
                          <a:pt x="632209" y="801657"/>
                        </a:cubicBezTo>
                        <a:cubicBezTo>
                          <a:pt x="623742" y="760382"/>
                          <a:pt x="504151" y="690532"/>
                          <a:pt x="441709" y="655607"/>
                        </a:cubicBezTo>
                        <a:cubicBezTo>
                          <a:pt x="379267" y="620682"/>
                          <a:pt x="257559" y="592107"/>
                          <a:pt x="257559" y="592107"/>
                        </a:cubicBezTo>
                        <a:cubicBezTo>
                          <a:pt x="205701" y="574115"/>
                          <a:pt x="151726" y="579407"/>
                          <a:pt x="130559" y="547657"/>
                        </a:cubicBezTo>
                        <a:cubicBezTo>
                          <a:pt x="109392" y="515907"/>
                          <a:pt x="114684" y="431240"/>
                          <a:pt x="130559" y="401607"/>
                        </a:cubicBezTo>
                        <a:cubicBezTo>
                          <a:pt x="146434" y="371974"/>
                          <a:pt x="171834" y="344457"/>
                          <a:pt x="225809" y="369857"/>
                        </a:cubicBezTo>
                        <a:cubicBezTo>
                          <a:pt x="279784" y="395257"/>
                          <a:pt x="387734" y="510615"/>
                          <a:pt x="454409" y="554007"/>
                        </a:cubicBezTo>
                        <a:cubicBezTo>
                          <a:pt x="521084" y="597399"/>
                          <a:pt x="577176" y="601632"/>
                          <a:pt x="625859" y="630207"/>
                        </a:cubicBezTo>
                        <a:cubicBezTo>
                          <a:pt x="674542" y="658782"/>
                          <a:pt x="710526" y="718049"/>
                          <a:pt x="746509" y="725457"/>
                        </a:cubicBezTo>
                        <a:cubicBezTo>
                          <a:pt x="782492" y="732865"/>
                          <a:pt x="823767" y="736040"/>
                          <a:pt x="841759" y="674657"/>
                        </a:cubicBezTo>
                        <a:cubicBezTo>
                          <a:pt x="859751" y="613274"/>
                          <a:pt x="851284" y="456640"/>
                          <a:pt x="854459" y="357157"/>
                        </a:cubicBezTo>
                        <a:cubicBezTo>
                          <a:pt x="857634" y="257674"/>
                          <a:pt x="851284" y="138082"/>
                          <a:pt x="860809" y="77757"/>
                        </a:cubicBezTo>
                        <a:cubicBezTo>
                          <a:pt x="870334" y="17432"/>
                          <a:pt x="894676" y="10024"/>
                          <a:pt x="937009" y="1557"/>
                        </a:cubicBezTo>
                        <a:close/>
                      </a:path>
                    </a:pathLst>
                  </a:custGeom>
                  <a:solidFill>
                    <a:srgbClr val="F47258"/>
                  </a:solidFill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  <p:sp>
                <p:nvSpPr>
                  <p:cNvPr id="29" name="Forma libre: forma 18">
                    <a:extLst>
                      <a:ext uri="{FF2B5EF4-FFF2-40B4-BE49-F238E27FC236}">
                        <a16:creationId xmlns:a16="http://schemas.microsoft.com/office/drawing/2014/main" id="{7671C11A-8744-2A48-8791-FEFC60DD7C7A}"/>
                      </a:ext>
                    </a:extLst>
                  </p:cNvPr>
                  <p:cNvSpPr/>
                  <p:nvPr/>
                </p:nvSpPr>
                <p:spPr>
                  <a:xfrm>
                    <a:off x="5303916" y="2770755"/>
                    <a:ext cx="971841" cy="2790765"/>
                  </a:xfrm>
                  <a:custGeom>
                    <a:avLst/>
                    <a:gdLst>
                      <a:gd name="connsiteX0" fmla="*/ 95303 w 971841"/>
                      <a:gd name="connsiteY0" fmla="*/ 629864 h 2790765"/>
                      <a:gd name="connsiteX1" fmla="*/ 241353 w 971841"/>
                      <a:gd name="connsiteY1" fmla="*/ 826714 h 2790765"/>
                      <a:gd name="connsiteX2" fmla="*/ 387403 w 971841"/>
                      <a:gd name="connsiteY2" fmla="*/ 915614 h 2790765"/>
                      <a:gd name="connsiteX3" fmla="*/ 514403 w 971841"/>
                      <a:gd name="connsiteY3" fmla="*/ 934664 h 2790765"/>
                      <a:gd name="connsiteX4" fmla="*/ 622353 w 971841"/>
                      <a:gd name="connsiteY4" fmla="*/ 820364 h 2790765"/>
                      <a:gd name="connsiteX5" fmla="*/ 635053 w 971841"/>
                      <a:gd name="connsiteY5" fmla="*/ 445714 h 2790765"/>
                      <a:gd name="connsiteX6" fmla="*/ 609653 w 971841"/>
                      <a:gd name="connsiteY6" fmla="*/ 20264 h 2790765"/>
                      <a:gd name="connsiteX7" fmla="*/ 743003 w 971841"/>
                      <a:gd name="connsiteY7" fmla="*/ 64714 h 2790765"/>
                      <a:gd name="connsiteX8" fmla="*/ 876353 w 971841"/>
                      <a:gd name="connsiteY8" fmla="*/ 32964 h 2790765"/>
                      <a:gd name="connsiteX9" fmla="*/ 882703 w 971841"/>
                      <a:gd name="connsiteY9" fmla="*/ 83764 h 2790765"/>
                      <a:gd name="connsiteX10" fmla="*/ 863653 w 971841"/>
                      <a:gd name="connsiteY10" fmla="*/ 490164 h 2790765"/>
                      <a:gd name="connsiteX11" fmla="*/ 946203 w 971841"/>
                      <a:gd name="connsiteY11" fmla="*/ 2033214 h 2790765"/>
                      <a:gd name="connsiteX12" fmla="*/ 958903 w 971841"/>
                      <a:gd name="connsiteY12" fmla="*/ 2738064 h 2790765"/>
                      <a:gd name="connsiteX13" fmla="*/ 774753 w 971841"/>
                      <a:gd name="connsiteY13" fmla="*/ 2719014 h 2790765"/>
                      <a:gd name="connsiteX14" fmla="*/ 698553 w 971841"/>
                      <a:gd name="connsiteY14" fmla="*/ 2553914 h 2790765"/>
                      <a:gd name="connsiteX15" fmla="*/ 736653 w 971841"/>
                      <a:gd name="connsiteY15" fmla="*/ 2007814 h 2790765"/>
                      <a:gd name="connsiteX16" fmla="*/ 685853 w 971841"/>
                      <a:gd name="connsiteY16" fmla="*/ 1347414 h 2790765"/>
                      <a:gd name="connsiteX17" fmla="*/ 571553 w 971841"/>
                      <a:gd name="connsiteY17" fmla="*/ 1302964 h 2790765"/>
                      <a:gd name="connsiteX18" fmla="*/ 362003 w 971841"/>
                      <a:gd name="connsiteY18" fmla="*/ 1455364 h 2790765"/>
                      <a:gd name="connsiteX19" fmla="*/ 190553 w 971841"/>
                      <a:gd name="connsiteY19" fmla="*/ 1696664 h 2790765"/>
                      <a:gd name="connsiteX20" fmla="*/ 158803 w 971841"/>
                      <a:gd name="connsiteY20" fmla="*/ 1734764 h 2790765"/>
                      <a:gd name="connsiteX21" fmla="*/ 95303 w 971841"/>
                      <a:gd name="connsiteY21" fmla="*/ 1633164 h 2790765"/>
                      <a:gd name="connsiteX22" fmla="*/ 222303 w 971841"/>
                      <a:gd name="connsiteY22" fmla="*/ 1429964 h 2790765"/>
                      <a:gd name="connsiteX23" fmla="*/ 368353 w 971841"/>
                      <a:gd name="connsiteY23" fmla="*/ 1302964 h 2790765"/>
                      <a:gd name="connsiteX24" fmla="*/ 438203 w 971841"/>
                      <a:gd name="connsiteY24" fmla="*/ 1226764 h 2790765"/>
                      <a:gd name="connsiteX25" fmla="*/ 158803 w 971841"/>
                      <a:gd name="connsiteY25" fmla="*/ 1245814 h 2790765"/>
                      <a:gd name="connsiteX26" fmla="*/ 25453 w 971841"/>
                      <a:gd name="connsiteY26" fmla="*/ 1239464 h 2790765"/>
                      <a:gd name="connsiteX27" fmla="*/ 19103 w 971841"/>
                      <a:gd name="connsiteY27" fmla="*/ 1106114 h 2790765"/>
                      <a:gd name="connsiteX28" fmla="*/ 228653 w 971841"/>
                      <a:gd name="connsiteY28" fmla="*/ 1106114 h 2790765"/>
                      <a:gd name="connsiteX29" fmla="*/ 419153 w 971841"/>
                      <a:gd name="connsiteY29" fmla="*/ 1131514 h 2790765"/>
                      <a:gd name="connsiteX30" fmla="*/ 431853 w 971841"/>
                      <a:gd name="connsiteY30" fmla="*/ 1036264 h 2790765"/>
                      <a:gd name="connsiteX31" fmla="*/ 203253 w 971841"/>
                      <a:gd name="connsiteY31" fmla="*/ 928314 h 2790765"/>
                      <a:gd name="connsiteX32" fmla="*/ 6403 w 971841"/>
                      <a:gd name="connsiteY32" fmla="*/ 845764 h 2790765"/>
                      <a:gd name="connsiteX33" fmla="*/ 95303 w 971841"/>
                      <a:gd name="connsiteY33" fmla="*/ 629864 h 2790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</a:cxnLst>
                    <a:rect l="l" t="t" r="r" b="b"/>
                    <a:pathLst>
                      <a:path w="971841" h="2790765">
                        <a:moveTo>
                          <a:pt x="95303" y="629864"/>
                        </a:moveTo>
                        <a:cubicBezTo>
                          <a:pt x="134461" y="626689"/>
                          <a:pt x="192670" y="779089"/>
                          <a:pt x="241353" y="826714"/>
                        </a:cubicBezTo>
                        <a:cubicBezTo>
                          <a:pt x="290036" y="874339"/>
                          <a:pt x="341895" y="897622"/>
                          <a:pt x="387403" y="915614"/>
                        </a:cubicBezTo>
                        <a:cubicBezTo>
                          <a:pt x="432911" y="933606"/>
                          <a:pt x="475245" y="950539"/>
                          <a:pt x="514403" y="934664"/>
                        </a:cubicBezTo>
                        <a:cubicBezTo>
                          <a:pt x="553561" y="918789"/>
                          <a:pt x="602245" y="901856"/>
                          <a:pt x="622353" y="820364"/>
                        </a:cubicBezTo>
                        <a:cubicBezTo>
                          <a:pt x="642461" y="738872"/>
                          <a:pt x="637170" y="579064"/>
                          <a:pt x="635053" y="445714"/>
                        </a:cubicBezTo>
                        <a:cubicBezTo>
                          <a:pt x="632936" y="312364"/>
                          <a:pt x="591661" y="83764"/>
                          <a:pt x="609653" y="20264"/>
                        </a:cubicBezTo>
                        <a:cubicBezTo>
                          <a:pt x="627645" y="-43236"/>
                          <a:pt x="698553" y="62597"/>
                          <a:pt x="743003" y="64714"/>
                        </a:cubicBezTo>
                        <a:cubicBezTo>
                          <a:pt x="787453" y="66831"/>
                          <a:pt x="853070" y="29789"/>
                          <a:pt x="876353" y="32964"/>
                        </a:cubicBezTo>
                        <a:cubicBezTo>
                          <a:pt x="899636" y="36139"/>
                          <a:pt x="884820" y="7564"/>
                          <a:pt x="882703" y="83764"/>
                        </a:cubicBezTo>
                        <a:cubicBezTo>
                          <a:pt x="880586" y="159964"/>
                          <a:pt x="853070" y="165256"/>
                          <a:pt x="863653" y="490164"/>
                        </a:cubicBezTo>
                        <a:cubicBezTo>
                          <a:pt x="874236" y="815072"/>
                          <a:pt x="930328" y="1658564"/>
                          <a:pt x="946203" y="2033214"/>
                        </a:cubicBezTo>
                        <a:cubicBezTo>
                          <a:pt x="962078" y="2407864"/>
                          <a:pt x="987478" y="2623764"/>
                          <a:pt x="958903" y="2738064"/>
                        </a:cubicBezTo>
                        <a:cubicBezTo>
                          <a:pt x="930328" y="2852364"/>
                          <a:pt x="818145" y="2749706"/>
                          <a:pt x="774753" y="2719014"/>
                        </a:cubicBezTo>
                        <a:cubicBezTo>
                          <a:pt x="731361" y="2688322"/>
                          <a:pt x="704903" y="2672447"/>
                          <a:pt x="698553" y="2553914"/>
                        </a:cubicBezTo>
                        <a:cubicBezTo>
                          <a:pt x="692203" y="2435381"/>
                          <a:pt x="738770" y="2208897"/>
                          <a:pt x="736653" y="2007814"/>
                        </a:cubicBezTo>
                        <a:cubicBezTo>
                          <a:pt x="734536" y="1806731"/>
                          <a:pt x="713370" y="1464889"/>
                          <a:pt x="685853" y="1347414"/>
                        </a:cubicBezTo>
                        <a:cubicBezTo>
                          <a:pt x="658336" y="1229939"/>
                          <a:pt x="625528" y="1284972"/>
                          <a:pt x="571553" y="1302964"/>
                        </a:cubicBezTo>
                        <a:cubicBezTo>
                          <a:pt x="517578" y="1320956"/>
                          <a:pt x="425503" y="1389747"/>
                          <a:pt x="362003" y="1455364"/>
                        </a:cubicBezTo>
                        <a:cubicBezTo>
                          <a:pt x="298503" y="1520981"/>
                          <a:pt x="224420" y="1650098"/>
                          <a:pt x="190553" y="1696664"/>
                        </a:cubicBezTo>
                        <a:cubicBezTo>
                          <a:pt x="156686" y="1743230"/>
                          <a:pt x="174678" y="1745347"/>
                          <a:pt x="158803" y="1734764"/>
                        </a:cubicBezTo>
                        <a:cubicBezTo>
                          <a:pt x="142928" y="1724181"/>
                          <a:pt x="84720" y="1683964"/>
                          <a:pt x="95303" y="1633164"/>
                        </a:cubicBezTo>
                        <a:cubicBezTo>
                          <a:pt x="105886" y="1582364"/>
                          <a:pt x="176795" y="1484997"/>
                          <a:pt x="222303" y="1429964"/>
                        </a:cubicBezTo>
                        <a:cubicBezTo>
                          <a:pt x="267811" y="1374931"/>
                          <a:pt x="332370" y="1336831"/>
                          <a:pt x="368353" y="1302964"/>
                        </a:cubicBezTo>
                        <a:cubicBezTo>
                          <a:pt x="404336" y="1269097"/>
                          <a:pt x="473128" y="1236289"/>
                          <a:pt x="438203" y="1226764"/>
                        </a:cubicBezTo>
                        <a:cubicBezTo>
                          <a:pt x="403278" y="1217239"/>
                          <a:pt x="227595" y="1243697"/>
                          <a:pt x="158803" y="1245814"/>
                        </a:cubicBezTo>
                        <a:cubicBezTo>
                          <a:pt x="90011" y="1247931"/>
                          <a:pt x="48736" y="1262747"/>
                          <a:pt x="25453" y="1239464"/>
                        </a:cubicBezTo>
                        <a:cubicBezTo>
                          <a:pt x="2170" y="1216181"/>
                          <a:pt x="-14764" y="1128339"/>
                          <a:pt x="19103" y="1106114"/>
                        </a:cubicBezTo>
                        <a:cubicBezTo>
                          <a:pt x="52970" y="1083889"/>
                          <a:pt x="161978" y="1101881"/>
                          <a:pt x="228653" y="1106114"/>
                        </a:cubicBezTo>
                        <a:cubicBezTo>
                          <a:pt x="295328" y="1110347"/>
                          <a:pt x="385286" y="1143156"/>
                          <a:pt x="419153" y="1131514"/>
                        </a:cubicBezTo>
                        <a:cubicBezTo>
                          <a:pt x="453020" y="1119872"/>
                          <a:pt x="467836" y="1070131"/>
                          <a:pt x="431853" y="1036264"/>
                        </a:cubicBezTo>
                        <a:cubicBezTo>
                          <a:pt x="395870" y="1002397"/>
                          <a:pt x="274161" y="960064"/>
                          <a:pt x="203253" y="928314"/>
                        </a:cubicBezTo>
                        <a:cubicBezTo>
                          <a:pt x="132345" y="896564"/>
                          <a:pt x="25453" y="892331"/>
                          <a:pt x="6403" y="845764"/>
                        </a:cubicBezTo>
                        <a:cubicBezTo>
                          <a:pt x="-12647" y="799197"/>
                          <a:pt x="56145" y="633039"/>
                          <a:pt x="95303" y="629864"/>
                        </a:cubicBezTo>
                        <a:close/>
                      </a:path>
                    </a:pathLst>
                  </a:custGeom>
                  <a:ln w="222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/>
                  </a:p>
                </p:txBody>
              </p:sp>
              <p:sp>
                <p:nvSpPr>
                  <p:cNvPr id="30" name="Forma libre: forma 9">
                    <a:extLst>
                      <a:ext uri="{FF2B5EF4-FFF2-40B4-BE49-F238E27FC236}">
                        <a16:creationId xmlns:a16="http://schemas.microsoft.com/office/drawing/2014/main" id="{EE4CA176-C8F0-D193-EF74-C78D836A83B4}"/>
                      </a:ext>
                    </a:extLst>
                  </p:cNvPr>
                  <p:cNvSpPr/>
                  <p:nvPr/>
                </p:nvSpPr>
                <p:spPr>
                  <a:xfrm>
                    <a:off x="3716944" y="2274190"/>
                    <a:ext cx="1916526" cy="3347037"/>
                  </a:xfrm>
                  <a:custGeom>
                    <a:avLst/>
                    <a:gdLst>
                      <a:gd name="connsiteX0" fmla="*/ 914400 w 1916526"/>
                      <a:gd name="connsiteY0" fmla="*/ 0 h 3347037"/>
                      <a:gd name="connsiteX1" fmla="*/ 1828800 w 1916526"/>
                      <a:gd name="connsiteY1" fmla="*/ 864454 h 3347037"/>
                      <a:gd name="connsiteX2" fmla="*/ 1738631 w 1916526"/>
                      <a:gd name="connsiteY2" fmla="*/ 1239231 h 3347037"/>
                      <a:gd name="connsiteX3" fmla="*/ 1680293 w 1916526"/>
                      <a:gd name="connsiteY3" fmla="*/ 1335184 h 3347037"/>
                      <a:gd name="connsiteX4" fmla="*/ 1703909 w 1916526"/>
                      <a:gd name="connsiteY4" fmla="*/ 1394010 h 3347037"/>
                      <a:gd name="connsiteX5" fmla="*/ 1741074 w 1916526"/>
                      <a:gd name="connsiteY5" fmla="*/ 1618130 h 3347037"/>
                      <a:gd name="connsiteX6" fmla="*/ 1703909 w 1916526"/>
                      <a:gd name="connsiteY6" fmla="*/ 1842250 h 3347037"/>
                      <a:gd name="connsiteX7" fmla="*/ 1678522 w 1916526"/>
                      <a:gd name="connsiteY7" fmla="*/ 1905487 h 3347037"/>
                      <a:gd name="connsiteX8" fmla="*/ 1760361 w 1916526"/>
                      <a:gd name="connsiteY8" fmla="*/ 1999259 h 3347037"/>
                      <a:gd name="connsiteX9" fmla="*/ 1916526 w 1916526"/>
                      <a:gd name="connsiteY9" fmla="*/ 2482583 h 3347037"/>
                      <a:gd name="connsiteX10" fmla="*/ 1002126 w 1916526"/>
                      <a:gd name="connsiteY10" fmla="*/ 3347037 h 3347037"/>
                      <a:gd name="connsiteX11" fmla="*/ 87726 w 1916526"/>
                      <a:gd name="connsiteY11" fmla="*/ 2482583 h 3347037"/>
                      <a:gd name="connsiteX12" fmla="*/ 95073 w 1916526"/>
                      <a:gd name="connsiteY12" fmla="*/ 2372483 h 3347037"/>
                      <a:gd name="connsiteX13" fmla="*/ 104255 w 1916526"/>
                      <a:gd name="connsiteY13" fmla="*/ 2327114 h 3347037"/>
                      <a:gd name="connsiteX14" fmla="*/ 64964 w 1916526"/>
                      <a:gd name="connsiteY14" fmla="*/ 2261119 h 3347037"/>
                      <a:gd name="connsiteX15" fmla="*/ 0 w 1916526"/>
                      <a:gd name="connsiteY15" fmla="*/ 1967754 h 3347037"/>
                      <a:gd name="connsiteX16" fmla="*/ 16795 w 1916526"/>
                      <a:gd name="connsiteY16" fmla="*/ 1815862 h 3347037"/>
                      <a:gd name="connsiteX17" fmla="*/ 32842 w 1916526"/>
                      <a:gd name="connsiteY17" fmla="*/ 1758966 h 3347037"/>
                      <a:gd name="connsiteX18" fmla="*/ 10325 w 1916526"/>
                      <a:gd name="connsiteY18" fmla="*/ 1673548 h 3347037"/>
                      <a:gd name="connsiteX19" fmla="*/ 0 w 1916526"/>
                      <a:gd name="connsiteY19" fmla="*/ 1554097 h 3347037"/>
                      <a:gd name="connsiteX20" fmla="*/ 16795 w 1916526"/>
                      <a:gd name="connsiteY20" fmla="*/ 1402205 h 3347037"/>
                      <a:gd name="connsiteX21" fmla="*/ 32289 w 1916526"/>
                      <a:gd name="connsiteY21" fmla="*/ 1347269 h 3347037"/>
                      <a:gd name="connsiteX22" fmla="*/ 16795 w 1916526"/>
                      <a:gd name="connsiteY22" fmla="*/ 1292332 h 3347037"/>
                      <a:gd name="connsiteX23" fmla="*/ 0 w 1916526"/>
                      <a:gd name="connsiteY23" fmla="*/ 1140440 h 3347037"/>
                      <a:gd name="connsiteX24" fmla="*/ 4268 w 1916526"/>
                      <a:gd name="connsiteY24" fmla="*/ 1063381 h 3347037"/>
                      <a:gd name="connsiteX25" fmla="*/ 13583 w 1916526"/>
                      <a:gd name="connsiteY25" fmla="*/ 1007735 h 3347037"/>
                      <a:gd name="connsiteX26" fmla="*/ 4721 w 1916526"/>
                      <a:gd name="connsiteY26" fmla="*/ 952840 h 3347037"/>
                      <a:gd name="connsiteX27" fmla="*/ 0 w 1916526"/>
                      <a:gd name="connsiteY27" fmla="*/ 864454 h 3347037"/>
                      <a:gd name="connsiteX28" fmla="*/ 914400 w 1916526"/>
                      <a:gd name="connsiteY28" fmla="*/ 0 h 33470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</a:cxnLst>
                    <a:rect l="l" t="t" r="r" b="b"/>
                    <a:pathLst>
                      <a:path w="1916526" h="3347037">
                        <a:moveTo>
                          <a:pt x="914400" y="0"/>
                        </a:moveTo>
                        <a:cubicBezTo>
                          <a:pt x="1419409" y="0"/>
                          <a:pt x="1828800" y="387029"/>
                          <a:pt x="1828800" y="864454"/>
                        </a:cubicBezTo>
                        <a:cubicBezTo>
                          <a:pt x="1828800" y="998730"/>
                          <a:pt x="1796417" y="1125855"/>
                          <a:pt x="1738631" y="1239231"/>
                        </a:cubicBezTo>
                        <a:lnTo>
                          <a:pt x="1680293" y="1335184"/>
                        </a:lnTo>
                        <a:lnTo>
                          <a:pt x="1703909" y="1394010"/>
                        </a:lnTo>
                        <a:cubicBezTo>
                          <a:pt x="1728062" y="1464809"/>
                          <a:pt x="1741074" y="1540084"/>
                          <a:pt x="1741074" y="1618130"/>
                        </a:cubicBezTo>
                        <a:cubicBezTo>
                          <a:pt x="1741074" y="1696176"/>
                          <a:pt x="1728062" y="1771451"/>
                          <a:pt x="1703909" y="1842250"/>
                        </a:cubicBezTo>
                        <a:lnTo>
                          <a:pt x="1678522" y="1905487"/>
                        </a:lnTo>
                        <a:lnTo>
                          <a:pt x="1760361" y="1999259"/>
                        </a:lnTo>
                        <a:cubicBezTo>
                          <a:pt x="1858956" y="2137226"/>
                          <a:pt x="1916526" y="2303549"/>
                          <a:pt x="1916526" y="2482583"/>
                        </a:cubicBezTo>
                        <a:cubicBezTo>
                          <a:pt x="1916526" y="2960008"/>
                          <a:pt x="1507135" y="3347037"/>
                          <a:pt x="1002126" y="3347037"/>
                        </a:cubicBezTo>
                        <a:cubicBezTo>
                          <a:pt x="497117" y="3347037"/>
                          <a:pt x="87726" y="2960008"/>
                          <a:pt x="87726" y="2482583"/>
                        </a:cubicBezTo>
                        <a:cubicBezTo>
                          <a:pt x="87726" y="2445284"/>
                          <a:pt x="90225" y="2408537"/>
                          <a:pt x="95073" y="2372483"/>
                        </a:cubicBezTo>
                        <a:lnTo>
                          <a:pt x="104255" y="2327114"/>
                        </a:lnTo>
                        <a:lnTo>
                          <a:pt x="64964" y="2261119"/>
                        </a:lnTo>
                        <a:cubicBezTo>
                          <a:pt x="23132" y="2170950"/>
                          <a:pt x="0" y="2071815"/>
                          <a:pt x="0" y="1967754"/>
                        </a:cubicBezTo>
                        <a:cubicBezTo>
                          <a:pt x="0" y="1915724"/>
                          <a:pt x="5783" y="1864925"/>
                          <a:pt x="16795" y="1815862"/>
                        </a:cubicBezTo>
                        <a:lnTo>
                          <a:pt x="32842" y="1758966"/>
                        </a:lnTo>
                        <a:lnTo>
                          <a:pt x="10325" y="1673548"/>
                        </a:lnTo>
                        <a:cubicBezTo>
                          <a:pt x="3530" y="1634643"/>
                          <a:pt x="0" y="1594746"/>
                          <a:pt x="0" y="1554097"/>
                        </a:cubicBezTo>
                        <a:cubicBezTo>
                          <a:pt x="0" y="1502067"/>
                          <a:pt x="5783" y="1451268"/>
                          <a:pt x="16795" y="1402205"/>
                        </a:cubicBezTo>
                        <a:lnTo>
                          <a:pt x="32289" y="1347269"/>
                        </a:lnTo>
                        <a:lnTo>
                          <a:pt x="16795" y="1292332"/>
                        </a:lnTo>
                        <a:cubicBezTo>
                          <a:pt x="5783" y="1243270"/>
                          <a:pt x="0" y="1192471"/>
                          <a:pt x="0" y="1140440"/>
                        </a:cubicBezTo>
                        <a:cubicBezTo>
                          <a:pt x="0" y="1114425"/>
                          <a:pt x="1446" y="1088717"/>
                          <a:pt x="4268" y="1063381"/>
                        </a:cubicBezTo>
                        <a:lnTo>
                          <a:pt x="13583" y="1007735"/>
                        </a:lnTo>
                        <a:lnTo>
                          <a:pt x="4721" y="952840"/>
                        </a:lnTo>
                        <a:cubicBezTo>
                          <a:pt x="1599" y="923779"/>
                          <a:pt x="0" y="894293"/>
                          <a:pt x="0" y="864454"/>
                        </a:cubicBezTo>
                        <a:cubicBezTo>
                          <a:pt x="0" y="387029"/>
                          <a:pt x="409391" y="0"/>
                          <a:pt x="914400" y="0"/>
                        </a:cubicBezTo>
                        <a:close/>
                      </a:path>
                    </a:pathLst>
                  </a:custGeom>
                  <a:solidFill>
                    <a:srgbClr val="D04E46"/>
                  </a:solidFill>
                  <a:ln w="349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wrap="square" rtlCol="0" anchor="ctr">
                    <a:no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23" name="Forma libre: forma 128">
                <a:extLst>
                  <a:ext uri="{FF2B5EF4-FFF2-40B4-BE49-F238E27FC236}">
                    <a16:creationId xmlns:a16="http://schemas.microsoft.com/office/drawing/2014/main" id="{1D9E1889-8A13-8F64-CE41-C13AF66E7AED}"/>
                  </a:ext>
                </a:extLst>
              </p:cNvPr>
              <p:cNvSpPr/>
              <p:nvPr/>
            </p:nvSpPr>
            <p:spPr>
              <a:xfrm>
                <a:off x="3807797" y="3118590"/>
                <a:ext cx="1056954" cy="842918"/>
              </a:xfrm>
              <a:custGeom>
                <a:avLst/>
                <a:gdLst>
                  <a:gd name="connsiteX0" fmla="*/ 59048 w 1056954"/>
                  <a:gd name="connsiteY0" fmla="*/ 59984 h 842918"/>
                  <a:gd name="connsiteX1" fmla="*/ 8248 w 1056954"/>
                  <a:gd name="connsiteY1" fmla="*/ 193334 h 842918"/>
                  <a:gd name="connsiteX2" fmla="*/ 1898 w 1056954"/>
                  <a:gd name="connsiteY2" fmla="*/ 390184 h 842918"/>
                  <a:gd name="connsiteX3" fmla="*/ 27298 w 1056954"/>
                  <a:gd name="connsiteY3" fmla="*/ 631484 h 842918"/>
                  <a:gd name="connsiteX4" fmla="*/ 78098 w 1056954"/>
                  <a:gd name="connsiteY4" fmla="*/ 828334 h 842918"/>
                  <a:gd name="connsiteX5" fmla="*/ 363848 w 1056954"/>
                  <a:gd name="connsiteY5" fmla="*/ 821984 h 842918"/>
                  <a:gd name="connsiteX6" fmla="*/ 713098 w 1056954"/>
                  <a:gd name="connsiteY6" fmla="*/ 771184 h 842918"/>
                  <a:gd name="connsiteX7" fmla="*/ 941698 w 1056954"/>
                  <a:gd name="connsiteY7" fmla="*/ 631484 h 842918"/>
                  <a:gd name="connsiteX8" fmla="*/ 1049648 w 1056954"/>
                  <a:gd name="connsiteY8" fmla="*/ 453684 h 842918"/>
                  <a:gd name="connsiteX9" fmla="*/ 1017898 w 1056954"/>
                  <a:gd name="connsiteY9" fmla="*/ 206034 h 842918"/>
                  <a:gd name="connsiteX10" fmla="*/ 782948 w 1056954"/>
                  <a:gd name="connsiteY10" fmla="*/ 40934 h 842918"/>
                  <a:gd name="connsiteX11" fmla="*/ 528948 w 1056954"/>
                  <a:gd name="connsiteY11" fmla="*/ 2834 h 842918"/>
                  <a:gd name="connsiteX12" fmla="*/ 141598 w 1056954"/>
                  <a:gd name="connsiteY12" fmla="*/ 9184 h 842918"/>
                  <a:gd name="connsiteX13" fmla="*/ 59048 w 1056954"/>
                  <a:gd name="connsiteY13" fmla="*/ 59984 h 8429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56954" h="842918">
                    <a:moveTo>
                      <a:pt x="59048" y="59984"/>
                    </a:moveTo>
                    <a:cubicBezTo>
                      <a:pt x="36823" y="90676"/>
                      <a:pt x="17773" y="138301"/>
                      <a:pt x="8248" y="193334"/>
                    </a:cubicBezTo>
                    <a:cubicBezTo>
                      <a:pt x="-1277" y="248367"/>
                      <a:pt x="-1277" y="317159"/>
                      <a:pt x="1898" y="390184"/>
                    </a:cubicBezTo>
                    <a:cubicBezTo>
                      <a:pt x="5073" y="463209"/>
                      <a:pt x="14598" y="558459"/>
                      <a:pt x="27298" y="631484"/>
                    </a:cubicBezTo>
                    <a:cubicBezTo>
                      <a:pt x="39998" y="704509"/>
                      <a:pt x="22006" y="796584"/>
                      <a:pt x="78098" y="828334"/>
                    </a:cubicBezTo>
                    <a:cubicBezTo>
                      <a:pt x="134190" y="860084"/>
                      <a:pt x="258015" y="831509"/>
                      <a:pt x="363848" y="821984"/>
                    </a:cubicBezTo>
                    <a:cubicBezTo>
                      <a:pt x="469681" y="812459"/>
                      <a:pt x="616790" y="802934"/>
                      <a:pt x="713098" y="771184"/>
                    </a:cubicBezTo>
                    <a:cubicBezTo>
                      <a:pt x="809406" y="739434"/>
                      <a:pt x="885606" y="684401"/>
                      <a:pt x="941698" y="631484"/>
                    </a:cubicBezTo>
                    <a:cubicBezTo>
                      <a:pt x="997790" y="578567"/>
                      <a:pt x="1036948" y="524592"/>
                      <a:pt x="1049648" y="453684"/>
                    </a:cubicBezTo>
                    <a:cubicBezTo>
                      <a:pt x="1062348" y="382776"/>
                      <a:pt x="1062348" y="274826"/>
                      <a:pt x="1017898" y="206034"/>
                    </a:cubicBezTo>
                    <a:cubicBezTo>
                      <a:pt x="973448" y="137242"/>
                      <a:pt x="864440" y="74801"/>
                      <a:pt x="782948" y="40934"/>
                    </a:cubicBezTo>
                    <a:cubicBezTo>
                      <a:pt x="701456" y="7067"/>
                      <a:pt x="635840" y="8126"/>
                      <a:pt x="528948" y="2834"/>
                    </a:cubicBezTo>
                    <a:cubicBezTo>
                      <a:pt x="422056" y="-2458"/>
                      <a:pt x="220973" y="-341"/>
                      <a:pt x="141598" y="9184"/>
                    </a:cubicBezTo>
                    <a:cubicBezTo>
                      <a:pt x="62223" y="18709"/>
                      <a:pt x="81273" y="29292"/>
                      <a:pt x="59048" y="599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24" name="Forma libre: forma 129">
                <a:extLst>
                  <a:ext uri="{FF2B5EF4-FFF2-40B4-BE49-F238E27FC236}">
                    <a16:creationId xmlns:a16="http://schemas.microsoft.com/office/drawing/2014/main" id="{2B88DFED-DC48-36E0-E971-E43F07246FE3}"/>
                  </a:ext>
                </a:extLst>
              </p:cNvPr>
              <p:cNvSpPr/>
              <p:nvPr/>
            </p:nvSpPr>
            <p:spPr>
              <a:xfrm>
                <a:off x="3888669" y="3887590"/>
                <a:ext cx="1131010" cy="793354"/>
              </a:xfrm>
              <a:custGeom>
                <a:avLst/>
                <a:gdLst>
                  <a:gd name="connsiteX0" fmla="*/ 9926 w 1131010"/>
                  <a:gd name="connsiteY0" fmla="*/ 256184 h 793354"/>
                  <a:gd name="connsiteX1" fmla="*/ 35326 w 1131010"/>
                  <a:gd name="connsiteY1" fmla="*/ 459384 h 793354"/>
                  <a:gd name="connsiteX2" fmla="*/ 187726 w 1131010"/>
                  <a:gd name="connsiteY2" fmla="*/ 630834 h 793354"/>
                  <a:gd name="connsiteX3" fmla="*/ 384576 w 1131010"/>
                  <a:gd name="connsiteY3" fmla="*/ 770534 h 793354"/>
                  <a:gd name="connsiteX4" fmla="*/ 625876 w 1131010"/>
                  <a:gd name="connsiteY4" fmla="*/ 789584 h 793354"/>
                  <a:gd name="connsiteX5" fmla="*/ 835426 w 1131010"/>
                  <a:gd name="connsiteY5" fmla="*/ 732434 h 793354"/>
                  <a:gd name="connsiteX6" fmla="*/ 1025926 w 1131010"/>
                  <a:gd name="connsiteY6" fmla="*/ 573684 h 793354"/>
                  <a:gd name="connsiteX7" fmla="*/ 1127526 w 1131010"/>
                  <a:gd name="connsiteY7" fmla="*/ 332384 h 793354"/>
                  <a:gd name="connsiteX8" fmla="*/ 1089426 w 1131010"/>
                  <a:gd name="connsiteY8" fmla="*/ 65684 h 793354"/>
                  <a:gd name="connsiteX9" fmla="*/ 917976 w 1131010"/>
                  <a:gd name="connsiteY9" fmla="*/ 2184 h 793354"/>
                  <a:gd name="connsiteX10" fmla="*/ 727476 w 1131010"/>
                  <a:gd name="connsiteY10" fmla="*/ 21234 h 793354"/>
                  <a:gd name="connsiteX11" fmla="*/ 511576 w 1131010"/>
                  <a:gd name="connsiteY11" fmla="*/ 84734 h 793354"/>
                  <a:gd name="connsiteX12" fmla="*/ 327426 w 1131010"/>
                  <a:gd name="connsiteY12" fmla="*/ 116484 h 793354"/>
                  <a:gd name="connsiteX13" fmla="*/ 168676 w 1131010"/>
                  <a:gd name="connsiteY13" fmla="*/ 122834 h 793354"/>
                  <a:gd name="connsiteX14" fmla="*/ 9926 w 1131010"/>
                  <a:gd name="connsiteY14" fmla="*/ 256184 h 793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1131010" h="793354">
                    <a:moveTo>
                      <a:pt x="9926" y="256184"/>
                    </a:moveTo>
                    <a:cubicBezTo>
                      <a:pt x="-12299" y="312276"/>
                      <a:pt x="5693" y="396942"/>
                      <a:pt x="35326" y="459384"/>
                    </a:cubicBezTo>
                    <a:cubicBezTo>
                      <a:pt x="64959" y="521826"/>
                      <a:pt x="129518" y="578976"/>
                      <a:pt x="187726" y="630834"/>
                    </a:cubicBezTo>
                    <a:cubicBezTo>
                      <a:pt x="245934" y="682692"/>
                      <a:pt x="311551" y="744076"/>
                      <a:pt x="384576" y="770534"/>
                    </a:cubicBezTo>
                    <a:cubicBezTo>
                      <a:pt x="457601" y="796992"/>
                      <a:pt x="550734" y="795934"/>
                      <a:pt x="625876" y="789584"/>
                    </a:cubicBezTo>
                    <a:cubicBezTo>
                      <a:pt x="701018" y="783234"/>
                      <a:pt x="768751" y="768417"/>
                      <a:pt x="835426" y="732434"/>
                    </a:cubicBezTo>
                    <a:cubicBezTo>
                      <a:pt x="902101" y="696451"/>
                      <a:pt x="977243" y="640359"/>
                      <a:pt x="1025926" y="573684"/>
                    </a:cubicBezTo>
                    <a:cubicBezTo>
                      <a:pt x="1074609" y="507009"/>
                      <a:pt x="1116943" y="417051"/>
                      <a:pt x="1127526" y="332384"/>
                    </a:cubicBezTo>
                    <a:cubicBezTo>
                      <a:pt x="1138109" y="247717"/>
                      <a:pt x="1124351" y="120717"/>
                      <a:pt x="1089426" y="65684"/>
                    </a:cubicBezTo>
                    <a:cubicBezTo>
                      <a:pt x="1054501" y="10651"/>
                      <a:pt x="978301" y="9592"/>
                      <a:pt x="917976" y="2184"/>
                    </a:cubicBezTo>
                    <a:cubicBezTo>
                      <a:pt x="857651" y="-5224"/>
                      <a:pt x="795209" y="7476"/>
                      <a:pt x="727476" y="21234"/>
                    </a:cubicBezTo>
                    <a:cubicBezTo>
                      <a:pt x="659743" y="34992"/>
                      <a:pt x="578251" y="68859"/>
                      <a:pt x="511576" y="84734"/>
                    </a:cubicBezTo>
                    <a:cubicBezTo>
                      <a:pt x="444901" y="100609"/>
                      <a:pt x="384576" y="110134"/>
                      <a:pt x="327426" y="116484"/>
                    </a:cubicBezTo>
                    <a:cubicBezTo>
                      <a:pt x="270276" y="122834"/>
                      <a:pt x="222651" y="104842"/>
                      <a:pt x="168676" y="122834"/>
                    </a:cubicBezTo>
                    <a:cubicBezTo>
                      <a:pt x="114701" y="140826"/>
                      <a:pt x="32151" y="200092"/>
                      <a:pt x="9926" y="256184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25" name="Forma libre: forma 130">
                <a:extLst>
                  <a:ext uri="{FF2B5EF4-FFF2-40B4-BE49-F238E27FC236}">
                    <a16:creationId xmlns:a16="http://schemas.microsoft.com/office/drawing/2014/main" id="{FC39A119-21F5-122E-C3C2-1804BB8E2DA9}"/>
                  </a:ext>
                </a:extLst>
              </p:cNvPr>
              <p:cNvSpPr/>
              <p:nvPr/>
            </p:nvSpPr>
            <p:spPr>
              <a:xfrm>
                <a:off x="3816024" y="2377299"/>
                <a:ext cx="1098835" cy="717462"/>
              </a:xfrm>
              <a:custGeom>
                <a:avLst/>
                <a:gdLst>
                  <a:gd name="connsiteX0" fmla="*/ 69871 w 1098835"/>
                  <a:gd name="connsiteY0" fmla="*/ 229775 h 717462"/>
                  <a:gd name="connsiteX1" fmla="*/ 21 w 1098835"/>
                  <a:gd name="connsiteY1" fmla="*/ 394875 h 717462"/>
                  <a:gd name="connsiteX2" fmla="*/ 76221 w 1098835"/>
                  <a:gd name="connsiteY2" fmla="*/ 579025 h 717462"/>
                  <a:gd name="connsiteX3" fmla="*/ 215921 w 1098835"/>
                  <a:gd name="connsiteY3" fmla="*/ 661575 h 717462"/>
                  <a:gd name="connsiteX4" fmla="*/ 533421 w 1098835"/>
                  <a:gd name="connsiteY4" fmla="*/ 648875 h 717462"/>
                  <a:gd name="connsiteX5" fmla="*/ 857271 w 1098835"/>
                  <a:gd name="connsiteY5" fmla="*/ 712375 h 717462"/>
                  <a:gd name="connsiteX6" fmla="*/ 1003321 w 1098835"/>
                  <a:gd name="connsiteY6" fmla="*/ 686975 h 717462"/>
                  <a:gd name="connsiteX7" fmla="*/ 1098571 w 1098835"/>
                  <a:gd name="connsiteY7" fmla="*/ 477425 h 717462"/>
                  <a:gd name="connsiteX8" fmla="*/ 1022371 w 1098835"/>
                  <a:gd name="connsiteY8" fmla="*/ 153575 h 717462"/>
                  <a:gd name="connsiteX9" fmla="*/ 774721 w 1098835"/>
                  <a:gd name="connsiteY9" fmla="*/ 20225 h 717462"/>
                  <a:gd name="connsiteX10" fmla="*/ 571521 w 1098835"/>
                  <a:gd name="connsiteY10" fmla="*/ 1175 h 717462"/>
                  <a:gd name="connsiteX11" fmla="*/ 368321 w 1098835"/>
                  <a:gd name="connsiteY11" fmla="*/ 26575 h 717462"/>
                  <a:gd name="connsiteX12" fmla="*/ 196871 w 1098835"/>
                  <a:gd name="connsiteY12" fmla="*/ 115475 h 717462"/>
                  <a:gd name="connsiteX13" fmla="*/ 69871 w 1098835"/>
                  <a:gd name="connsiteY13" fmla="*/ 229775 h 7174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1098835" h="717462">
                    <a:moveTo>
                      <a:pt x="69871" y="229775"/>
                    </a:moveTo>
                    <a:cubicBezTo>
                      <a:pt x="37063" y="276342"/>
                      <a:pt x="-1037" y="336667"/>
                      <a:pt x="21" y="394875"/>
                    </a:cubicBezTo>
                    <a:cubicBezTo>
                      <a:pt x="1079" y="453083"/>
                      <a:pt x="40238" y="534575"/>
                      <a:pt x="76221" y="579025"/>
                    </a:cubicBezTo>
                    <a:cubicBezTo>
                      <a:pt x="112204" y="623475"/>
                      <a:pt x="139721" y="649933"/>
                      <a:pt x="215921" y="661575"/>
                    </a:cubicBezTo>
                    <a:cubicBezTo>
                      <a:pt x="292121" y="673217"/>
                      <a:pt x="426529" y="640408"/>
                      <a:pt x="533421" y="648875"/>
                    </a:cubicBezTo>
                    <a:cubicBezTo>
                      <a:pt x="640313" y="657342"/>
                      <a:pt x="778954" y="706025"/>
                      <a:pt x="857271" y="712375"/>
                    </a:cubicBezTo>
                    <a:cubicBezTo>
                      <a:pt x="935588" y="718725"/>
                      <a:pt x="963104" y="726133"/>
                      <a:pt x="1003321" y="686975"/>
                    </a:cubicBezTo>
                    <a:cubicBezTo>
                      <a:pt x="1043538" y="647817"/>
                      <a:pt x="1095396" y="566325"/>
                      <a:pt x="1098571" y="477425"/>
                    </a:cubicBezTo>
                    <a:cubicBezTo>
                      <a:pt x="1101746" y="388525"/>
                      <a:pt x="1076346" y="229775"/>
                      <a:pt x="1022371" y="153575"/>
                    </a:cubicBezTo>
                    <a:cubicBezTo>
                      <a:pt x="968396" y="77375"/>
                      <a:pt x="849863" y="45625"/>
                      <a:pt x="774721" y="20225"/>
                    </a:cubicBezTo>
                    <a:cubicBezTo>
                      <a:pt x="699579" y="-5175"/>
                      <a:pt x="639254" y="117"/>
                      <a:pt x="571521" y="1175"/>
                    </a:cubicBezTo>
                    <a:cubicBezTo>
                      <a:pt x="503788" y="2233"/>
                      <a:pt x="430763" y="7525"/>
                      <a:pt x="368321" y="26575"/>
                    </a:cubicBezTo>
                    <a:cubicBezTo>
                      <a:pt x="305879" y="45625"/>
                      <a:pt x="243438" y="87958"/>
                      <a:pt x="196871" y="115475"/>
                    </a:cubicBezTo>
                    <a:cubicBezTo>
                      <a:pt x="150304" y="142992"/>
                      <a:pt x="102679" y="183208"/>
                      <a:pt x="69871" y="229775"/>
                    </a:cubicBezTo>
                    <a:close/>
                  </a:path>
                </a:pathLst>
              </a:custGeom>
              <a:solidFill>
                <a:srgbClr val="F47258">
                  <a:alpha val="3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  <p:grpSp>
          <p:nvGrpSpPr>
            <p:cNvPr id="16" name="Grupo 30">
              <a:extLst>
                <a:ext uri="{FF2B5EF4-FFF2-40B4-BE49-F238E27FC236}">
                  <a16:creationId xmlns:a16="http://schemas.microsoft.com/office/drawing/2014/main" id="{94EB7180-10EC-EFF5-E232-7CFF938724D1}"/>
                </a:ext>
              </a:extLst>
            </p:cNvPr>
            <p:cNvGrpSpPr/>
            <p:nvPr/>
          </p:nvGrpSpPr>
          <p:grpSpPr>
            <a:xfrm>
              <a:off x="3314114" y="4001075"/>
              <a:ext cx="1634014" cy="1634014"/>
              <a:chOff x="3314114" y="4001075"/>
              <a:chExt cx="1634014" cy="1634014"/>
            </a:xfrm>
          </p:grpSpPr>
          <p:sp>
            <p:nvSpPr>
              <p:cNvPr id="17" name="Elipse 88">
                <a:extLst>
                  <a:ext uri="{FF2B5EF4-FFF2-40B4-BE49-F238E27FC236}">
                    <a16:creationId xmlns:a16="http://schemas.microsoft.com/office/drawing/2014/main" id="{5AD5C776-A6C5-1D55-1FBE-E6B4AF36E1DF}"/>
                  </a:ext>
                </a:extLst>
              </p:cNvPr>
              <p:cNvSpPr/>
              <p:nvPr/>
            </p:nvSpPr>
            <p:spPr>
              <a:xfrm>
                <a:off x="3314114" y="4001075"/>
                <a:ext cx="1634014" cy="1634014"/>
              </a:xfrm>
              <a:prstGeom prst="ellipse">
                <a:avLst/>
              </a:prstGeom>
              <a:solidFill>
                <a:schemeClr val="accent4">
                  <a:lumMod val="50000"/>
                </a:schemeClr>
              </a:solidFill>
              <a:ln w="349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18" name="Forma libre: forma 93">
                <a:extLst>
                  <a:ext uri="{FF2B5EF4-FFF2-40B4-BE49-F238E27FC236}">
                    <a16:creationId xmlns:a16="http://schemas.microsoft.com/office/drawing/2014/main" id="{2E9D4CA2-7F9A-C9DF-7812-ECA33BBB83B7}"/>
                  </a:ext>
                </a:extLst>
              </p:cNvPr>
              <p:cNvSpPr/>
              <p:nvPr/>
            </p:nvSpPr>
            <p:spPr>
              <a:xfrm>
                <a:off x="3739373" y="4206055"/>
                <a:ext cx="901700" cy="687150"/>
              </a:xfrm>
              <a:custGeom>
                <a:avLst/>
                <a:gdLst>
                  <a:gd name="connsiteX0" fmla="*/ 0 w 901700"/>
                  <a:gd name="connsiteY0" fmla="*/ 628650 h 687150"/>
                  <a:gd name="connsiteX1" fmla="*/ 139700 w 901700"/>
                  <a:gd name="connsiteY1" fmla="*/ 685800 h 687150"/>
                  <a:gd name="connsiteX2" fmla="*/ 400050 w 901700"/>
                  <a:gd name="connsiteY2" fmla="*/ 577850 h 687150"/>
                  <a:gd name="connsiteX3" fmla="*/ 508000 w 901700"/>
                  <a:gd name="connsiteY3" fmla="*/ 431800 h 687150"/>
                  <a:gd name="connsiteX4" fmla="*/ 730250 w 901700"/>
                  <a:gd name="connsiteY4" fmla="*/ 107950 h 687150"/>
                  <a:gd name="connsiteX5" fmla="*/ 901700 w 901700"/>
                  <a:gd name="connsiteY5" fmla="*/ 0 h 6871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901700" h="687150">
                    <a:moveTo>
                      <a:pt x="0" y="628650"/>
                    </a:moveTo>
                    <a:cubicBezTo>
                      <a:pt x="36512" y="661458"/>
                      <a:pt x="73025" y="694267"/>
                      <a:pt x="139700" y="685800"/>
                    </a:cubicBezTo>
                    <a:cubicBezTo>
                      <a:pt x="206375" y="677333"/>
                      <a:pt x="338667" y="620183"/>
                      <a:pt x="400050" y="577850"/>
                    </a:cubicBezTo>
                    <a:cubicBezTo>
                      <a:pt x="461433" y="535517"/>
                      <a:pt x="452967" y="510117"/>
                      <a:pt x="508000" y="431800"/>
                    </a:cubicBezTo>
                    <a:cubicBezTo>
                      <a:pt x="563033" y="353483"/>
                      <a:pt x="664634" y="179916"/>
                      <a:pt x="730250" y="107950"/>
                    </a:cubicBezTo>
                    <a:cubicBezTo>
                      <a:pt x="795866" y="35984"/>
                      <a:pt x="848783" y="17992"/>
                      <a:pt x="901700" y="0"/>
                    </a:cubicBezTo>
                  </a:path>
                </a:pathLst>
              </a:custGeom>
              <a:noFill/>
              <a:ln w="19050"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9" name="Forma libre: forma 94">
                <a:extLst>
                  <a:ext uri="{FF2B5EF4-FFF2-40B4-BE49-F238E27FC236}">
                    <a16:creationId xmlns:a16="http://schemas.microsoft.com/office/drawing/2014/main" id="{42123C5C-B945-E10C-233F-8963E9082F16}"/>
                  </a:ext>
                </a:extLst>
              </p:cNvPr>
              <p:cNvSpPr/>
              <p:nvPr/>
            </p:nvSpPr>
            <p:spPr>
              <a:xfrm>
                <a:off x="4107673" y="4796605"/>
                <a:ext cx="825500" cy="384847"/>
              </a:xfrm>
              <a:custGeom>
                <a:avLst/>
                <a:gdLst>
                  <a:gd name="connsiteX0" fmla="*/ 0 w 825500"/>
                  <a:gd name="connsiteY0" fmla="*/ 0 h 384847"/>
                  <a:gd name="connsiteX1" fmla="*/ 69850 w 825500"/>
                  <a:gd name="connsiteY1" fmla="*/ 107950 h 384847"/>
                  <a:gd name="connsiteX2" fmla="*/ 114300 w 825500"/>
                  <a:gd name="connsiteY2" fmla="*/ 317500 h 384847"/>
                  <a:gd name="connsiteX3" fmla="*/ 457200 w 825500"/>
                  <a:gd name="connsiteY3" fmla="*/ 368300 h 384847"/>
                  <a:gd name="connsiteX4" fmla="*/ 673100 w 825500"/>
                  <a:gd name="connsiteY4" fmla="*/ 57150 h 384847"/>
                  <a:gd name="connsiteX5" fmla="*/ 825500 w 825500"/>
                  <a:gd name="connsiteY5" fmla="*/ 12700 h 3848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25500" h="384847">
                    <a:moveTo>
                      <a:pt x="0" y="0"/>
                    </a:moveTo>
                    <a:cubicBezTo>
                      <a:pt x="25400" y="27516"/>
                      <a:pt x="50800" y="55033"/>
                      <a:pt x="69850" y="107950"/>
                    </a:cubicBezTo>
                    <a:cubicBezTo>
                      <a:pt x="88900" y="160867"/>
                      <a:pt x="49742" y="274108"/>
                      <a:pt x="114300" y="317500"/>
                    </a:cubicBezTo>
                    <a:cubicBezTo>
                      <a:pt x="178858" y="360892"/>
                      <a:pt x="364067" y="411692"/>
                      <a:pt x="457200" y="368300"/>
                    </a:cubicBezTo>
                    <a:cubicBezTo>
                      <a:pt x="550333" y="324908"/>
                      <a:pt x="611717" y="116417"/>
                      <a:pt x="673100" y="57150"/>
                    </a:cubicBezTo>
                    <a:cubicBezTo>
                      <a:pt x="734483" y="-2117"/>
                      <a:pt x="779991" y="5291"/>
                      <a:pt x="825500" y="12700"/>
                    </a:cubicBezTo>
                  </a:path>
                </a:pathLst>
              </a:custGeom>
              <a:noFill/>
              <a:ln w="22225"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/>
              </a:p>
            </p:txBody>
          </p:sp>
          <p:sp>
            <p:nvSpPr>
              <p:cNvPr id="20" name="Forma libre: forma 26">
                <a:extLst>
                  <a:ext uri="{FF2B5EF4-FFF2-40B4-BE49-F238E27FC236}">
                    <a16:creationId xmlns:a16="http://schemas.microsoft.com/office/drawing/2014/main" id="{3B9AB253-D1CF-F112-74BB-8C632AD07133}"/>
                  </a:ext>
                </a:extLst>
              </p:cNvPr>
              <p:cNvSpPr/>
              <p:nvPr/>
            </p:nvSpPr>
            <p:spPr>
              <a:xfrm>
                <a:off x="4164340" y="4035824"/>
                <a:ext cx="418620" cy="1592644"/>
              </a:xfrm>
              <a:custGeom>
                <a:avLst/>
                <a:gdLst>
                  <a:gd name="connsiteX0" fmla="*/ 3363 w 418620"/>
                  <a:gd name="connsiteY0" fmla="*/ 1610916 h 1613520"/>
                  <a:gd name="connsiteX1" fmla="*/ 206563 w 418620"/>
                  <a:gd name="connsiteY1" fmla="*/ 884476 h 1613520"/>
                  <a:gd name="connsiteX2" fmla="*/ 292923 w 418620"/>
                  <a:gd name="connsiteY2" fmla="*/ 518716 h 1613520"/>
                  <a:gd name="connsiteX3" fmla="*/ 165923 w 418620"/>
                  <a:gd name="connsiteY3" fmla="*/ 122476 h 1613520"/>
                  <a:gd name="connsiteX4" fmla="*/ 125283 w 418620"/>
                  <a:gd name="connsiteY4" fmla="*/ 556 h 1613520"/>
                  <a:gd name="connsiteX5" fmla="*/ 328483 w 418620"/>
                  <a:gd name="connsiteY5" fmla="*/ 91996 h 1613520"/>
                  <a:gd name="connsiteX6" fmla="*/ 384363 w 418620"/>
                  <a:gd name="connsiteY6" fmla="*/ 401876 h 1613520"/>
                  <a:gd name="connsiteX7" fmla="*/ 389443 w 418620"/>
                  <a:gd name="connsiteY7" fmla="*/ 605076 h 1613520"/>
                  <a:gd name="connsiteX8" fmla="*/ 3363 w 418620"/>
                  <a:gd name="connsiteY8" fmla="*/ 1610916 h 16135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418620" h="1613520">
                    <a:moveTo>
                      <a:pt x="3363" y="1610916"/>
                    </a:moveTo>
                    <a:cubicBezTo>
                      <a:pt x="-27117" y="1657483"/>
                      <a:pt x="158303" y="1066509"/>
                      <a:pt x="206563" y="884476"/>
                    </a:cubicBezTo>
                    <a:cubicBezTo>
                      <a:pt x="254823" y="702443"/>
                      <a:pt x="299696" y="645716"/>
                      <a:pt x="292923" y="518716"/>
                    </a:cubicBezTo>
                    <a:cubicBezTo>
                      <a:pt x="286150" y="391716"/>
                      <a:pt x="193863" y="208836"/>
                      <a:pt x="165923" y="122476"/>
                    </a:cubicBezTo>
                    <a:cubicBezTo>
                      <a:pt x="137983" y="36116"/>
                      <a:pt x="98190" y="5636"/>
                      <a:pt x="125283" y="556"/>
                    </a:cubicBezTo>
                    <a:cubicBezTo>
                      <a:pt x="152376" y="-4524"/>
                      <a:pt x="285303" y="25109"/>
                      <a:pt x="328483" y="91996"/>
                    </a:cubicBezTo>
                    <a:cubicBezTo>
                      <a:pt x="371663" y="158883"/>
                      <a:pt x="374203" y="316363"/>
                      <a:pt x="384363" y="401876"/>
                    </a:cubicBezTo>
                    <a:cubicBezTo>
                      <a:pt x="394523" y="487389"/>
                      <a:pt x="452943" y="401876"/>
                      <a:pt x="389443" y="605076"/>
                    </a:cubicBezTo>
                    <a:cubicBezTo>
                      <a:pt x="325943" y="808276"/>
                      <a:pt x="33843" y="1564349"/>
                      <a:pt x="3363" y="1610916"/>
                    </a:cubicBezTo>
                    <a:close/>
                  </a:path>
                </a:pathLst>
              </a:custGeom>
              <a:solidFill>
                <a:schemeClr val="accent4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21" name="Forma libre: forma 25">
                <a:extLst>
                  <a:ext uri="{FF2B5EF4-FFF2-40B4-BE49-F238E27FC236}">
                    <a16:creationId xmlns:a16="http://schemas.microsoft.com/office/drawing/2014/main" id="{1B7BDC37-EF17-AAA4-0277-DC266947F819}"/>
                  </a:ext>
                </a:extLst>
              </p:cNvPr>
              <p:cNvSpPr/>
              <p:nvPr/>
            </p:nvSpPr>
            <p:spPr>
              <a:xfrm>
                <a:off x="3594770" y="4190094"/>
                <a:ext cx="165426" cy="1286973"/>
              </a:xfrm>
              <a:custGeom>
                <a:avLst/>
                <a:gdLst>
                  <a:gd name="connsiteX0" fmla="*/ 164 w 165426"/>
                  <a:gd name="connsiteY0" fmla="*/ 40463 h 1286973"/>
                  <a:gd name="connsiteX1" fmla="*/ 34031 w 165426"/>
                  <a:gd name="connsiteY1" fmla="*/ 158997 h 1286973"/>
                  <a:gd name="connsiteX2" fmla="*/ 103881 w 165426"/>
                  <a:gd name="connsiteY2" fmla="*/ 347380 h 1286973"/>
                  <a:gd name="connsiteX3" fmla="*/ 99647 w 165426"/>
                  <a:gd name="connsiteY3" fmla="*/ 484963 h 1286973"/>
                  <a:gd name="connsiteX4" fmla="*/ 112347 w 165426"/>
                  <a:gd name="connsiteY4" fmla="*/ 654297 h 1286973"/>
                  <a:gd name="connsiteX5" fmla="*/ 118697 w 165426"/>
                  <a:gd name="connsiteY5" fmla="*/ 819397 h 1286973"/>
                  <a:gd name="connsiteX6" fmla="*/ 97531 w 165426"/>
                  <a:gd name="connsiteY6" fmla="*/ 1043763 h 1286973"/>
                  <a:gd name="connsiteX7" fmla="*/ 50964 w 165426"/>
                  <a:gd name="connsiteY7" fmla="*/ 1246963 h 1286973"/>
                  <a:gd name="connsiteX8" fmla="*/ 63664 w 165426"/>
                  <a:gd name="connsiteY8" fmla="*/ 1268130 h 1286973"/>
                  <a:gd name="connsiteX9" fmla="*/ 93297 w 165426"/>
                  <a:gd name="connsiteY9" fmla="*/ 1282947 h 1286973"/>
                  <a:gd name="connsiteX10" fmla="*/ 108114 w 165426"/>
                  <a:gd name="connsiteY10" fmla="*/ 1276597 h 1286973"/>
                  <a:gd name="connsiteX11" fmla="*/ 122931 w 165426"/>
                  <a:gd name="connsiteY11" fmla="*/ 1177113 h 1286973"/>
                  <a:gd name="connsiteX12" fmla="*/ 158914 w 165426"/>
                  <a:gd name="connsiteY12" fmla="*/ 1037413 h 1286973"/>
                  <a:gd name="connsiteX13" fmla="*/ 165264 w 165426"/>
                  <a:gd name="connsiteY13" fmla="*/ 916763 h 1286973"/>
                  <a:gd name="connsiteX14" fmla="*/ 163147 w 165426"/>
                  <a:gd name="connsiteY14" fmla="*/ 800347 h 1286973"/>
                  <a:gd name="connsiteX15" fmla="*/ 158914 w 165426"/>
                  <a:gd name="connsiteY15" fmla="*/ 722030 h 1286973"/>
                  <a:gd name="connsiteX16" fmla="*/ 152564 w 165426"/>
                  <a:gd name="connsiteY16" fmla="*/ 643713 h 1286973"/>
                  <a:gd name="connsiteX17" fmla="*/ 152564 w 165426"/>
                  <a:gd name="connsiteY17" fmla="*/ 588680 h 1286973"/>
                  <a:gd name="connsiteX18" fmla="*/ 156797 w 165426"/>
                  <a:gd name="connsiteY18" fmla="*/ 440513 h 1286973"/>
                  <a:gd name="connsiteX19" fmla="*/ 161031 w 165426"/>
                  <a:gd name="connsiteY19" fmla="*/ 341030 h 1286973"/>
                  <a:gd name="connsiteX20" fmla="*/ 137747 w 165426"/>
                  <a:gd name="connsiteY20" fmla="*/ 237313 h 1286973"/>
                  <a:gd name="connsiteX21" fmla="*/ 97531 w 165426"/>
                  <a:gd name="connsiteY21" fmla="*/ 133597 h 1286973"/>
                  <a:gd name="connsiteX22" fmla="*/ 70014 w 165426"/>
                  <a:gd name="connsiteY22" fmla="*/ 42580 h 1286973"/>
                  <a:gd name="connsiteX23" fmla="*/ 46731 w 165426"/>
                  <a:gd name="connsiteY23" fmla="*/ 247 h 1286973"/>
                  <a:gd name="connsiteX24" fmla="*/ 164 w 165426"/>
                  <a:gd name="connsiteY24" fmla="*/ 40463 h 12869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</a:cxnLst>
                <a:rect l="l" t="t" r="r" b="b"/>
                <a:pathLst>
                  <a:path w="165426" h="1286973">
                    <a:moveTo>
                      <a:pt x="164" y="40463"/>
                    </a:moveTo>
                    <a:cubicBezTo>
                      <a:pt x="-1953" y="66921"/>
                      <a:pt x="16745" y="107844"/>
                      <a:pt x="34031" y="158997"/>
                    </a:cubicBezTo>
                    <a:cubicBezTo>
                      <a:pt x="51317" y="210150"/>
                      <a:pt x="92945" y="293052"/>
                      <a:pt x="103881" y="347380"/>
                    </a:cubicBezTo>
                    <a:cubicBezTo>
                      <a:pt x="114817" y="401708"/>
                      <a:pt x="98236" y="433810"/>
                      <a:pt x="99647" y="484963"/>
                    </a:cubicBezTo>
                    <a:cubicBezTo>
                      <a:pt x="101058" y="536116"/>
                      <a:pt x="109172" y="598558"/>
                      <a:pt x="112347" y="654297"/>
                    </a:cubicBezTo>
                    <a:cubicBezTo>
                      <a:pt x="115522" y="710036"/>
                      <a:pt x="121166" y="754486"/>
                      <a:pt x="118697" y="819397"/>
                    </a:cubicBezTo>
                    <a:cubicBezTo>
                      <a:pt x="116228" y="884308"/>
                      <a:pt x="108820" y="972502"/>
                      <a:pt x="97531" y="1043763"/>
                    </a:cubicBezTo>
                    <a:cubicBezTo>
                      <a:pt x="86242" y="1115024"/>
                      <a:pt x="56608" y="1209569"/>
                      <a:pt x="50964" y="1246963"/>
                    </a:cubicBezTo>
                    <a:cubicBezTo>
                      <a:pt x="45320" y="1284357"/>
                      <a:pt x="56609" y="1262133"/>
                      <a:pt x="63664" y="1268130"/>
                    </a:cubicBezTo>
                    <a:cubicBezTo>
                      <a:pt x="70719" y="1274127"/>
                      <a:pt x="85889" y="1281536"/>
                      <a:pt x="93297" y="1282947"/>
                    </a:cubicBezTo>
                    <a:cubicBezTo>
                      <a:pt x="100705" y="1284358"/>
                      <a:pt x="103175" y="1294236"/>
                      <a:pt x="108114" y="1276597"/>
                    </a:cubicBezTo>
                    <a:cubicBezTo>
                      <a:pt x="113053" y="1258958"/>
                      <a:pt x="114464" y="1216977"/>
                      <a:pt x="122931" y="1177113"/>
                    </a:cubicBezTo>
                    <a:cubicBezTo>
                      <a:pt x="131398" y="1137249"/>
                      <a:pt x="151858" y="1080805"/>
                      <a:pt x="158914" y="1037413"/>
                    </a:cubicBezTo>
                    <a:cubicBezTo>
                      <a:pt x="165970" y="994021"/>
                      <a:pt x="164558" y="956274"/>
                      <a:pt x="165264" y="916763"/>
                    </a:cubicBezTo>
                    <a:cubicBezTo>
                      <a:pt x="165970" y="877252"/>
                      <a:pt x="164205" y="832802"/>
                      <a:pt x="163147" y="800347"/>
                    </a:cubicBezTo>
                    <a:cubicBezTo>
                      <a:pt x="162089" y="767892"/>
                      <a:pt x="160678" y="748136"/>
                      <a:pt x="158914" y="722030"/>
                    </a:cubicBezTo>
                    <a:cubicBezTo>
                      <a:pt x="157150" y="695924"/>
                      <a:pt x="153622" y="665938"/>
                      <a:pt x="152564" y="643713"/>
                    </a:cubicBezTo>
                    <a:cubicBezTo>
                      <a:pt x="151506" y="621488"/>
                      <a:pt x="151859" y="622547"/>
                      <a:pt x="152564" y="588680"/>
                    </a:cubicBezTo>
                    <a:cubicBezTo>
                      <a:pt x="153270" y="554813"/>
                      <a:pt x="155386" y="481788"/>
                      <a:pt x="156797" y="440513"/>
                    </a:cubicBezTo>
                    <a:cubicBezTo>
                      <a:pt x="158208" y="399238"/>
                      <a:pt x="164206" y="374897"/>
                      <a:pt x="161031" y="341030"/>
                    </a:cubicBezTo>
                    <a:cubicBezTo>
                      <a:pt x="157856" y="307163"/>
                      <a:pt x="148330" y="271885"/>
                      <a:pt x="137747" y="237313"/>
                    </a:cubicBezTo>
                    <a:cubicBezTo>
                      <a:pt x="127164" y="202741"/>
                      <a:pt x="108820" y="166053"/>
                      <a:pt x="97531" y="133597"/>
                    </a:cubicBezTo>
                    <a:cubicBezTo>
                      <a:pt x="86242" y="101142"/>
                      <a:pt x="78481" y="64805"/>
                      <a:pt x="70014" y="42580"/>
                    </a:cubicBezTo>
                    <a:cubicBezTo>
                      <a:pt x="61547" y="20355"/>
                      <a:pt x="54845" y="2716"/>
                      <a:pt x="46731" y="247"/>
                    </a:cubicBezTo>
                    <a:cubicBezTo>
                      <a:pt x="38617" y="-2222"/>
                      <a:pt x="2281" y="14005"/>
                      <a:pt x="164" y="40463"/>
                    </a:cubicBezTo>
                    <a:close/>
                  </a:path>
                </a:pathLst>
              </a:custGeom>
              <a:solidFill>
                <a:schemeClr val="accent4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</p:grpSp>
      </p:grpSp>
      <p:sp>
        <p:nvSpPr>
          <p:cNvPr id="10" name="CuadroTexto 41">
            <a:extLst>
              <a:ext uri="{FF2B5EF4-FFF2-40B4-BE49-F238E27FC236}">
                <a16:creationId xmlns:a16="http://schemas.microsoft.com/office/drawing/2014/main" id="{C4DC2CAC-DA38-C402-5ADA-B7C393A9BA41}"/>
              </a:ext>
            </a:extLst>
          </p:cNvPr>
          <p:cNvSpPr txBox="1"/>
          <p:nvPr/>
        </p:nvSpPr>
        <p:spPr>
          <a:xfrm>
            <a:off x="118039" y="1852163"/>
            <a:ext cx="1783671" cy="307777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>
                <a:latin typeface="Calibri bold"/>
                <a:ea typeface="Calibri bold"/>
                <a:cs typeface="Calibri bold"/>
              </a:rPr>
              <a:t>Inflammatory</a:t>
            </a:r>
          </a:p>
        </p:txBody>
      </p:sp>
      <p:sp>
        <p:nvSpPr>
          <p:cNvPr id="12" name="CuadroTexto 42">
            <a:extLst>
              <a:ext uri="{FF2B5EF4-FFF2-40B4-BE49-F238E27FC236}">
                <a16:creationId xmlns:a16="http://schemas.microsoft.com/office/drawing/2014/main" id="{F3A5C718-119E-660A-3B18-A8D9B1BAA7DA}"/>
              </a:ext>
            </a:extLst>
          </p:cNvPr>
          <p:cNvSpPr txBox="1"/>
          <p:nvPr/>
        </p:nvSpPr>
        <p:spPr>
          <a:xfrm>
            <a:off x="1727994" y="1847459"/>
            <a:ext cx="2018646" cy="307777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ca-ES" sz="1400" b="1" dirty="0" err="1">
                <a:cs typeface="Calibri"/>
              </a:rPr>
              <a:t>Cystic</a:t>
            </a:r>
            <a:r>
              <a:rPr lang="ca-ES" sz="1400" b="1" dirty="0">
                <a:cs typeface="Calibri"/>
              </a:rPr>
              <a:t> </a:t>
            </a:r>
            <a:r>
              <a:rPr lang="ca-ES" sz="1400" b="1" dirty="0" err="1">
                <a:cs typeface="Calibri"/>
              </a:rPr>
              <a:t>nephroma</a:t>
            </a:r>
            <a:endParaRPr lang="ca-ES" sz="1400" b="1" dirty="0">
              <a:latin typeface="Calibri bold"/>
              <a:ea typeface="Calibri bold"/>
              <a:cs typeface="Calibri bold"/>
            </a:endParaRPr>
          </a:p>
        </p:txBody>
      </p:sp>
      <p:sp>
        <p:nvSpPr>
          <p:cNvPr id="13" name="CuadroTexto 43">
            <a:extLst>
              <a:ext uri="{FF2B5EF4-FFF2-40B4-BE49-F238E27FC236}">
                <a16:creationId xmlns:a16="http://schemas.microsoft.com/office/drawing/2014/main" id="{91B2C9EA-66F0-155A-D348-3AB253F6F370}"/>
              </a:ext>
            </a:extLst>
          </p:cNvPr>
          <p:cNvSpPr txBox="1"/>
          <p:nvPr/>
        </p:nvSpPr>
        <p:spPr>
          <a:xfrm>
            <a:off x="3937779" y="1845892"/>
            <a:ext cx="1251275" cy="307777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ca-ES" sz="1400" b="1" dirty="0" err="1">
                <a:cs typeface="Calibri"/>
              </a:rPr>
              <a:t>Papillary</a:t>
            </a:r>
            <a:endParaRPr lang="en-US" sz="1200" dirty="0">
              <a:latin typeface="Calibri bold" panose="020F0702030404030204" pitchFamily="34" charset="0"/>
              <a:ea typeface="Calibri bold" panose="020F0702030404030204" pitchFamily="34" charset="0"/>
              <a:cs typeface="Calibri bold" panose="020F0702030404030204" pitchFamily="34" charset="0"/>
            </a:endParaRPr>
          </a:p>
        </p:txBody>
      </p:sp>
      <p:sp>
        <p:nvSpPr>
          <p:cNvPr id="14" name="CuadroTexto 44">
            <a:extLst>
              <a:ext uri="{FF2B5EF4-FFF2-40B4-BE49-F238E27FC236}">
                <a16:creationId xmlns:a16="http://schemas.microsoft.com/office/drawing/2014/main" id="{0576D77D-F98B-6A40-03C1-B3283FC324FD}"/>
              </a:ext>
            </a:extLst>
          </p:cNvPr>
          <p:cNvSpPr txBox="1"/>
          <p:nvPr/>
        </p:nvSpPr>
        <p:spPr>
          <a:xfrm>
            <a:off x="5876021" y="1839520"/>
            <a:ext cx="1282930" cy="307777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ca-ES" sz="1400" b="1" dirty="0">
                <a:cs typeface="Calibri"/>
              </a:rPr>
              <a:t>Clear</a:t>
            </a:r>
            <a:r>
              <a:rPr lang="ca-ES" sz="1200" b="1" dirty="0">
                <a:cs typeface="Calibri"/>
              </a:rPr>
              <a:t> </a:t>
            </a:r>
            <a:r>
              <a:rPr lang="ca-ES" sz="1400" b="1" dirty="0">
                <a:cs typeface="Calibri"/>
              </a:rPr>
              <a:t>cell</a:t>
            </a:r>
            <a:endParaRPr lang="en-US" sz="1200" dirty="0">
              <a:latin typeface="Calibri bold" panose="020F0702030404030204" pitchFamily="34" charset="0"/>
              <a:ea typeface="Calibri bold" panose="020F0702030404030204" pitchFamily="34" charset="0"/>
              <a:cs typeface="Calibri bold" panose="020F0702030404030204" pitchFamily="34" charset="0"/>
            </a:endParaRPr>
          </a:p>
        </p:txBody>
      </p:sp>
      <p:sp>
        <p:nvSpPr>
          <p:cNvPr id="96" name="Text Placeholder 4">
            <a:extLst>
              <a:ext uri="{FF2B5EF4-FFF2-40B4-BE49-F238E27FC236}">
                <a16:creationId xmlns:a16="http://schemas.microsoft.com/office/drawing/2014/main" id="{327369B6-C29A-9888-1434-A112466F0B40}"/>
              </a:ext>
            </a:extLst>
          </p:cNvPr>
          <p:cNvSpPr>
            <a:spLocks noGrp="1"/>
          </p:cNvSpPr>
          <p:nvPr/>
        </p:nvSpPr>
        <p:spPr>
          <a:xfrm>
            <a:off x="7564509" y="1343788"/>
            <a:ext cx="2384573" cy="2941711"/>
          </a:xfrm>
          <a:prstGeom prst="rect">
            <a:avLst/>
          </a:prstGeom>
        </p:spPr>
        <p:txBody>
          <a:bodyPr lIns="91440" tIns="45720" rIns="91440" bIns="45720" anchor="ctr"/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US" sz="1400" b="0" dirty="0">
                <a:latin typeface="Arial"/>
                <a:cs typeface="Arial"/>
              </a:rPr>
              <a:t>The radiological cystic renal mass (CRM) patterns described in the present study are a helpful tool for differentiating benign CRM with thick septa and wall versus malignant CRM with acute angle nodules.</a:t>
            </a:r>
          </a:p>
        </p:txBody>
      </p:sp>
      <p:sp>
        <p:nvSpPr>
          <p:cNvPr id="97" name="CuadroTexto 42">
            <a:extLst>
              <a:ext uri="{FF2B5EF4-FFF2-40B4-BE49-F238E27FC236}">
                <a16:creationId xmlns:a16="http://schemas.microsoft.com/office/drawing/2014/main" id="{515B2A05-EC5B-B026-17F7-3DFB6C9F5EAD}"/>
              </a:ext>
            </a:extLst>
          </p:cNvPr>
          <p:cNvSpPr txBox="1"/>
          <p:nvPr/>
        </p:nvSpPr>
        <p:spPr>
          <a:xfrm>
            <a:off x="826956" y="1432578"/>
            <a:ext cx="206827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>
                <a:latin typeface="Calibri bold"/>
                <a:ea typeface="Calibri bold"/>
                <a:cs typeface="Calibri bold"/>
              </a:rPr>
              <a:t>SEPTA  PATTERNS (BENIGN)</a:t>
            </a:r>
            <a:endParaRPr lang="ca-ES" sz="1200" b="1" dirty="0">
              <a:latin typeface="Calibri bold"/>
              <a:ea typeface="Calibri bold"/>
              <a:cs typeface="Calibri bold"/>
            </a:endParaRPr>
          </a:p>
        </p:txBody>
      </p:sp>
      <p:sp>
        <p:nvSpPr>
          <p:cNvPr id="99" name="CuadroTexto 42">
            <a:extLst>
              <a:ext uri="{FF2B5EF4-FFF2-40B4-BE49-F238E27FC236}">
                <a16:creationId xmlns:a16="http://schemas.microsoft.com/office/drawing/2014/main" id="{107C942E-AFF9-CC78-E346-3EFAE38040FD}"/>
              </a:ext>
            </a:extLst>
          </p:cNvPr>
          <p:cNvSpPr txBox="1"/>
          <p:nvPr/>
        </p:nvSpPr>
        <p:spPr>
          <a:xfrm>
            <a:off x="4197904" y="1418316"/>
            <a:ext cx="244057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>
                <a:latin typeface="Calibri bold"/>
                <a:ea typeface="Calibri bold"/>
                <a:cs typeface="Calibri bold"/>
              </a:rPr>
              <a:t>NODULAR PATTERNS (MALIGNANT)</a:t>
            </a:r>
            <a:endParaRPr lang="ca-ES" sz="1200" b="1" dirty="0">
              <a:latin typeface="Calibri bold"/>
              <a:ea typeface="Calibri bold"/>
              <a:cs typeface="Calibri bold"/>
            </a:endParaRP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69</Words>
  <Application>Microsoft Office PowerPoint</Application>
  <PresentationFormat>Personalizado</PresentationFormat>
  <Paragraphs>10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bold</vt:lpstr>
      <vt:lpstr>Calibri Light</vt:lpstr>
      <vt:lpstr>Office Theme</vt:lpstr>
      <vt:lpstr>Presentación de PowerPoint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Daniel Corominas Muñoz</cp:lastModifiedBy>
  <cp:revision>80</cp:revision>
  <dcterms:created xsi:type="dcterms:W3CDTF">2020-06-22T01:49:04Z</dcterms:created>
  <dcterms:modified xsi:type="dcterms:W3CDTF">2025-03-03T07:35:42Z</dcterms:modified>
</cp:coreProperties>
</file>